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notesSlides/notesSlide1.xml" ContentType="application/vnd.openxmlformats-officedocument.presentationml.notesSlid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drawings/drawing1.xml" ContentType="application/vnd.openxmlformats-officedocument.drawingml.chartshapes+xml"/>
  <Override PartName="/ppt/charts/chart8.xml" ContentType="application/vnd.openxmlformats-officedocument.drawingml.chart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  <p:sldMasterId id="2147483672" r:id="rId5"/>
  </p:sldMasterIdLst>
  <p:notesMasterIdLst>
    <p:notesMasterId r:id="rId18"/>
  </p:notesMasterIdLst>
  <p:sldIdLst>
    <p:sldId id="301" r:id="rId6"/>
    <p:sldId id="300" r:id="rId7"/>
    <p:sldId id="289" r:id="rId8"/>
    <p:sldId id="290" r:id="rId9"/>
    <p:sldId id="305" r:id="rId10"/>
    <p:sldId id="302" r:id="rId11"/>
    <p:sldId id="291" r:id="rId12"/>
    <p:sldId id="292" r:id="rId13"/>
    <p:sldId id="303" r:id="rId14"/>
    <p:sldId id="304" r:id="rId15"/>
    <p:sldId id="295" r:id="rId16"/>
    <p:sldId id="297" r:id="rId17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ne Charbonneau" initials="JPC" lastIdx="3" clrIdx="0">
    <p:extLst>
      <p:ext uri="{19B8F6BF-5375-455C-9EA6-DF929625EA0E}">
        <p15:presenceInfo xmlns:p15="http://schemas.microsoft.com/office/powerpoint/2012/main" userId="Jane Charbonneau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1123" y="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21" Type="http://schemas.openxmlformats.org/officeDocument/2006/relationships/viewProps" Target="viewProp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" Type="http://schemas.openxmlformats.org/officeDocument/2006/relationships/customXml" Target="../customXml/item2.xml"/><Relationship Id="rId16" Type="http://schemas.openxmlformats.org/officeDocument/2006/relationships/slide" Target="slides/slide11.xml"/><Relationship Id="rId20" Type="http://schemas.openxmlformats.org/officeDocument/2006/relationships/presProps" Target="presProps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2.xml"/><Relationship Id="rId15" Type="http://schemas.openxmlformats.org/officeDocument/2006/relationships/slide" Target="slides/slide10.xml"/><Relationship Id="rId23" Type="http://schemas.openxmlformats.org/officeDocument/2006/relationships/tableStyles" Target="tableStyles.xml"/><Relationship Id="rId10" Type="http://schemas.openxmlformats.org/officeDocument/2006/relationships/slide" Target="slides/slide5.xml"/><Relationship Id="rId19" Type="http://schemas.openxmlformats.org/officeDocument/2006/relationships/commentAuthors" Target="commentAuthor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icrosoft%20PowerPoint%20&#20869;&#12398;&#12464;&#12521;&#12501;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icrosoft%20PowerPoint%20&#20869;&#12398;&#12464;&#12521;&#12501;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2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3:$Q$3</c:f>
              <c:numCache>
                <c:formatCode>General</c:formatCode>
                <c:ptCount val="13"/>
                <c:pt idx="4" formatCode="0">
                  <c:v>2087.549</c:v>
                </c:pt>
                <c:pt idx="5" formatCode="0">
                  <c:v>2370.212</c:v>
                </c:pt>
                <c:pt idx="6" formatCode="0">
                  <c:v>1691.29</c:v>
                </c:pt>
                <c:pt idx="7" formatCode="0">
                  <c:v>1677.4349999999999</c:v>
                </c:pt>
                <c:pt idx="8" formatCode="0">
                  <c:v>1789.2270000000001</c:v>
                </c:pt>
                <c:pt idx="10" formatCode="0">
                  <c:v>1975.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919-42C9-A73F-45F0F7AB17B2}"/>
            </c:ext>
          </c:extLst>
        </c:ser>
        <c:ser>
          <c:idx val="1"/>
          <c:order val="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4:$Q$4</c:f>
              <c:numCache>
                <c:formatCode>General</c:formatCode>
                <c:ptCount val="13"/>
                <c:pt idx="4" formatCode="0">
                  <c:v>2571.777</c:v>
                </c:pt>
                <c:pt idx="6" formatCode="0">
                  <c:v>4043.4270000000001</c:v>
                </c:pt>
                <c:pt idx="7" formatCode="0">
                  <c:v>3270.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919-42C9-A73F-45F0F7AB17B2}"/>
            </c:ext>
          </c:extLst>
        </c:ser>
        <c:ser>
          <c:idx val="2"/>
          <c:order val="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5:$Q$5</c:f>
              <c:numCache>
                <c:formatCode>General</c:formatCode>
                <c:ptCount val="13"/>
                <c:pt idx="4" formatCode="0">
                  <c:v>1842.2429999999999</c:v>
                </c:pt>
                <c:pt idx="5" formatCode="0">
                  <c:v>2040.5630000000001</c:v>
                </c:pt>
                <c:pt idx="6" formatCode="0">
                  <c:v>2296.9690000000001</c:v>
                </c:pt>
                <c:pt idx="7" formatCode="0">
                  <c:v>2488.1</c:v>
                </c:pt>
                <c:pt idx="8" formatCode="0">
                  <c:v>2453.0819999999999</c:v>
                </c:pt>
                <c:pt idx="9" formatCode="0">
                  <c:v>2103.07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919-42C9-A73F-45F0F7AB17B2}"/>
            </c:ext>
          </c:extLst>
        </c:ser>
        <c:ser>
          <c:idx val="3"/>
          <c:order val="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6:$Q$6</c:f>
              <c:numCache>
                <c:formatCode>General</c:formatCode>
                <c:ptCount val="13"/>
                <c:pt idx="4" formatCode="0">
                  <c:v>2038.758</c:v>
                </c:pt>
                <c:pt idx="5" formatCode="0">
                  <c:v>2500.3710000000001</c:v>
                </c:pt>
                <c:pt idx="6" formatCode="0">
                  <c:v>2654.049</c:v>
                </c:pt>
                <c:pt idx="7" formatCode="0">
                  <c:v>2982.9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7919-42C9-A73F-45F0F7AB17B2}"/>
            </c:ext>
          </c:extLst>
        </c:ser>
        <c:ser>
          <c:idx val="4"/>
          <c:order val="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7:$Q$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7919-42C9-A73F-45F0F7AB17B2}"/>
            </c:ext>
          </c:extLst>
        </c:ser>
        <c:ser>
          <c:idx val="5"/>
          <c:order val="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8:$Q$8</c:f>
              <c:numCache>
                <c:formatCode>General</c:formatCode>
                <c:ptCount val="13"/>
                <c:pt idx="6" formatCode="0">
                  <c:v>3629.0790000000002</c:v>
                </c:pt>
                <c:pt idx="8" formatCode="0">
                  <c:v>4386.74</c:v>
                </c:pt>
                <c:pt idx="9" formatCode="0">
                  <c:v>4712.7299999999996</c:v>
                </c:pt>
                <c:pt idx="12" formatCode="0">
                  <c:v>5383.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7919-42C9-A73F-45F0F7AB17B2}"/>
            </c:ext>
          </c:extLst>
        </c:ser>
        <c:ser>
          <c:idx val="6"/>
          <c:order val="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9:$Q$9</c:f>
              <c:numCache>
                <c:formatCode>General</c:formatCode>
                <c:ptCount val="13"/>
                <c:pt idx="5" formatCode="0">
                  <c:v>4745.6350000000002</c:v>
                </c:pt>
                <c:pt idx="6" formatCode="0">
                  <c:v>4982.704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7919-42C9-A73F-45F0F7AB17B2}"/>
            </c:ext>
          </c:extLst>
        </c:ser>
        <c:ser>
          <c:idx val="7"/>
          <c:order val="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10:$Q$1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7919-42C9-A73F-45F0F7AB17B2}"/>
            </c:ext>
          </c:extLst>
        </c:ser>
        <c:ser>
          <c:idx val="8"/>
          <c:order val="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11:$Q$11</c:f>
              <c:numCache>
                <c:formatCode>0</c:formatCode>
                <c:ptCount val="13"/>
                <c:pt idx="0">
                  <c:v>2161.681</c:v>
                </c:pt>
                <c:pt idx="1">
                  <c:v>2319.2289999999998</c:v>
                </c:pt>
                <c:pt idx="2">
                  <c:v>2329.1260000000002</c:v>
                </c:pt>
                <c:pt idx="3">
                  <c:v>2515.4479999999999</c:v>
                </c:pt>
                <c:pt idx="5">
                  <c:v>2737.67</c:v>
                </c:pt>
                <c:pt idx="6">
                  <c:v>2822.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7919-42C9-A73F-45F0F7AB17B2}"/>
            </c:ext>
          </c:extLst>
        </c:ser>
        <c:ser>
          <c:idx val="9"/>
          <c:order val="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12:$Q$12</c:f>
              <c:numCache>
                <c:formatCode>General</c:formatCode>
                <c:ptCount val="13"/>
                <c:pt idx="6" formatCode="0">
                  <c:v>3206.82</c:v>
                </c:pt>
                <c:pt idx="7" formatCode="0">
                  <c:v>2303.65</c:v>
                </c:pt>
                <c:pt idx="8" formatCode="0">
                  <c:v>2294.36</c:v>
                </c:pt>
                <c:pt idx="12" formatCode="0">
                  <c:v>1807.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7919-42C9-A73F-45F0F7AB17B2}"/>
            </c:ext>
          </c:extLst>
        </c:ser>
        <c:ser>
          <c:idx val="10"/>
          <c:order val="1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13:$Q$13</c:f>
              <c:numCache>
                <c:formatCode>0</c:formatCode>
                <c:ptCount val="13"/>
                <c:pt idx="1">
                  <c:v>1782.566</c:v>
                </c:pt>
                <c:pt idx="2">
                  <c:v>1958.9010000000001</c:v>
                </c:pt>
                <c:pt idx="3">
                  <c:v>2056.5889999999999</c:v>
                </c:pt>
                <c:pt idx="4">
                  <c:v>2151.7060000000001</c:v>
                </c:pt>
                <c:pt idx="5">
                  <c:v>2413.4389999999999</c:v>
                </c:pt>
                <c:pt idx="6">
                  <c:v>1916.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7919-42C9-A73F-45F0F7AB17B2}"/>
            </c:ext>
          </c:extLst>
        </c:ser>
        <c:ser>
          <c:idx val="11"/>
          <c:order val="1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14:$Q$14</c:f>
              <c:numCache>
                <c:formatCode>General</c:formatCode>
                <c:ptCount val="13"/>
                <c:pt idx="3" formatCode="0">
                  <c:v>1345.452</c:v>
                </c:pt>
                <c:pt idx="4" formatCode="0">
                  <c:v>1448.451</c:v>
                </c:pt>
                <c:pt idx="5" formatCode="0">
                  <c:v>1472.491</c:v>
                </c:pt>
                <c:pt idx="6" formatCode="0">
                  <c:v>1640.78</c:v>
                </c:pt>
                <c:pt idx="7" formatCode="0">
                  <c:v>1407.33</c:v>
                </c:pt>
                <c:pt idx="8" formatCode="0">
                  <c:v>1296.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7919-42C9-A73F-45F0F7AB17B2}"/>
            </c:ext>
          </c:extLst>
        </c:ser>
        <c:ser>
          <c:idx val="12"/>
          <c:order val="1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15:$Q$15</c:f>
              <c:numCache>
                <c:formatCode>General</c:formatCode>
                <c:ptCount val="13"/>
                <c:pt idx="4" formatCode="0">
                  <c:v>3172.8850000000002</c:v>
                </c:pt>
                <c:pt idx="6" formatCode="0">
                  <c:v>3267.11</c:v>
                </c:pt>
                <c:pt idx="7" formatCode="0">
                  <c:v>2622.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7919-42C9-A73F-45F0F7AB17B2}"/>
            </c:ext>
          </c:extLst>
        </c:ser>
        <c:ser>
          <c:idx val="13"/>
          <c:order val="1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16:$Q$1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7919-42C9-A73F-45F0F7AB17B2}"/>
            </c:ext>
          </c:extLst>
        </c:ser>
        <c:ser>
          <c:idx val="14"/>
          <c:order val="1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17:$Q$17</c:f>
              <c:numCache>
                <c:formatCode>0</c:formatCode>
                <c:ptCount val="13"/>
                <c:pt idx="1">
                  <c:v>1943.4110000000001</c:v>
                </c:pt>
                <c:pt idx="3">
                  <c:v>2079.0079999999998</c:v>
                </c:pt>
                <c:pt idx="6">
                  <c:v>3094.65</c:v>
                </c:pt>
                <c:pt idx="7">
                  <c:v>2621.87</c:v>
                </c:pt>
                <c:pt idx="8">
                  <c:v>2353.8200000000002</c:v>
                </c:pt>
                <c:pt idx="9">
                  <c:v>2650.2</c:v>
                </c:pt>
                <c:pt idx="12">
                  <c:v>2600.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7919-42C9-A73F-45F0F7AB17B2}"/>
            </c:ext>
          </c:extLst>
        </c:ser>
        <c:ser>
          <c:idx val="15"/>
          <c:order val="1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18:$Q$18</c:f>
              <c:numCache>
                <c:formatCode>0</c:formatCode>
                <c:ptCount val="13"/>
                <c:pt idx="0">
                  <c:v>3597.61</c:v>
                </c:pt>
                <c:pt idx="1">
                  <c:v>3797.3159999999998</c:v>
                </c:pt>
                <c:pt idx="2">
                  <c:v>4016.2249999999999</c:v>
                </c:pt>
                <c:pt idx="3">
                  <c:v>4492.8019999999997</c:v>
                </c:pt>
                <c:pt idx="4">
                  <c:v>4901.9340000000002</c:v>
                </c:pt>
                <c:pt idx="5">
                  <c:v>5899.94</c:v>
                </c:pt>
                <c:pt idx="6">
                  <c:v>6806.35</c:v>
                </c:pt>
                <c:pt idx="7">
                  <c:v>5235.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7919-42C9-A73F-45F0F7AB17B2}"/>
            </c:ext>
          </c:extLst>
        </c:ser>
        <c:ser>
          <c:idx val="16"/>
          <c:order val="1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19:$Q$19</c:f>
              <c:numCache>
                <c:formatCode>General</c:formatCode>
                <c:ptCount val="13"/>
                <c:pt idx="3" formatCode="0">
                  <c:v>1781.7249999999999</c:v>
                </c:pt>
                <c:pt idx="5" formatCode="0">
                  <c:v>2296.88</c:v>
                </c:pt>
                <c:pt idx="6" formatCode="0">
                  <c:v>2209.06</c:v>
                </c:pt>
                <c:pt idx="7" formatCode="0">
                  <c:v>1825.08</c:v>
                </c:pt>
                <c:pt idx="8" formatCode="0">
                  <c:v>1788.56</c:v>
                </c:pt>
                <c:pt idx="9" formatCode="0">
                  <c:v>1725.4</c:v>
                </c:pt>
                <c:pt idx="10" formatCode="0">
                  <c:v>1901</c:v>
                </c:pt>
                <c:pt idx="11" formatCode="0">
                  <c:v>1680.15</c:v>
                </c:pt>
                <c:pt idx="12" formatCode="0">
                  <c:v>1602.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7919-42C9-A73F-45F0F7AB17B2}"/>
            </c:ext>
          </c:extLst>
        </c:ser>
        <c:ser>
          <c:idx val="17"/>
          <c:order val="1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20:$Q$20</c:f>
              <c:numCache>
                <c:formatCode>General</c:formatCode>
                <c:ptCount val="13"/>
                <c:pt idx="0" formatCode="0">
                  <c:v>2335.2040000000002</c:v>
                </c:pt>
                <c:pt idx="5" formatCode="0">
                  <c:v>2365.71</c:v>
                </c:pt>
                <c:pt idx="6" formatCode="0">
                  <c:v>2786.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7919-42C9-A73F-45F0F7AB17B2}"/>
            </c:ext>
          </c:extLst>
        </c:ser>
        <c:ser>
          <c:idx val="18"/>
          <c:order val="1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21:$Q$2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7919-42C9-A73F-45F0F7AB17B2}"/>
            </c:ext>
          </c:extLst>
        </c:ser>
        <c:ser>
          <c:idx val="19"/>
          <c:order val="1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22:$Q$22</c:f>
              <c:numCache>
                <c:formatCode>0</c:formatCode>
                <c:ptCount val="13"/>
                <c:pt idx="0">
                  <c:v>1589.4960000000001</c:v>
                </c:pt>
                <c:pt idx="1">
                  <c:v>1714.143</c:v>
                </c:pt>
                <c:pt idx="2">
                  <c:v>1857.4739999999999</c:v>
                </c:pt>
                <c:pt idx="3">
                  <c:v>1927.6769999999999</c:v>
                </c:pt>
                <c:pt idx="6">
                  <c:v>3550.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7919-42C9-A73F-45F0F7AB17B2}"/>
            </c:ext>
          </c:extLst>
        </c:ser>
        <c:ser>
          <c:idx val="20"/>
          <c:order val="2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23:$Q$23</c:f>
              <c:numCache>
                <c:formatCode>General</c:formatCode>
                <c:ptCount val="13"/>
                <c:pt idx="0" formatCode="0">
                  <c:v>2714.902</c:v>
                </c:pt>
                <c:pt idx="5" formatCode="0">
                  <c:v>8200.7900000000009</c:v>
                </c:pt>
                <c:pt idx="6" formatCode="0">
                  <c:v>6039.51</c:v>
                </c:pt>
                <c:pt idx="8" formatCode="0">
                  <c:v>4968.2299999999996</c:v>
                </c:pt>
                <c:pt idx="10" formatCode="0">
                  <c:v>5101.09</c:v>
                </c:pt>
                <c:pt idx="11" formatCode="0">
                  <c:v>5826.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7919-42C9-A73F-45F0F7AB17B2}"/>
            </c:ext>
          </c:extLst>
        </c:ser>
        <c:ser>
          <c:idx val="21"/>
          <c:order val="2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24:$Q$24</c:f>
              <c:numCache>
                <c:formatCode>0</c:formatCode>
                <c:ptCount val="13"/>
                <c:pt idx="0">
                  <c:v>1599.28</c:v>
                </c:pt>
                <c:pt idx="1">
                  <c:v>2214.8389999999999</c:v>
                </c:pt>
                <c:pt idx="5">
                  <c:v>2698.96</c:v>
                </c:pt>
                <c:pt idx="6">
                  <c:v>2578.5500000000002</c:v>
                </c:pt>
                <c:pt idx="8">
                  <c:v>2307.2800000000002</c:v>
                </c:pt>
                <c:pt idx="9">
                  <c:v>2019.07</c:v>
                </c:pt>
                <c:pt idx="11">
                  <c:v>1793.01</c:v>
                </c:pt>
                <c:pt idx="12">
                  <c:v>1667.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7919-42C9-A73F-45F0F7AB17B2}"/>
            </c:ext>
          </c:extLst>
        </c:ser>
        <c:ser>
          <c:idx val="22"/>
          <c:order val="2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25:$Q$25</c:f>
              <c:numCache>
                <c:formatCode>General</c:formatCode>
                <c:ptCount val="13"/>
                <c:pt idx="2" formatCode="0">
                  <c:v>1367.9280000000001</c:v>
                </c:pt>
                <c:pt idx="3" formatCode="0">
                  <c:v>1616.204</c:v>
                </c:pt>
                <c:pt idx="4" formatCode="0">
                  <c:v>1842.57</c:v>
                </c:pt>
                <c:pt idx="6" formatCode="0">
                  <c:v>2739.28</c:v>
                </c:pt>
                <c:pt idx="7" formatCode="0">
                  <c:v>2781.62</c:v>
                </c:pt>
                <c:pt idx="8" formatCode="0">
                  <c:v>2458.5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7919-42C9-A73F-45F0F7AB17B2}"/>
            </c:ext>
          </c:extLst>
        </c:ser>
        <c:ser>
          <c:idx val="23"/>
          <c:order val="2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26:$Q$26</c:f>
              <c:numCache>
                <c:formatCode>General</c:formatCode>
                <c:ptCount val="13"/>
                <c:pt idx="6" formatCode="0">
                  <c:v>2232.42</c:v>
                </c:pt>
                <c:pt idx="7" formatCode="0">
                  <c:v>3243.8</c:v>
                </c:pt>
                <c:pt idx="8" formatCode="0">
                  <c:v>2895.78</c:v>
                </c:pt>
                <c:pt idx="9" formatCode="0">
                  <c:v>3366.31</c:v>
                </c:pt>
                <c:pt idx="10" formatCode="0">
                  <c:v>3521.92</c:v>
                </c:pt>
                <c:pt idx="11" formatCode="0">
                  <c:v>3703.68</c:v>
                </c:pt>
                <c:pt idx="12" formatCode="0">
                  <c:v>4154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7919-42C9-A73F-45F0F7AB17B2}"/>
            </c:ext>
          </c:extLst>
        </c:ser>
        <c:ser>
          <c:idx val="24"/>
          <c:order val="2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27:$Q$27</c:f>
              <c:numCache>
                <c:formatCode>General</c:formatCode>
                <c:ptCount val="13"/>
                <c:pt idx="5" formatCode="0">
                  <c:v>4068.03</c:v>
                </c:pt>
                <c:pt idx="6" formatCode="0">
                  <c:v>3398.47</c:v>
                </c:pt>
                <c:pt idx="7" formatCode="0">
                  <c:v>3266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7919-42C9-A73F-45F0F7AB17B2}"/>
            </c:ext>
          </c:extLst>
        </c:ser>
        <c:ser>
          <c:idx val="25"/>
          <c:order val="2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28:$Q$28</c:f>
              <c:numCache>
                <c:formatCode>0</c:formatCode>
                <c:ptCount val="13"/>
                <c:pt idx="1">
                  <c:v>2438.5610000000001</c:v>
                </c:pt>
                <c:pt idx="2">
                  <c:v>2631.8139999999999</c:v>
                </c:pt>
                <c:pt idx="3">
                  <c:v>2892.4</c:v>
                </c:pt>
                <c:pt idx="4">
                  <c:v>3191.58</c:v>
                </c:pt>
                <c:pt idx="6">
                  <c:v>3056.06</c:v>
                </c:pt>
                <c:pt idx="8">
                  <c:v>2710.25</c:v>
                </c:pt>
                <c:pt idx="9">
                  <c:v>3308.5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7919-42C9-A73F-45F0F7AB17B2}"/>
            </c:ext>
          </c:extLst>
        </c:ser>
        <c:ser>
          <c:idx val="26"/>
          <c:order val="2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29:$Q$29</c:f>
              <c:numCache>
                <c:formatCode>General</c:formatCode>
                <c:ptCount val="13"/>
                <c:pt idx="4" formatCode="0">
                  <c:v>2047.19</c:v>
                </c:pt>
                <c:pt idx="5" formatCode="0">
                  <c:v>2258.5700000000002</c:v>
                </c:pt>
                <c:pt idx="6" formatCode="0">
                  <c:v>2024.35</c:v>
                </c:pt>
                <c:pt idx="7" formatCode="0">
                  <c:v>1873.12</c:v>
                </c:pt>
                <c:pt idx="8" formatCode="0">
                  <c:v>1854.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7919-42C9-A73F-45F0F7AB17B2}"/>
            </c:ext>
          </c:extLst>
        </c:ser>
        <c:ser>
          <c:idx val="27"/>
          <c:order val="2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30:$Q$30</c:f>
              <c:numCache>
                <c:formatCode>General</c:formatCode>
                <c:ptCount val="13"/>
                <c:pt idx="5" formatCode="0">
                  <c:v>3034.54</c:v>
                </c:pt>
                <c:pt idx="6" formatCode="0">
                  <c:v>3038.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7919-42C9-A73F-45F0F7AB17B2}"/>
            </c:ext>
          </c:extLst>
        </c:ser>
        <c:ser>
          <c:idx val="28"/>
          <c:order val="2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31:$Q$31</c:f>
              <c:numCache>
                <c:formatCode>General</c:formatCode>
                <c:ptCount val="13"/>
                <c:pt idx="6" formatCode="0">
                  <c:v>1310.28</c:v>
                </c:pt>
                <c:pt idx="7" formatCode="0">
                  <c:v>951.48</c:v>
                </c:pt>
                <c:pt idx="8" formatCode="0">
                  <c:v>747.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7919-42C9-A73F-45F0F7AB17B2}"/>
            </c:ext>
          </c:extLst>
        </c:ser>
        <c:ser>
          <c:idx val="29"/>
          <c:order val="2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32:$Q$3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7919-42C9-A73F-45F0F7AB17B2}"/>
            </c:ext>
          </c:extLst>
        </c:ser>
        <c:ser>
          <c:idx val="30"/>
          <c:order val="3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33:$Q$33</c:f>
              <c:numCache>
                <c:formatCode>0</c:formatCode>
                <c:ptCount val="13"/>
                <c:pt idx="1">
                  <c:v>671.23</c:v>
                </c:pt>
                <c:pt idx="3">
                  <c:v>757.45699999999999</c:v>
                </c:pt>
                <c:pt idx="4">
                  <c:v>690.46</c:v>
                </c:pt>
                <c:pt idx="5">
                  <c:v>960.76</c:v>
                </c:pt>
                <c:pt idx="6">
                  <c:v>721.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7919-42C9-A73F-45F0F7AB17B2}"/>
            </c:ext>
          </c:extLst>
        </c:ser>
        <c:ser>
          <c:idx val="31"/>
          <c:order val="3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34:$Q$34</c:f>
              <c:numCache>
                <c:formatCode>General</c:formatCode>
                <c:ptCount val="13"/>
                <c:pt idx="4" formatCode="0">
                  <c:v>2859.18</c:v>
                </c:pt>
                <c:pt idx="6" formatCode="0">
                  <c:v>3330.5</c:v>
                </c:pt>
                <c:pt idx="7" formatCode="0">
                  <c:v>3009.87</c:v>
                </c:pt>
                <c:pt idx="8" formatCode="0">
                  <c:v>2299.0100000000002</c:v>
                </c:pt>
                <c:pt idx="9" formatCode="0">
                  <c:v>2192.96</c:v>
                </c:pt>
                <c:pt idx="10" formatCode="0">
                  <c:v>2182.4899999999998</c:v>
                </c:pt>
                <c:pt idx="11" formatCode="0">
                  <c:v>2004.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7919-42C9-A73F-45F0F7AB17B2}"/>
            </c:ext>
          </c:extLst>
        </c:ser>
        <c:ser>
          <c:idx val="32"/>
          <c:order val="3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35:$Q$35</c:f>
              <c:numCache>
                <c:formatCode>General</c:formatCode>
                <c:ptCount val="13"/>
                <c:pt idx="2" formatCode="0">
                  <c:v>3281.9470000000001</c:v>
                </c:pt>
                <c:pt idx="4" formatCode="0">
                  <c:v>3449.93</c:v>
                </c:pt>
                <c:pt idx="6" formatCode="0">
                  <c:v>3714.48</c:v>
                </c:pt>
                <c:pt idx="7" formatCode="0">
                  <c:v>3441.59</c:v>
                </c:pt>
                <c:pt idx="8" formatCode="0">
                  <c:v>3504.17</c:v>
                </c:pt>
                <c:pt idx="9" formatCode="0">
                  <c:v>2851.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7919-42C9-A73F-45F0F7AB17B2}"/>
            </c:ext>
          </c:extLst>
        </c:ser>
        <c:ser>
          <c:idx val="33"/>
          <c:order val="3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36:$Q$36</c:f>
              <c:numCache>
                <c:formatCode>General</c:formatCode>
                <c:ptCount val="13"/>
                <c:pt idx="6" formatCode="0">
                  <c:v>2801.73</c:v>
                </c:pt>
                <c:pt idx="7" formatCode="0">
                  <c:v>2533.5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7919-42C9-A73F-45F0F7AB17B2}"/>
            </c:ext>
          </c:extLst>
        </c:ser>
        <c:ser>
          <c:idx val="34"/>
          <c:order val="3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37:$Q$37</c:f>
              <c:numCache>
                <c:formatCode>0</c:formatCode>
                <c:ptCount val="13"/>
                <c:pt idx="1">
                  <c:v>2600.2170000000001</c:v>
                </c:pt>
                <c:pt idx="4">
                  <c:v>3217.49</c:v>
                </c:pt>
                <c:pt idx="6">
                  <c:v>3407.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7919-42C9-A73F-45F0F7AB17B2}"/>
            </c:ext>
          </c:extLst>
        </c:ser>
        <c:ser>
          <c:idx val="35"/>
          <c:order val="3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38:$Q$38</c:f>
              <c:numCache>
                <c:formatCode>General</c:formatCode>
                <c:ptCount val="13"/>
                <c:pt idx="0" formatCode="0">
                  <c:v>2948.3809999999999</c:v>
                </c:pt>
                <c:pt idx="5" formatCode="0">
                  <c:v>4295.46</c:v>
                </c:pt>
                <c:pt idx="6" formatCode="0">
                  <c:v>4530.62</c:v>
                </c:pt>
                <c:pt idx="8" formatCode="0">
                  <c:v>3884.8</c:v>
                </c:pt>
                <c:pt idx="10" formatCode="0">
                  <c:v>2418.5700000000002</c:v>
                </c:pt>
                <c:pt idx="11" formatCode="0">
                  <c:v>2129.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7919-42C9-A73F-45F0F7AB17B2}"/>
            </c:ext>
          </c:extLst>
        </c:ser>
        <c:ser>
          <c:idx val="36"/>
          <c:order val="3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39:$Q$3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7919-42C9-A73F-45F0F7AB17B2}"/>
            </c:ext>
          </c:extLst>
        </c:ser>
        <c:ser>
          <c:idx val="37"/>
          <c:order val="3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40:$Q$40</c:f>
              <c:numCache>
                <c:formatCode>General</c:formatCode>
                <c:ptCount val="13"/>
                <c:pt idx="5" formatCode="0">
                  <c:v>3639.43</c:v>
                </c:pt>
                <c:pt idx="6" formatCode="0">
                  <c:v>3013.14</c:v>
                </c:pt>
                <c:pt idx="7" formatCode="0">
                  <c:v>2917.67</c:v>
                </c:pt>
                <c:pt idx="8" formatCode="0">
                  <c:v>2976.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7919-42C9-A73F-45F0F7AB17B2}"/>
            </c:ext>
          </c:extLst>
        </c:ser>
        <c:ser>
          <c:idx val="38"/>
          <c:order val="3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41:$Q$41</c:f>
              <c:numCache>
                <c:formatCode>General</c:formatCode>
                <c:ptCount val="13"/>
                <c:pt idx="5" formatCode="0">
                  <c:v>2807.21</c:v>
                </c:pt>
                <c:pt idx="6" formatCode="0">
                  <c:v>2410.26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7919-42C9-A73F-45F0F7AB17B2}"/>
            </c:ext>
          </c:extLst>
        </c:ser>
        <c:ser>
          <c:idx val="39"/>
          <c:order val="3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42:$Q$4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7919-42C9-A73F-45F0F7AB17B2}"/>
            </c:ext>
          </c:extLst>
        </c:ser>
        <c:ser>
          <c:idx val="40"/>
          <c:order val="4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43:$Q$43</c:f>
              <c:numCache>
                <c:formatCode>General</c:formatCode>
                <c:ptCount val="13"/>
                <c:pt idx="4" formatCode="0">
                  <c:v>8454.8819999999996</c:v>
                </c:pt>
                <c:pt idx="6" formatCode="0">
                  <c:v>10334.727000000001</c:v>
                </c:pt>
                <c:pt idx="7" formatCode="0">
                  <c:v>9332.7960000000003</c:v>
                </c:pt>
                <c:pt idx="8" formatCode="0">
                  <c:v>9743.8539999999994</c:v>
                </c:pt>
                <c:pt idx="9" formatCode="0">
                  <c:v>10677.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7919-42C9-A73F-45F0F7AB17B2}"/>
            </c:ext>
          </c:extLst>
        </c:ser>
        <c:ser>
          <c:idx val="41"/>
          <c:order val="4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44:$Q$44</c:f>
              <c:numCache>
                <c:formatCode>General</c:formatCode>
                <c:ptCount val="13"/>
                <c:pt idx="4" formatCode="0">
                  <c:v>2374.21</c:v>
                </c:pt>
                <c:pt idx="5" formatCode="0">
                  <c:v>2691.55</c:v>
                </c:pt>
                <c:pt idx="6" formatCode="0">
                  <c:v>2882.85</c:v>
                </c:pt>
                <c:pt idx="7" formatCode="0">
                  <c:v>3508.49</c:v>
                </c:pt>
                <c:pt idx="8" formatCode="0">
                  <c:v>2946.49</c:v>
                </c:pt>
                <c:pt idx="9" formatCode="0">
                  <c:v>2229.9499999999998</c:v>
                </c:pt>
                <c:pt idx="10" formatCode="0">
                  <c:v>2086.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7919-42C9-A73F-45F0F7AB17B2}"/>
            </c:ext>
          </c:extLst>
        </c:ser>
        <c:ser>
          <c:idx val="42"/>
          <c:order val="4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45:$Q$45</c:f>
              <c:numCache>
                <c:formatCode>General</c:formatCode>
                <c:ptCount val="13"/>
                <c:pt idx="3" formatCode="0">
                  <c:v>3015.65</c:v>
                </c:pt>
                <c:pt idx="4" formatCode="0">
                  <c:v>2667.22</c:v>
                </c:pt>
                <c:pt idx="5" formatCode="0">
                  <c:v>3215.85</c:v>
                </c:pt>
                <c:pt idx="6" formatCode="0">
                  <c:v>3613.63</c:v>
                </c:pt>
                <c:pt idx="7" formatCode="0">
                  <c:v>2620.7399999999998</c:v>
                </c:pt>
                <c:pt idx="9" formatCode="0">
                  <c:v>2560.9299999999998</c:v>
                </c:pt>
                <c:pt idx="10" formatCode="0">
                  <c:v>2419.42</c:v>
                </c:pt>
                <c:pt idx="11" formatCode="0">
                  <c:v>2724.3</c:v>
                </c:pt>
                <c:pt idx="12" formatCode="0">
                  <c:v>3052.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7919-42C9-A73F-45F0F7AB17B2}"/>
            </c:ext>
          </c:extLst>
        </c:ser>
        <c:ser>
          <c:idx val="43"/>
          <c:order val="4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46:$Q$46</c:f>
              <c:numCache>
                <c:formatCode>General</c:formatCode>
                <c:ptCount val="13"/>
                <c:pt idx="4" formatCode="0">
                  <c:v>5062.26</c:v>
                </c:pt>
                <c:pt idx="5" formatCode="0">
                  <c:v>5618.94</c:v>
                </c:pt>
                <c:pt idx="6" formatCode="0">
                  <c:v>6466.01</c:v>
                </c:pt>
                <c:pt idx="9" formatCode="0">
                  <c:v>6016.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7919-42C9-A73F-45F0F7AB17B2}"/>
            </c:ext>
          </c:extLst>
        </c:ser>
        <c:ser>
          <c:idx val="44"/>
          <c:order val="4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47:$Q$47</c:f>
              <c:numCache>
                <c:formatCode>General</c:formatCode>
                <c:ptCount val="13"/>
                <c:pt idx="4" formatCode="0">
                  <c:v>1180.49</c:v>
                </c:pt>
                <c:pt idx="5" formatCode="0">
                  <c:v>1515.3</c:v>
                </c:pt>
                <c:pt idx="6" formatCode="0">
                  <c:v>2675.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7919-42C9-A73F-45F0F7AB17B2}"/>
            </c:ext>
          </c:extLst>
        </c:ser>
        <c:ser>
          <c:idx val="45"/>
          <c:order val="4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48:$Q$48</c:f>
              <c:numCache>
                <c:formatCode>General</c:formatCode>
                <c:ptCount val="13"/>
                <c:pt idx="2" formatCode="0">
                  <c:v>2742.87</c:v>
                </c:pt>
                <c:pt idx="3" formatCode="0">
                  <c:v>2597.92</c:v>
                </c:pt>
                <c:pt idx="4" formatCode="0">
                  <c:v>3032.77</c:v>
                </c:pt>
                <c:pt idx="6" formatCode="0">
                  <c:v>3817.09</c:v>
                </c:pt>
                <c:pt idx="7" formatCode="0">
                  <c:v>3562.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7919-42C9-A73F-45F0F7AB17B2}"/>
            </c:ext>
          </c:extLst>
        </c:ser>
        <c:ser>
          <c:idx val="46"/>
          <c:order val="4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49:$Q$49</c:f>
              <c:numCache>
                <c:formatCode>General</c:formatCode>
                <c:ptCount val="13"/>
                <c:pt idx="3" formatCode="0">
                  <c:v>3194.59</c:v>
                </c:pt>
                <c:pt idx="6" formatCode="0">
                  <c:v>3171.4</c:v>
                </c:pt>
                <c:pt idx="7" formatCode="0">
                  <c:v>2897.55</c:v>
                </c:pt>
                <c:pt idx="8" formatCode="0">
                  <c:v>2997.7</c:v>
                </c:pt>
                <c:pt idx="9" formatCode="0">
                  <c:v>2451</c:v>
                </c:pt>
                <c:pt idx="10" formatCode="0">
                  <c:v>2271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7919-42C9-A73F-45F0F7AB17B2}"/>
            </c:ext>
          </c:extLst>
        </c:ser>
        <c:ser>
          <c:idx val="47"/>
          <c:order val="4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50:$Q$50</c:f>
              <c:numCache>
                <c:formatCode>General</c:formatCode>
                <c:ptCount val="13"/>
                <c:pt idx="0" formatCode="0">
                  <c:v>986.65800000000002</c:v>
                </c:pt>
                <c:pt idx="2" formatCode="0">
                  <c:v>1031.21</c:v>
                </c:pt>
                <c:pt idx="3" formatCode="0">
                  <c:v>1118.0899999999999</c:v>
                </c:pt>
                <c:pt idx="4" formatCode="0">
                  <c:v>1370.95</c:v>
                </c:pt>
                <c:pt idx="5" formatCode="0">
                  <c:v>2155.11</c:v>
                </c:pt>
                <c:pt idx="6" formatCode="0">
                  <c:v>2544.46</c:v>
                </c:pt>
                <c:pt idx="7" formatCode="0">
                  <c:v>2028.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7919-42C9-A73F-45F0F7AB17B2}"/>
            </c:ext>
          </c:extLst>
        </c:ser>
        <c:ser>
          <c:idx val="48"/>
          <c:order val="4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51:$Q$51</c:f>
              <c:numCache>
                <c:formatCode>0</c:formatCode>
                <c:ptCount val="13"/>
                <c:pt idx="1">
                  <c:v>1853.19</c:v>
                </c:pt>
                <c:pt idx="2">
                  <c:v>2025.58</c:v>
                </c:pt>
                <c:pt idx="3">
                  <c:v>2554.34</c:v>
                </c:pt>
                <c:pt idx="5">
                  <c:v>3315.57</c:v>
                </c:pt>
                <c:pt idx="6">
                  <c:v>4152.28</c:v>
                </c:pt>
                <c:pt idx="7">
                  <c:v>2895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7919-42C9-A73F-45F0F7AB17B2}"/>
            </c:ext>
          </c:extLst>
        </c:ser>
        <c:ser>
          <c:idx val="49"/>
          <c:order val="4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52:$Q$52</c:f>
              <c:numCache>
                <c:formatCode>General</c:formatCode>
                <c:ptCount val="13"/>
                <c:pt idx="5" formatCode="0">
                  <c:v>1951.69</c:v>
                </c:pt>
                <c:pt idx="6" formatCode="0">
                  <c:v>1958.79</c:v>
                </c:pt>
                <c:pt idx="7" formatCode="0">
                  <c:v>1331.19</c:v>
                </c:pt>
                <c:pt idx="8" formatCode="0">
                  <c:v>1181.8699999999999</c:v>
                </c:pt>
                <c:pt idx="9" formatCode="0">
                  <c:v>1162.26</c:v>
                </c:pt>
                <c:pt idx="10" formatCode="0">
                  <c:v>1291.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7919-42C9-A73F-45F0F7AB17B2}"/>
            </c:ext>
          </c:extLst>
        </c:ser>
        <c:ser>
          <c:idx val="50"/>
          <c:order val="5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53:$Q$53</c:f>
              <c:numCache>
                <c:formatCode>General</c:formatCode>
                <c:ptCount val="13"/>
                <c:pt idx="5" formatCode="0">
                  <c:v>2679.96</c:v>
                </c:pt>
                <c:pt idx="6" formatCode="0">
                  <c:v>3152.63</c:v>
                </c:pt>
                <c:pt idx="7" formatCode="0">
                  <c:v>3528.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2-7919-42C9-A73F-45F0F7AB17B2}"/>
            </c:ext>
          </c:extLst>
        </c:ser>
        <c:ser>
          <c:idx val="51"/>
          <c:order val="5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54:$Q$54</c:f>
              <c:numCache>
                <c:formatCode>General</c:formatCode>
                <c:ptCount val="13"/>
                <c:pt idx="4" formatCode="0">
                  <c:v>1331.01</c:v>
                </c:pt>
                <c:pt idx="6" formatCode="0">
                  <c:v>1806.13</c:v>
                </c:pt>
                <c:pt idx="7" formatCode="0">
                  <c:v>1784.9</c:v>
                </c:pt>
                <c:pt idx="8" formatCode="0">
                  <c:v>1878.85</c:v>
                </c:pt>
                <c:pt idx="9" formatCode="0">
                  <c:v>1940.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3-7919-42C9-A73F-45F0F7AB17B2}"/>
            </c:ext>
          </c:extLst>
        </c:ser>
        <c:ser>
          <c:idx val="52"/>
          <c:order val="5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55:$Q$55</c:f>
              <c:numCache>
                <c:formatCode>General</c:formatCode>
                <c:ptCount val="13"/>
                <c:pt idx="5" formatCode="0">
                  <c:v>6661.7449999999999</c:v>
                </c:pt>
                <c:pt idx="6" formatCode="0">
                  <c:v>7858.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4-7919-42C9-A73F-45F0F7AB17B2}"/>
            </c:ext>
          </c:extLst>
        </c:ser>
        <c:ser>
          <c:idx val="53"/>
          <c:order val="5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56:$Q$56</c:f>
              <c:numCache>
                <c:formatCode>General</c:formatCode>
                <c:ptCount val="13"/>
                <c:pt idx="4" formatCode="0">
                  <c:v>7187.02</c:v>
                </c:pt>
                <c:pt idx="5" formatCode="0">
                  <c:v>8686.2800000000007</c:v>
                </c:pt>
                <c:pt idx="6" formatCode="0">
                  <c:v>9079.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5-7919-42C9-A73F-45F0F7AB17B2}"/>
            </c:ext>
          </c:extLst>
        </c:ser>
        <c:ser>
          <c:idx val="54"/>
          <c:order val="5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57:$Q$57</c:f>
              <c:numCache>
                <c:formatCode>General</c:formatCode>
                <c:ptCount val="13"/>
                <c:pt idx="3" formatCode="0">
                  <c:v>3676.65</c:v>
                </c:pt>
                <c:pt idx="4" formatCode="0">
                  <c:v>4827.21</c:v>
                </c:pt>
                <c:pt idx="5" formatCode="0">
                  <c:v>7060</c:v>
                </c:pt>
                <c:pt idx="6" formatCode="0">
                  <c:v>7470.2</c:v>
                </c:pt>
                <c:pt idx="7" formatCode="0">
                  <c:v>8568.95999999999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6-7919-42C9-A73F-45F0F7AB17B2}"/>
            </c:ext>
          </c:extLst>
        </c:ser>
        <c:ser>
          <c:idx val="55"/>
          <c:order val="5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58:$Q$58</c:f>
              <c:numCache>
                <c:formatCode>General</c:formatCode>
                <c:ptCount val="13"/>
                <c:pt idx="3" formatCode="0">
                  <c:v>4963.4399999999996</c:v>
                </c:pt>
                <c:pt idx="4" formatCode="0">
                  <c:v>6502.18</c:v>
                </c:pt>
                <c:pt idx="5" formatCode="0">
                  <c:v>7334.5</c:v>
                </c:pt>
                <c:pt idx="6" formatCode="0">
                  <c:v>9847.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7-7919-42C9-A73F-45F0F7AB17B2}"/>
            </c:ext>
          </c:extLst>
        </c:ser>
        <c:ser>
          <c:idx val="56"/>
          <c:order val="5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59:$Q$59</c:f>
              <c:numCache>
                <c:formatCode>General</c:formatCode>
                <c:ptCount val="13"/>
                <c:pt idx="3" formatCode="0">
                  <c:v>2102.52</c:v>
                </c:pt>
                <c:pt idx="5" formatCode="0">
                  <c:v>3079.26</c:v>
                </c:pt>
                <c:pt idx="6" formatCode="0">
                  <c:v>2991.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8-7919-42C9-A73F-45F0F7AB17B2}"/>
            </c:ext>
          </c:extLst>
        </c:ser>
        <c:ser>
          <c:idx val="57"/>
          <c:order val="5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60:$Q$60</c:f>
              <c:numCache>
                <c:formatCode>General</c:formatCode>
                <c:ptCount val="13"/>
                <c:pt idx="3" formatCode="0">
                  <c:v>1172.72</c:v>
                </c:pt>
                <c:pt idx="4" formatCode="0">
                  <c:v>1408.98</c:v>
                </c:pt>
                <c:pt idx="6" formatCode="0">
                  <c:v>2099.81</c:v>
                </c:pt>
                <c:pt idx="7" formatCode="0">
                  <c:v>1212.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9-7919-42C9-A73F-45F0F7AB17B2}"/>
            </c:ext>
          </c:extLst>
        </c:ser>
        <c:ser>
          <c:idx val="58"/>
          <c:order val="5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61:$Q$61</c:f>
              <c:numCache>
                <c:formatCode>0</c:formatCode>
                <c:ptCount val="13"/>
                <c:pt idx="1">
                  <c:v>1501.93</c:v>
                </c:pt>
                <c:pt idx="5">
                  <c:v>2534.31</c:v>
                </c:pt>
                <c:pt idx="6">
                  <c:v>2289.64</c:v>
                </c:pt>
                <c:pt idx="7">
                  <c:v>1884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A-7919-42C9-A73F-45F0F7AB17B2}"/>
            </c:ext>
          </c:extLst>
        </c:ser>
        <c:ser>
          <c:idx val="59"/>
          <c:order val="5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62:$Q$62</c:f>
              <c:numCache>
                <c:formatCode>General</c:formatCode>
                <c:ptCount val="13"/>
                <c:pt idx="2" formatCode="0">
                  <c:v>2265.06</c:v>
                </c:pt>
                <c:pt idx="4" formatCode="0">
                  <c:v>2678.65</c:v>
                </c:pt>
                <c:pt idx="5" formatCode="0">
                  <c:v>2870.95</c:v>
                </c:pt>
                <c:pt idx="6" formatCode="0">
                  <c:v>2868.88</c:v>
                </c:pt>
                <c:pt idx="7" formatCode="0">
                  <c:v>2793.61</c:v>
                </c:pt>
                <c:pt idx="8" formatCode="0">
                  <c:v>2163.9699999999998</c:v>
                </c:pt>
                <c:pt idx="9" formatCode="0">
                  <c:v>2271.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B-7919-42C9-A73F-45F0F7AB17B2}"/>
            </c:ext>
          </c:extLst>
        </c:ser>
        <c:ser>
          <c:idx val="60"/>
          <c:order val="6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63:$Q$6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C-7919-42C9-A73F-45F0F7AB17B2}"/>
            </c:ext>
          </c:extLst>
        </c:ser>
        <c:ser>
          <c:idx val="61"/>
          <c:order val="6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64:$Q$64</c:f>
              <c:numCache>
                <c:formatCode>General</c:formatCode>
                <c:ptCount val="13"/>
                <c:pt idx="3" formatCode="0">
                  <c:v>1425.07</c:v>
                </c:pt>
                <c:pt idx="6" formatCode="0">
                  <c:v>1679.82</c:v>
                </c:pt>
                <c:pt idx="11" formatCode="0">
                  <c:v>1153.35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D-7919-42C9-A73F-45F0F7AB17B2}"/>
            </c:ext>
          </c:extLst>
        </c:ser>
        <c:ser>
          <c:idx val="62"/>
          <c:order val="6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65:$Q$65</c:f>
              <c:numCache>
                <c:formatCode>General</c:formatCode>
                <c:ptCount val="13"/>
                <c:pt idx="3" formatCode="0">
                  <c:v>2646.7</c:v>
                </c:pt>
                <c:pt idx="4" formatCode="0">
                  <c:v>2566.67</c:v>
                </c:pt>
                <c:pt idx="5" formatCode="0">
                  <c:v>2721.61</c:v>
                </c:pt>
                <c:pt idx="6" formatCode="0">
                  <c:v>3629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E-7919-42C9-A73F-45F0F7AB17B2}"/>
            </c:ext>
          </c:extLst>
        </c:ser>
        <c:ser>
          <c:idx val="63"/>
          <c:order val="6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66:$Q$66</c:f>
              <c:numCache>
                <c:formatCode>General</c:formatCode>
                <c:ptCount val="13"/>
                <c:pt idx="3" formatCode="0">
                  <c:v>1428.11</c:v>
                </c:pt>
                <c:pt idx="5" formatCode="0">
                  <c:v>1625.42</c:v>
                </c:pt>
                <c:pt idx="6" formatCode="0">
                  <c:v>1264.78</c:v>
                </c:pt>
                <c:pt idx="7" formatCode="0">
                  <c:v>1263.26</c:v>
                </c:pt>
                <c:pt idx="8" formatCode="0">
                  <c:v>1342.79</c:v>
                </c:pt>
                <c:pt idx="9" formatCode="0">
                  <c:v>1202.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F-7919-42C9-A73F-45F0F7AB17B2}"/>
            </c:ext>
          </c:extLst>
        </c:ser>
        <c:ser>
          <c:idx val="64"/>
          <c:order val="6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67:$Q$67</c:f>
              <c:numCache>
                <c:formatCode>General</c:formatCode>
                <c:ptCount val="13"/>
                <c:pt idx="3" formatCode="0">
                  <c:v>2968.58</c:v>
                </c:pt>
                <c:pt idx="4" formatCode="0">
                  <c:v>2748.09</c:v>
                </c:pt>
                <c:pt idx="5" formatCode="0">
                  <c:v>2634.64</c:v>
                </c:pt>
                <c:pt idx="6" formatCode="0">
                  <c:v>2479.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0-7919-42C9-A73F-45F0F7AB17B2}"/>
            </c:ext>
          </c:extLst>
        </c:ser>
        <c:ser>
          <c:idx val="65"/>
          <c:order val="6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68:$Q$68</c:f>
              <c:numCache>
                <c:formatCode>0</c:formatCode>
                <c:ptCount val="13"/>
                <c:pt idx="1">
                  <c:v>1718.66</c:v>
                </c:pt>
                <c:pt idx="3">
                  <c:v>1962.71</c:v>
                </c:pt>
                <c:pt idx="6">
                  <c:v>1962.99</c:v>
                </c:pt>
                <c:pt idx="7">
                  <c:v>1557.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1-7919-42C9-A73F-45F0F7AB17B2}"/>
            </c:ext>
          </c:extLst>
        </c:ser>
        <c:ser>
          <c:idx val="66"/>
          <c:order val="6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69:$Q$69</c:f>
              <c:numCache>
                <c:formatCode>General</c:formatCode>
                <c:ptCount val="13"/>
                <c:pt idx="4" formatCode="0">
                  <c:v>6052.62</c:v>
                </c:pt>
                <c:pt idx="5" formatCode="0">
                  <c:v>6262.53</c:v>
                </c:pt>
                <c:pt idx="6" formatCode="0">
                  <c:v>7406.91</c:v>
                </c:pt>
                <c:pt idx="7" formatCode="0">
                  <c:v>6352.4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2-7919-42C9-A73F-45F0F7AB17B2}"/>
            </c:ext>
          </c:extLst>
        </c:ser>
        <c:ser>
          <c:idx val="67"/>
          <c:order val="6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70:$Q$70</c:f>
              <c:numCache>
                <c:formatCode>General</c:formatCode>
                <c:ptCount val="13"/>
                <c:pt idx="2" formatCode="0">
                  <c:v>7126.51</c:v>
                </c:pt>
                <c:pt idx="3" formatCode="0">
                  <c:v>8185.27</c:v>
                </c:pt>
                <c:pt idx="5" formatCode="0">
                  <c:v>8485.7900000000009</c:v>
                </c:pt>
                <c:pt idx="6" formatCode="0">
                  <c:v>8710.7199999999993</c:v>
                </c:pt>
                <c:pt idx="7" formatCode="0">
                  <c:v>7539.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3-7919-42C9-A73F-45F0F7AB17B2}"/>
            </c:ext>
          </c:extLst>
        </c:ser>
        <c:ser>
          <c:idx val="68"/>
          <c:order val="6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71:$Q$71</c:f>
              <c:numCache>
                <c:formatCode>0</c:formatCode>
                <c:ptCount val="13"/>
                <c:pt idx="1">
                  <c:v>1427.31</c:v>
                </c:pt>
                <c:pt idx="3">
                  <c:v>1475.05</c:v>
                </c:pt>
                <c:pt idx="6">
                  <c:v>1709.46</c:v>
                </c:pt>
                <c:pt idx="7">
                  <c:v>1241.79</c:v>
                </c:pt>
                <c:pt idx="8">
                  <c:v>1270.4000000000001</c:v>
                </c:pt>
                <c:pt idx="9">
                  <c:v>1239.99</c:v>
                </c:pt>
                <c:pt idx="10">
                  <c:v>1194.47</c:v>
                </c:pt>
                <c:pt idx="11">
                  <c:v>1043.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4-7919-42C9-A73F-45F0F7AB17B2}"/>
            </c:ext>
          </c:extLst>
        </c:ser>
        <c:ser>
          <c:idx val="69"/>
          <c:order val="6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72:$Q$72</c:f>
              <c:numCache>
                <c:formatCode>General</c:formatCode>
                <c:ptCount val="13"/>
                <c:pt idx="2" formatCode="0">
                  <c:v>6200.61</c:v>
                </c:pt>
                <c:pt idx="3" formatCode="0">
                  <c:v>6825.52</c:v>
                </c:pt>
                <c:pt idx="4" formatCode="0">
                  <c:v>8351.8799999999992</c:v>
                </c:pt>
                <c:pt idx="5" formatCode="0">
                  <c:v>8688.9599999999991</c:v>
                </c:pt>
                <c:pt idx="6" formatCode="0">
                  <c:v>8091.38</c:v>
                </c:pt>
                <c:pt idx="7" formatCode="0">
                  <c:v>8007.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5-7919-42C9-A73F-45F0F7AB17B2}"/>
            </c:ext>
          </c:extLst>
        </c:ser>
        <c:ser>
          <c:idx val="70"/>
          <c:order val="7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73:$Q$73</c:f>
              <c:numCache>
                <c:formatCode>General</c:formatCode>
                <c:ptCount val="13"/>
                <c:pt idx="2" formatCode="0">
                  <c:v>3246.93</c:v>
                </c:pt>
                <c:pt idx="4" formatCode="0">
                  <c:v>3168.76</c:v>
                </c:pt>
                <c:pt idx="6" formatCode="0">
                  <c:v>3877.58</c:v>
                </c:pt>
                <c:pt idx="8" formatCode="0">
                  <c:v>2533.23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6-7919-42C9-A73F-45F0F7AB17B2}"/>
            </c:ext>
          </c:extLst>
        </c:ser>
        <c:ser>
          <c:idx val="71"/>
          <c:order val="7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74:$Q$74</c:f>
              <c:numCache>
                <c:formatCode>General</c:formatCode>
                <c:ptCount val="13"/>
                <c:pt idx="5" formatCode="0">
                  <c:v>7999.7129999999997</c:v>
                </c:pt>
                <c:pt idx="6" formatCode="0">
                  <c:v>7853.5339999999997</c:v>
                </c:pt>
                <c:pt idx="7" formatCode="0">
                  <c:v>6655.0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7-7919-42C9-A73F-45F0F7AB17B2}"/>
            </c:ext>
          </c:extLst>
        </c:ser>
        <c:ser>
          <c:idx val="72"/>
          <c:order val="7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75:$Q$75</c:f>
              <c:numCache>
                <c:formatCode>General</c:formatCode>
                <c:ptCount val="13"/>
                <c:pt idx="5" formatCode="0">
                  <c:v>6766.9960000000001</c:v>
                </c:pt>
                <c:pt idx="6" formatCode="0">
                  <c:v>5553.6009999999997</c:v>
                </c:pt>
                <c:pt idx="7" formatCode="0">
                  <c:v>4948.6580000000004</c:v>
                </c:pt>
                <c:pt idx="8" formatCode="0">
                  <c:v>5478.180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8-7919-42C9-A73F-45F0F7AB17B2}"/>
            </c:ext>
          </c:extLst>
        </c:ser>
        <c:ser>
          <c:idx val="73"/>
          <c:order val="7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76:$Q$76</c:f>
              <c:numCache>
                <c:formatCode>General</c:formatCode>
                <c:ptCount val="13"/>
                <c:pt idx="5" formatCode="0">
                  <c:v>454.80900000000003</c:v>
                </c:pt>
                <c:pt idx="6" formatCode="0">
                  <c:v>471.64800000000002</c:v>
                </c:pt>
                <c:pt idx="8" formatCode="0">
                  <c:v>376.96</c:v>
                </c:pt>
                <c:pt idx="9" formatCode="0">
                  <c:v>369.23500000000001</c:v>
                </c:pt>
                <c:pt idx="10" formatCode="0">
                  <c:v>279.545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9-7919-42C9-A73F-45F0F7AB17B2}"/>
            </c:ext>
          </c:extLst>
        </c:ser>
        <c:ser>
          <c:idx val="74"/>
          <c:order val="7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77:$Q$77</c:f>
              <c:numCache>
                <c:formatCode>General</c:formatCode>
                <c:ptCount val="13"/>
                <c:pt idx="4" formatCode="0">
                  <c:v>2279.163</c:v>
                </c:pt>
                <c:pt idx="5" formatCode="0">
                  <c:v>2429.2040000000002</c:v>
                </c:pt>
                <c:pt idx="6" formatCode="0">
                  <c:v>2304.91</c:v>
                </c:pt>
                <c:pt idx="7" formatCode="0">
                  <c:v>2280.395</c:v>
                </c:pt>
                <c:pt idx="8" formatCode="0">
                  <c:v>2139.831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A-7919-42C9-A73F-45F0F7AB17B2}"/>
            </c:ext>
          </c:extLst>
        </c:ser>
        <c:ser>
          <c:idx val="75"/>
          <c:order val="7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78:$Q$78</c:f>
              <c:numCache>
                <c:formatCode>General</c:formatCode>
                <c:ptCount val="13"/>
                <c:pt idx="4" formatCode="0">
                  <c:v>4568.1890000000003</c:v>
                </c:pt>
                <c:pt idx="5" formatCode="0">
                  <c:v>4893.5640000000003</c:v>
                </c:pt>
                <c:pt idx="6" formatCode="0">
                  <c:v>4489.819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B-7919-42C9-A73F-45F0F7AB17B2}"/>
            </c:ext>
          </c:extLst>
        </c:ser>
        <c:ser>
          <c:idx val="76"/>
          <c:order val="7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79:$Q$79</c:f>
              <c:numCache>
                <c:formatCode>General</c:formatCode>
                <c:ptCount val="13"/>
                <c:pt idx="4" formatCode="0">
                  <c:v>4310.1239999999998</c:v>
                </c:pt>
                <c:pt idx="6" formatCode="0">
                  <c:v>4409.3239999999996</c:v>
                </c:pt>
                <c:pt idx="7" formatCode="0">
                  <c:v>3417.847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C-7919-42C9-A73F-45F0F7AB17B2}"/>
            </c:ext>
          </c:extLst>
        </c:ser>
        <c:ser>
          <c:idx val="77"/>
          <c:order val="7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80:$Q$80</c:f>
              <c:numCache>
                <c:formatCode>General</c:formatCode>
                <c:ptCount val="13"/>
                <c:pt idx="6" formatCode="0">
                  <c:v>1665.3789999999999</c:v>
                </c:pt>
                <c:pt idx="7" formatCode="0">
                  <c:v>1326.8979999999999</c:v>
                </c:pt>
                <c:pt idx="8" formatCode="0">
                  <c:v>1293.098</c:v>
                </c:pt>
                <c:pt idx="11" formatCode="0">
                  <c:v>1095.9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D-7919-42C9-A73F-45F0F7AB17B2}"/>
            </c:ext>
          </c:extLst>
        </c:ser>
        <c:ser>
          <c:idx val="78"/>
          <c:order val="7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81:$Q$81</c:f>
              <c:numCache>
                <c:formatCode>General</c:formatCode>
                <c:ptCount val="13"/>
                <c:pt idx="4" formatCode="0">
                  <c:v>3346.0720000000001</c:v>
                </c:pt>
                <c:pt idx="6" formatCode="0">
                  <c:v>4156.5249999999996</c:v>
                </c:pt>
                <c:pt idx="7" formatCode="0">
                  <c:v>3778.2950000000001</c:v>
                </c:pt>
                <c:pt idx="9" formatCode="0">
                  <c:v>3125.03</c:v>
                </c:pt>
                <c:pt idx="11" formatCode="0">
                  <c:v>3150.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E-7919-42C9-A73F-45F0F7AB17B2}"/>
            </c:ext>
          </c:extLst>
        </c:ser>
        <c:ser>
          <c:idx val="79"/>
          <c:order val="7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82:$Q$82</c:f>
              <c:numCache>
                <c:formatCode>0</c:formatCode>
                <c:ptCount val="13"/>
                <c:pt idx="0">
                  <c:v>1823.0989999999999</c:v>
                </c:pt>
                <c:pt idx="1">
                  <c:v>2031.1220000000001</c:v>
                </c:pt>
                <c:pt idx="2">
                  <c:v>2090.8000000000002</c:v>
                </c:pt>
                <c:pt idx="3">
                  <c:v>2132.17</c:v>
                </c:pt>
                <c:pt idx="4">
                  <c:v>2282.88</c:v>
                </c:pt>
                <c:pt idx="6">
                  <c:v>2092.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F-7919-42C9-A73F-45F0F7AB17B2}"/>
            </c:ext>
          </c:extLst>
        </c:ser>
        <c:ser>
          <c:idx val="80"/>
          <c:order val="8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83:$Q$83</c:f>
              <c:numCache>
                <c:formatCode>General</c:formatCode>
                <c:ptCount val="13"/>
                <c:pt idx="5" formatCode="0">
                  <c:v>908.68</c:v>
                </c:pt>
                <c:pt idx="6" formatCode="0">
                  <c:v>771.49</c:v>
                </c:pt>
                <c:pt idx="7" formatCode="0">
                  <c:v>635.15</c:v>
                </c:pt>
                <c:pt idx="8" formatCode="0">
                  <c:v>520.91999999999996</c:v>
                </c:pt>
                <c:pt idx="9" formatCode="0">
                  <c:v>507.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0-7919-42C9-A73F-45F0F7AB17B2}"/>
            </c:ext>
          </c:extLst>
        </c:ser>
        <c:ser>
          <c:idx val="81"/>
          <c:order val="8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84:$Q$84</c:f>
              <c:numCache>
                <c:formatCode>General</c:formatCode>
                <c:ptCount val="13"/>
                <c:pt idx="4" formatCode="0">
                  <c:v>1595.174</c:v>
                </c:pt>
                <c:pt idx="6" formatCode="0">
                  <c:v>1954.3019999999999</c:v>
                </c:pt>
                <c:pt idx="11" formatCode="0">
                  <c:v>2313.51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1-7919-42C9-A73F-45F0F7AB17B2}"/>
            </c:ext>
          </c:extLst>
        </c:ser>
        <c:ser>
          <c:idx val="82"/>
          <c:order val="8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85:$Q$8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2-7919-42C9-A73F-45F0F7AB17B2}"/>
            </c:ext>
          </c:extLst>
        </c:ser>
        <c:ser>
          <c:idx val="83"/>
          <c:order val="8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86:$Q$86</c:f>
              <c:numCache>
                <c:formatCode>General</c:formatCode>
                <c:ptCount val="13"/>
                <c:pt idx="5" formatCode="0">
                  <c:v>3151.25</c:v>
                </c:pt>
                <c:pt idx="6" formatCode="0">
                  <c:v>3456.78</c:v>
                </c:pt>
                <c:pt idx="7" formatCode="0">
                  <c:v>2690.77</c:v>
                </c:pt>
                <c:pt idx="8" formatCode="0">
                  <c:v>2628.6</c:v>
                </c:pt>
                <c:pt idx="9" formatCode="0">
                  <c:v>2441.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3-7919-42C9-A73F-45F0F7AB17B2}"/>
            </c:ext>
          </c:extLst>
        </c:ser>
        <c:ser>
          <c:idx val="84"/>
          <c:order val="8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87:$Q$87</c:f>
              <c:numCache>
                <c:formatCode>0</c:formatCode>
                <c:ptCount val="13"/>
                <c:pt idx="1">
                  <c:v>5370.3</c:v>
                </c:pt>
                <c:pt idx="2">
                  <c:v>5445.4</c:v>
                </c:pt>
                <c:pt idx="3">
                  <c:v>5816.81</c:v>
                </c:pt>
                <c:pt idx="4">
                  <c:v>6604.06</c:v>
                </c:pt>
                <c:pt idx="5">
                  <c:v>7101.95</c:v>
                </c:pt>
                <c:pt idx="6">
                  <c:v>8025.15</c:v>
                </c:pt>
                <c:pt idx="7">
                  <c:v>8301.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4-7919-42C9-A73F-45F0F7AB17B2}"/>
            </c:ext>
          </c:extLst>
        </c:ser>
        <c:ser>
          <c:idx val="85"/>
          <c:order val="8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88:$Q$88</c:f>
              <c:numCache>
                <c:formatCode>General</c:formatCode>
                <c:ptCount val="13"/>
                <c:pt idx="5" formatCode="0">
                  <c:v>6721.35</c:v>
                </c:pt>
                <c:pt idx="6" formatCode="0">
                  <c:v>7260.39</c:v>
                </c:pt>
                <c:pt idx="8" formatCode="0">
                  <c:v>7994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5-7919-42C9-A73F-45F0F7AB17B2}"/>
            </c:ext>
          </c:extLst>
        </c:ser>
        <c:ser>
          <c:idx val="86"/>
          <c:order val="8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89:$Q$89</c:f>
              <c:numCache>
                <c:formatCode>0</c:formatCode>
                <c:ptCount val="13"/>
                <c:pt idx="0">
                  <c:v>1460.13</c:v>
                </c:pt>
                <c:pt idx="1">
                  <c:v>2138.25</c:v>
                </c:pt>
                <c:pt idx="2">
                  <c:v>2039.6</c:v>
                </c:pt>
                <c:pt idx="3">
                  <c:v>2113.38</c:v>
                </c:pt>
                <c:pt idx="4">
                  <c:v>2228.9</c:v>
                </c:pt>
                <c:pt idx="6">
                  <c:v>2701.77</c:v>
                </c:pt>
                <c:pt idx="8">
                  <c:v>2789.7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6-7919-42C9-A73F-45F0F7AB17B2}"/>
            </c:ext>
          </c:extLst>
        </c:ser>
        <c:ser>
          <c:idx val="87"/>
          <c:order val="8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90:$Q$90</c:f>
              <c:numCache>
                <c:formatCode>General</c:formatCode>
                <c:ptCount val="13"/>
                <c:pt idx="4" formatCode="0">
                  <c:v>1429.9</c:v>
                </c:pt>
                <c:pt idx="5" formatCode="0">
                  <c:v>1245.05</c:v>
                </c:pt>
                <c:pt idx="6" formatCode="0">
                  <c:v>1304.8900000000001</c:v>
                </c:pt>
                <c:pt idx="7" formatCode="0">
                  <c:v>1340.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7-7919-42C9-A73F-45F0F7AB17B2}"/>
            </c:ext>
          </c:extLst>
        </c:ser>
        <c:ser>
          <c:idx val="88"/>
          <c:order val="8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91:$Q$91</c:f>
              <c:numCache>
                <c:formatCode>0</c:formatCode>
                <c:ptCount val="13"/>
                <c:pt idx="0">
                  <c:v>1548.22</c:v>
                </c:pt>
                <c:pt idx="1">
                  <c:v>1758.92</c:v>
                </c:pt>
                <c:pt idx="2">
                  <c:v>1872.52</c:v>
                </c:pt>
                <c:pt idx="4">
                  <c:v>2370.1</c:v>
                </c:pt>
                <c:pt idx="5">
                  <c:v>3384.34</c:v>
                </c:pt>
                <c:pt idx="6">
                  <c:v>5053.7</c:v>
                </c:pt>
                <c:pt idx="7">
                  <c:v>4582.60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8-7919-42C9-A73F-45F0F7AB17B2}"/>
            </c:ext>
          </c:extLst>
        </c:ser>
        <c:ser>
          <c:idx val="89"/>
          <c:order val="8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92:$Q$92</c:f>
              <c:numCache>
                <c:formatCode>General</c:formatCode>
                <c:ptCount val="13"/>
                <c:pt idx="2" formatCode="0">
                  <c:v>1503.17</c:v>
                </c:pt>
                <c:pt idx="3" formatCode="0">
                  <c:v>1640.28</c:v>
                </c:pt>
                <c:pt idx="4" formatCode="0">
                  <c:v>1846.24</c:v>
                </c:pt>
                <c:pt idx="5" formatCode="0">
                  <c:v>1863.77</c:v>
                </c:pt>
                <c:pt idx="6" formatCode="0">
                  <c:v>2204.36</c:v>
                </c:pt>
                <c:pt idx="7" formatCode="0">
                  <c:v>1961.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9-7919-42C9-A73F-45F0F7AB17B2}"/>
            </c:ext>
          </c:extLst>
        </c:ser>
        <c:ser>
          <c:idx val="90"/>
          <c:order val="9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93:$Q$93</c:f>
              <c:numCache>
                <c:formatCode>0</c:formatCode>
                <c:ptCount val="13"/>
                <c:pt idx="1">
                  <c:v>2494.23</c:v>
                </c:pt>
                <c:pt idx="2">
                  <c:v>2821.79</c:v>
                </c:pt>
                <c:pt idx="6">
                  <c:v>3999.23</c:v>
                </c:pt>
                <c:pt idx="7">
                  <c:v>3875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A-7919-42C9-A73F-45F0F7AB17B2}"/>
            </c:ext>
          </c:extLst>
        </c:ser>
        <c:ser>
          <c:idx val="91"/>
          <c:order val="9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94:$Q$94</c:f>
              <c:numCache>
                <c:formatCode>General</c:formatCode>
                <c:ptCount val="13"/>
                <c:pt idx="3" formatCode="0">
                  <c:v>570</c:v>
                </c:pt>
                <c:pt idx="4" formatCode="0">
                  <c:v>618.05999999999995</c:v>
                </c:pt>
                <c:pt idx="5" formatCode="0">
                  <c:v>664.67</c:v>
                </c:pt>
                <c:pt idx="6" formatCode="0">
                  <c:v>674.52</c:v>
                </c:pt>
                <c:pt idx="7" formatCode="0">
                  <c:v>427.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B-7919-42C9-A73F-45F0F7AB17B2}"/>
            </c:ext>
          </c:extLst>
        </c:ser>
        <c:ser>
          <c:idx val="92"/>
          <c:order val="9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95:$Q$95</c:f>
              <c:numCache>
                <c:formatCode>General</c:formatCode>
                <c:ptCount val="13"/>
                <c:pt idx="4" formatCode="0">
                  <c:v>923.97</c:v>
                </c:pt>
                <c:pt idx="6" formatCode="0">
                  <c:v>981.57</c:v>
                </c:pt>
                <c:pt idx="7" formatCode="0">
                  <c:v>1002.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C-7919-42C9-A73F-45F0F7AB17B2}"/>
            </c:ext>
          </c:extLst>
        </c:ser>
        <c:ser>
          <c:idx val="93"/>
          <c:order val="9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96:$Q$9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D-7919-42C9-A73F-45F0F7AB17B2}"/>
            </c:ext>
          </c:extLst>
        </c:ser>
        <c:ser>
          <c:idx val="94"/>
          <c:order val="9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HD (実測)'!$E$97:$Q$97</c:f>
              <c:numCache>
                <c:formatCode>0</c:formatCode>
                <c:ptCount val="13"/>
                <c:pt idx="0">
                  <c:v>2195.0700000000002</c:v>
                </c:pt>
                <c:pt idx="1">
                  <c:v>2248.83</c:v>
                </c:pt>
                <c:pt idx="2">
                  <c:v>2279.21</c:v>
                </c:pt>
                <c:pt idx="3">
                  <c:v>2447.31</c:v>
                </c:pt>
                <c:pt idx="4">
                  <c:v>2544.86</c:v>
                </c:pt>
                <c:pt idx="5">
                  <c:v>2198.5100000000002</c:v>
                </c:pt>
                <c:pt idx="6">
                  <c:v>2450.7800000000002</c:v>
                </c:pt>
                <c:pt idx="7">
                  <c:v>2306.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E-7919-42C9-A73F-45F0F7AB17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7149664"/>
        <c:axId val="397147704"/>
      </c:lineChart>
      <c:catAx>
        <c:axId val="3971496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 sz="1600" baseline="0"/>
            </a:pPr>
            <a:endParaRPr lang="ja-JP"/>
          </a:p>
        </c:txPr>
        <c:crossAx val="397147704"/>
        <c:crosses val="autoZero"/>
        <c:auto val="1"/>
        <c:lblAlgn val="ctr"/>
        <c:lblOffset val="100"/>
        <c:noMultiLvlLbl val="0"/>
      </c:catAx>
      <c:valAx>
        <c:axId val="397147704"/>
        <c:scaling>
          <c:orientation val="minMax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 lang="ja-JP" sz="1800" baseline="0"/>
                </a:pPr>
                <a:r>
                  <a:rPr lang="en-US" altLang="ja-JP" sz="1800" baseline="0" dirty="0"/>
                  <a:t>TKV (mL)</a:t>
                </a:r>
                <a:endParaRPr lang="ja-JP" altLang="en-US" sz="1800" baseline="0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 sz="1600" baseline="0"/>
            </a:pPr>
            <a:endParaRPr lang="ja-JP"/>
          </a:p>
        </c:txPr>
        <c:crossAx val="397149664"/>
        <c:crosses val="autoZero"/>
        <c:crossBetween val="between"/>
      </c:valAx>
    </c:plotArea>
    <c:plotVisOnly val="1"/>
    <c:dispBlanksAs val="span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763128706544081"/>
          <c:y val="3.9719719210841817E-2"/>
          <c:w val="0.85653832310643163"/>
          <c:h val="0.86293354345919704"/>
        </c:manualLayout>
      </c:layout>
      <c:lineChart>
        <c:grouping val="standard"/>
        <c:varyColors val="0"/>
        <c:ser>
          <c:idx val="0"/>
          <c:order val="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3:$Q$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2F2-4461-B821-F7205143E38B}"/>
            </c:ext>
          </c:extLst>
        </c:ser>
        <c:ser>
          <c:idx val="1"/>
          <c:order val="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4:$Q$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2F2-4461-B821-F7205143E38B}"/>
            </c:ext>
          </c:extLst>
        </c:ser>
        <c:ser>
          <c:idx val="2"/>
          <c:order val="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5:$Q$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2F2-4461-B821-F7205143E38B}"/>
            </c:ext>
          </c:extLst>
        </c:ser>
        <c:ser>
          <c:idx val="3"/>
          <c:order val="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6:$Q$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2F2-4461-B821-F7205143E38B}"/>
            </c:ext>
          </c:extLst>
        </c:ser>
        <c:ser>
          <c:idx val="4"/>
          <c:order val="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7:$Q$7</c:f>
              <c:numCache>
                <c:formatCode>General</c:formatCode>
                <c:ptCount val="13"/>
                <c:pt idx="3" formatCode="0">
                  <c:v>3249.3809999999999</c:v>
                </c:pt>
                <c:pt idx="5" formatCode="0">
                  <c:v>3819.5639999999999</c:v>
                </c:pt>
                <c:pt idx="6" formatCode="0">
                  <c:v>4624.3999999999996</c:v>
                </c:pt>
                <c:pt idx="7" formatCode="0">
                  <c:v>5787.632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32F2-4461-B821-F7205143E38B}"/>
            </c:ext>
          </c:extLst>
        </c:ser>
        <c:ser>
          <c:idx val="5"/>
          <c:order val="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8:$Q$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32F2-4461-B821-F7205143E38B}"/>
            </c:ext>
          </c:extLst>
        </c:ser>
        <c:ser>
          <c:idx val="6"/>
          <c:order val="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9:$Q$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32F2-4461-B821-F7205143E38B}"/>
            </c:ext>
          </c:extLst>
        </c:ser>
        <c:ser>
          <c:idx val="7"/>
          <c:order val="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10:$Q$10</c:f>
              <c:numCache>
                <c:formatCode>General</c:formatCode>
                <c:ptCount val="13"/>
                <c:pt idx="4" formatCode="0">
                  <c:v>2270.9780000000001</c:v>
                </c:pt>
                <c:pt idx="6" formatCode="0">
                  <c:v>1955.54</c:v>
                </c:pt>
                <c:pt idx="7" formatCode="0">
                  <c:v>2140.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32F2-4461-B821-F7205143E38B}"/>
            </c:ext>
          </c:extLst>
        </c:ser>
        <c:ser>
          <c:idx val="8"/>
          <c:order val="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11:$Q$1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32F2-4461-B821-F7205143E38B}"/>
            </c:ext>
          </c:extLst>
        </c:ser>
        <c:ser>
          <c:idx val="9"/>
          <c:order val="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12:$Q$1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32F2-4461-B821-F7205143E38B}"/>
            </c:ext>
          </c:extLst>
        </c:ser>
        <c:ser>
          <c:idx val="10"/>
          <c:order val="1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13:$Q$1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32F2-4461-B821-F7205143E38B}"/>
            </c:ext>
          </c:extLst>
        </c:ser>
        <c:ser>
          <c:idx val="11"/>
          <c:order val="1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14:$Q$1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32F2-4461-B821-F7205143E38B}"/>
            </c:ext>
          </c:extLst>
        </c:ser>
        <c:ser>
          <c:idx val="12"/>
          <c:order val="1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15:$Q$1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32F2-4461-B821-F7205143E38B}"/>
            </c:ext>
          </c:extLst>
        </c:ser>
        <c:ser>
          <c:idx val="13"/>
          <c:order val="1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16:$Q$16</c:f>
              <c:numCache>
                <c:formatCode>General</c:formatCode>
                <c:ptCount val="13"/>
                <c:pt idx="3" formatCode="0">
                  <c:v>842.31200000000001</c:v>
                </c:pt>
                <c:pt idx="4" formatCode="0">
                  <c:v>926.226</c:v>
                </c:pt>
                <c:pt idx="5" formatCode="0">
                  <c:v>1016.77</c:v>
                </c:pt>
                <c:pt idx="6" formatCode="0">
                  <c:v>1147.8499999999999</c:v>
                </c:pt>
                <c:pt idx="7" formatCode="0">
                  <c:v>1080.01</c:v>
                </c:pt>
                <c:pt idx="8" formatCode="0">
                  <c:v>714.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32F2-4461-B821-F7205143E38B}"/>
            </c:ext>
          </c:extLst>
        </c:ser>
        <c:ser>
          <c:idx val="14"/>
          <c:order val="1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17:$Q$1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32F2-4461-B821-F7205143E38B}"/>
            </c:ext>
          </c:extLst>
        </c:ser>
        <c:ser>
          <c:idx val="15"/>
          <c:order val="1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18:$Q$1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32F2-4461-B821-F7205143E38B}"/>
            </c:ext>
          </c:extLst>
        </c:ser>
        <c:ser>
          <c:idx val="16"/>
          <c:order val="1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19:$Q$1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32F2-4461-B821-F7205143E38B}"/>
            </c:ext>
          </c:extLst>
        </c:ser>
        <c:ser>
          <c:idx val="17"/>
          <c:order val="1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20:$Q$2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32F2-4461-B821-F7205143E38B}"/>
            </c:ext>
          </c:extLst>
        </c:ser>
        <c:ser>
          <c:idx val="18"/>
          <c:order val="1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21:$Q$21</c:f>
              <c:numCache>
                <c:formatCode>General</c:formatCode>
                <c:ptCount val="13"/>
                <c:pt idx="2" formatCode="0">
                  <c:v>1308.306</c:v>
                </c:pt>
                <c:pt idx="4" formatCode="0">
                  <c:v>1288.43</c:v>
                </c:pt>
                <c:pt idx="6" formatCode="0">
                  <c:v>1726.59</c:v>
                </c:pt>
                <c:pt idx="7" formatCode="0">
                  <c:v>19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32F2-4461-B821-F7205143E38B}"/>
            </c:ext>
          </c:extLst>
        </c:ser>
        <c:ser>
          <c:idx val="19"/>
          <c:order val="1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22:$Q$2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32F2-4461-B821-F7205143E38B}"/>
            </c:ext>
          </c:extLst>
        </c:ser>
        <c:ser>
          <c:idx val="20"/>
          <c:order val="2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23:$Q$2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32F2-4461-B821-F7205143E38B}"/>
            </c:ext>
          </c:extLst>
        </c:ser>
        <c:ser>
          <c:idx val="21"/>
          <c:order val="2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24:$Q$2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32F2-4461-B821-F7205143E38B}"/>
            </c:ext>
          </c:extLst>
        </c:ser>
        <c:ser>
          <c:idx val="22"/>
          <c:order val="2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25:$Q$2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32F2-4461-B821-F7205143E38B}"/>
            </c:ext>
          </c:extLst>
        </c:ser>
        <c:ser>
          <c:idx val="23"/>
          <c:order val="2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26:$Q$2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32F2-4461-B821-F7205143E38B}"/>
            </c:ext>
          </c:extLst>
        </c:ser>
        <c:ser>
          <c:idx val="24"/>
          <c:order val="2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27:$Q$2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32F2-4461-B821-F7205143E38B}"/>
            </c:ext>
          </c:extLst>
        </c:ser>
        <c:ser>
          <c:idx val="25"/>
          <c:order val="2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28:$Q$2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32F2-4461-B821-F7205143E38B}"/>
            </c:ext>
          </c:extLst>
        </c:ser>
        <c:ser>
          <c:idx val="26"/>
          <c:order val="2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29:$Q$2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32F2-4461-B821-F7205143E38B}"/>
            </c:ext>
          </c:extLst>
        </c:ser>
        <c:ser>
          <c:idx val="27"/>
          <c:order val="2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30:$Q$3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32F2-4461-B821-F7205143E38B}"/>
            </c:ext>
          </c:extLst>
        </c:ser>
        <c:ser>
          <c:idx val="28"/>
          <c:order val="28"/>
          <c:marker>
            <c:symbol val="none"/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31:$Q$3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32F2-4461-B821-F7205143E38B}"/>
            </c:ext>
          </c:extLst>
        </c:ser>
        <c:ser>
          <c:idx val="29"/>
          <c:order val="2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32:$Q$32</c:f>
              <c:numCache>
                <c:formatCode>General</c:formatCode>
                <c:ptCount val="13"/>
                <c:pt idx="2" formatCode="0">
                  <c:v>2668.8719999999998</c:v>
                </c:pt>
                <c:pt idx="4" formatCode="0">
                  <c:v>3775.93</c:v>
                </c:pt>
                <c:pt idx="5" formatCode="0">
                  <c:v>4636.8900000000003</c:v>
                </c:pt>
                <c:pt idx="6" formatCode="0">
                  <c:v>4944.83</c:v>
                </c:pt>
                <c:pt idx="7" formatCode="0">
                  <c:v>5551.14</c:v>
                </c:pt>
                <c:pt idx="8" formatCode="0">
                  <c:v>6877.26</c:v>
                </c:pt>
                <c:pt idx="9" formatCode="0">
                  <c:v>8380.68</c:v>
                </c:pt>
                <c:pt idx="10" formatCode="0">
                  <c:v>9748.43</c:v>
                </c:pt>
                <c:pt idx="11" formatCode="0">
                  <c:v>9904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32F2-4461-B821-F7205143E38B}"/>
            </c:ext>
          </c:extLst>
        </c:ser>
        <c:ser>
          <c:idx val="30"/>
          <c:order val="3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33:$Q$3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32F2-4461-B821-F7205143E38B}"/>
            </c:ext>
          </c:extLst>
        </c:ser>
        <c:ser>
          <c:idx val="31"/>
          <c:order val="3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34:$Q$3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32F2-4461-B821-F7205143E38B}"/>
            </c:ext>
          </c:extLst>
        </c:ser>
        <c:ser>
          <c:idx val="32"/>
          <c:order val="3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35:$Q$3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32F2-4461-B821-F7205143E38B}"/>
            </c:ext>
          </c:extLst>
        </c:ser>
        <c:ser>
          <c:idx val="33"/>
          <c:order val="3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36:$Q$3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32F2-4461-B821-F7205143E38B}"/>
            </c:ext>
          </c:extLst>
        </c:ser>
        <c:ser>
          <c:idx val="34"/>
          <c:order val="3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37:$Q$3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32F2-4461-B821-F7205143E38B}"/>
            </c:ext>
          </c:extLst>
        </c:ser>
        <c:ser>
          <c:idx val="35"/>
          <c:order val="3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38:$Q$3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32F2-4461-B821-F7205143E38B}"/>
            </c:ext>
          </c:extLst>
        </c:ser>
        <c:ser>
          <c:idx val="36"/>
          <c:order val="3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39:$Q$39</c:f>
              <c:numCache>
                <c:formatCode>General</c:formatCode>
                <c:ptCount val="13"/>
                <c:pt idx="5" formatCode="0">
                  <c:v>5788.29</c:v>
                </c:pt>
                <c:pt idx="6" formatCode="0">
                  <c:v>6133.29</c:v>
                </c:pt>
                <c:pt idx="7" formatCode="0">
                  <c:v>7130.33</c:v>
                </c:pt>
                <c:pt idx="8" formatCode="0">
                  <c:v>9407.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32F2-4461-B821-F7205143E38B}"/>
            </c:ext>
          </c:extLst>
        </c:ser>
        <c:ser>
          <c:idx val="37"/>
          <c:order val="3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40:$Q$4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32F2-4461-B821-F7205143E38B}"/>
            </c:ext>
          </c:extLst>
        </c:ser>
        <c:ser>
          <c:idx val="38"/>
          <c:order val="3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41:$Q$4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32F2-4461-B821-F7205143E38B}"/>
            </c:ext>
          </c:extLst>
        </c:ser>
        <c:ser>
          <c:idx val="39"/>
          <c:order val="3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42:$Q$42</c:f>
              <c:numCache>
                <c:formatCode>General</c:formatCode>
                <c:ptCount val="13"/>
                <c:pt idx="2" formatCode="0">
                  <c:v>1663.9110000000001</c:v>
                </c:pt>
                <c:pt idx="5" formatCode="0">
                  <c:v>1959.46</c:v>
                </c:pt>
                <c:pt idx="6" formatCode="0">
                  <c:v>2089.4699999999998</c:v>
                </c:pt>
                <c:pt idx="7" formatCode="0">
                  <c:v>2003.79</c:v>
                </c:pt>
                <c:pt idx="8" formatCode="0">
                  <c:v>2478.6999999999998</c:v>
                </c:pt>
                <c:pt idx="9" formatCode="0">
                  <c:v>2489.44</c:v>
                </c:pt>
                <c:pt idx="10" formatCode="0">
                  <c:v>2587.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32F2-4461-B821-F7205143E38B}"/>
            </c:ext>
          </c:extLst>
        </c:ser>
        <c:ser>
          <c:idx val="40"/>
          <c:order val="4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43:$Q$4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32F2-4461-B821-F7205143E38B}"/>
            </c:ext>
          </c:extLst>
        </c:ser>
        <c:ser>
          <c:idx val="41"/>
          <c:order val="4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44:$Q$4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32F2-4461-B821-F7205143E38B}"/>
            </c:ext>
          </c:extLst>
        </c:ser>
        <c:ser>
          <c:idx val="42"/>
          <c:order val="4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45:$Q$4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32F2-4461-B821-F7205143E38B}"/>
            </c:ext>
          </c:extLst>
        </c:ser>
        <c:ser>
          <c:idx val="43"/>
          <c:order val="4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46:$Q$4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32F2-4461-B821-F7205143E38B}"/>
            </c:ext>
          </c:extLst>
        </c:ser>
        <c:ser>
          <c:idx val="44"/>
          <c:order val="4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47:$Q$4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32F2-4461-B821-F7205143E38B}"/>
            </c:ext>
          </c:extLst>
        </c:ser>
        <c:ser>
          <c:idx val="45"/>
          <c:order val="4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48:$Q$4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32F2-4461-B821-F7205143E38B}"/>
            </c:ext>
          </c:extLst>
        </c:ser>
        <c:ser>
          <c:idx val="46"/>
          <c:order val="4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49:$Q$4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32F2-4461-B821-F7205143E38B}"/>
            </c:ext>
          </c:extLst>
        </c:ser>
        <c:ser>
          <c:idx val="47"/>
          <c:order val="4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50:$Q$5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32F2-4461-B821-F7205143E38B}"/>
            </c:ext>
          </c:extLst>
        </c:ser>
        <c:ser>
          <c:idx val="48"/>
          <c:order val="4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51:$Q$5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32F2-4461-B821-F7205143E38B}"/>
            </c:ext>
          </c:extLst>
        </c:ser>
        <c:ser>
          <c:idx val="49"/>
          <c:order val="4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52:$Q$5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32F2-4461-B821-F7205143E38B}"/>
            </c:ext>
          </c:extLst>
        </c:ser>
        <c:ser>
          <c:idx val="50"/>
          <c:order val="5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53:$Q$5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2-32F2-4461-B821-F7205143E38B}"/>
            </c:ext>
          </c:extLst>
        </c:ser>
        <c:ser>
          <c:idx val="51"/>
          <c:order val="5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54:$Q$5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3-32F2-4461-B821-F7205143E38B}"/>
            </c:ext>
          </c:extLst>
        </c:ser>
        <c:ser>
          <c:idx val="52"/>
          <c:order val="5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55:$Q$5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4-32F2-4461-B821-F7205143E38B}"/>
            </c:ext>
          </c:extLst>
        </c:ser>
        <c:ser>
          <c:idx val="53"/>
          <c:order val="5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56:$Q$5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5-32F2-4461-B821-F7205143E38B}"/>
            </c:ext>
          </c:extLst>
        </c:ser>
        <c:ser>
          <c:idx val="54"/>
          <c:order val="5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57:$Q$5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6-32F2-4461-B821-F7205143E38B}"/>
            </c:ext>
          </c:extLst>
        </c:ser>
        <c:ser>
          <c:idx val="55"/>
          <c:order val="5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58:$Q$5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7-32F2-4461-B821-F7205143E38B}"/>
            </c:ext>
          </c:extLst>
        </c:ser>
        <c:ser>
          <c:idx val="56"/>
          <c:order val="5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59:$Q$5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8-32F2-4461-B821-F7205143E38B}"/>
            </c:ext>
          </c:extLst>
        </c:ser>
        <c:ser>
          <c:idx val="57"/>
          <c:order val="5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60:$Q$6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9-32F2-4461-B821-F7205143E38B}"/>
            </c:ext>
          </c:extLst>
        </c:ser>
        <c:ser>
          <c:idx val="58"/>
          <c:order val="5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61:$Q$6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A-32F2-4461-B821-F7205143E38B}"/>
            </c:ext>
          </c:extLst>
        </c:ser>
        <c:ser>
          <c:idx val="59"/>
          <c:order val="5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62:$Q$6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B-32F2-4461-B821-F7205143E38B}"/>
            </c:ext>
          </c:extLst>
        </c:ser>
        <c:ser>
          <c:idx val="60"/>
          <c:order val="6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63:$Q$63</c:f>
              <c:numCache>
                <c:formatCode>General</c:formatCode>
                <c:ptCount val="13"/>
                <c:pt idx="2" formatCode="0">
                  <c:v>2468.6</c:v>
                </c:pt>
                <c:pt idx="3" formatCode="0">
                  <c:v>2794.99</c:v>
                </c:pt>
                <c:pt idx="4" formatCode="0">
                  <c:v>3192.16</c:v>
                </c:pt>
                <c:pt idx="5" formatCode="0">
                  <c:v>3991.64</c:v>
                </c:pt>
                <c:pt idx="6" formatCode="0">
                  <c:v>5557.23</c:v>
                </c:pt>
                <c:pt idx="7" formatCode="0">
                  <c:v>5818.07</c:v>
                </c:pt>
                <c:pt idx="8" formatCode="0">
                  <c:v>6873.34</c:v>
                </c:pt>
                <c:pt idx="9" formatCode="0">
                  <c:v>8859.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C-32F2-4461-B821-F7205143E38B}"/>
            </c:ext>
          </c:extLst>
        </c:ser>
        <c:ser>
          <c:idx val="61"/>
          <c:order val="6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64:$Q$6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D-32F2-4461-B821-F7205143E38B}"/>
            </c:ext>
          </c:extLst>
        </c:ser>
        <c:ser>
          <c:idx val="62"/>
          <c:order val="6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65:$Q$6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E-32F2-4461-B821-F7205143E38B}"/>
            </c:ext>
          </c:extLst>
        </c:ser>
        <c:ser>
          <c:idx val="63"/>
          <c:order val="6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66:$Q$6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F-32F2-4461-B821-F7205143E38B}"/>
            </c:ext>
          </c:extLst>
        </c:ser>
        <c:ser>
          <c:idx val="64"/>
          <c:order val="6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67:$Q$6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0-32F2-4461-B821-F7205143E38B}"/>
            </c:ext>
          </c:extLst>
        </c:ser>
        <c:ser>
          <c:idx val="65"/>
          <c:order val="6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68:$Q$6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1-32F2-4461-B821-F7205143E38B}"/>
            </c:ext>
          </c:extLst>
        </c:ser>
        <c:ser>
          <c:idx val="66"/>
          <c:order val="6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69:$Q$6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2-32F2-4461-B821-F7205143E38B}"/>
            </c:ext>
          </c:extLst>
        </c:ser>
        <c:ser>
          <c:idx val="67"/>
          <c:order val="6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70:$Q$7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3-32F2-4461-B821-F7205143E38B}"/>
            </c:ext>
          </c:extLst>
        </c:ser>
        <c:ser>
          <c:idx val="68"/>
          <c:order val="6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71:$Q$7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4-32F2-4461-B821-F7205143E38B}"/>
            </c:ext>
          </c:extLst>
        </c:ser>
        <c:ser>
          <c:idx val="69"/>
          <c:order val="6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72:$Q$7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5-32F2-4461-B821-F7205143E38B}"/>
            </c:ext>
          </c:extLst>
        </c:ser>
        <c:ser>
          <c:idx val="70"/>
          <c:order val="7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73:$Q$7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6-32F2-4461-B821-F7205143E38B}"/>
            </c:ext>
          </c:extLst>
        </c:ser>
        <c:ser>
          <c:idx val="71"/>
          <c:order val="7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74:$Q$7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7-32F2-4461-B821-F7205143E38B}"/>
            </c:ext>
          </c:extLst>
        </c:ser>
        <c:ser>
          <c:idx val="72"/>
          <c:order val="7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75:$Q$7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8-32F2-4461-B821-F7205143E38B}"/>
            </c:ext>
          </c:extLst>
        </c:ser>
        <c:ser>
          <c:idx val="73"/>
          <c:order val="7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76:$Q$7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9-32F2-4461-B821-F7205143E38B}"/>
            </c:ext>
          </c:extLst>
        </c:ser>
        <c:ser>
          <c:idx val="74"/>
          <c:order val="7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77:$Q$7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A-32F2-4461-B821-F7205143E38B}"/>
            </c:ext>
          </c:extLst>
        </c:ser>
        <c:ser>
          <c:idx val="75"/>
          <c:order val="7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78:$Q$7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B-32F2-4461-B821-F7205143E38B}"/>
            </c:ext>
          </c:extLst>
        </c:ser>
        <c:ser>
          <c:idx val="76"/>
          <c:order val="7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79:$Q$7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C-32F2-4461-B821-F7205143E38B}"/>
            </c:ext>
          </c:extLst>
        </c:ser>
        <c:ser>
          <c:idx val="77"/>
          <c:order val="7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80:$Q$8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D-32F2-4461-B821-F7205143E38B}"/>
            </c:ext>
          </c:extLst>
        </c:ser>
        <c:ser>
          <c:idx val="78"/>
          <c:order val="7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81:$Q$8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E-32F2-4461-B821-F7205143E38B}"/>
            </c:ext>
          </c:extLst>
        </c:ser>
        <c:ser>
          <c:idx val="79"/>
          <c:order val="7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82:$Q$8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F-32F2-4461-B821-F7205143E38B}"/>
            </c:ext>
          </c:extLst>
        </c:ser>
        <c:ser>
          <c:idx val="80"/>
          <c:order val="8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83:$Q$8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0-32F2-4461-B821-F7205143E38B}"/>
            </c:ext>
          </c:extLst>
        </c:ser>
        <c:ser>
          <c:idx val="81"/>
          <c:order val="8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84:$Q$8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1-32F2-4461-B821-F7205143E38B}"/>
            </c:ext>
          </c:extLst>
        </c:ser>
        <c:ser>
          <c:idx val="82"/>
          <c:order val="8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85:$Q$85</c:f>
              <c:numCache>
                <c:formatCode>General</c:formatCode>
                <c:ptCount val="13"/>
                <c:pt idx="0" formatCode="0">
                  <c:v>1847.3</c:v>
                </c:pt>
                <c:pt idx="2" formatCode="0">
                  <c:v>2096.41</c:v>
                </c:pt>
                <c:pt idx="3" formatCode="0">
                  <c:v>2033.96</c:v>
                </c:pt>
                <c:pt idx="4" formatCode="0">
                  <c:v>2353.65</c:v>
                </c:pt>
                <c:pt idx="5" formatCode="0">
                  <c:v>2732.38</c:v>
                </c:pt>
                <c:pt idx="6" formatCode="0">
                  <c:v>3507.15</c:v>
                </c:pt>
                <c:pt idx="7" formatCode="0">
                  <c:v>3784.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2-32F2-4461-B821-F7205143E38B}"/>
            </c:ext>
          </c:extLst>
        </c:ser>
        <c:ser>
          <c:idx val="83"/>
          <c:order val="8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86:$Q$8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3-32F2-4461-B821-F7205143E38B}"/>
            </c:ext>
          </c:extLst>
        </c:ser>
        <c:ser>
          <c:idx val="84"/>
          <c:order val="8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87:$Q$8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4-32F2-4461-B821-F7205143E38B}"/>
            </c:ext>
          </c:extLst>
        </c:ser>
        <c:ser>
          <c:idx val="85"/>
          <c:order val="8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88:$Q$8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5-32F2-4461-B821-F7205143E38B}"/>
            </c:ext>
          </c:extLst>
        </c:ser>
        <c:ser>
          <c:idx val="86"/>
          <c:order val="8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89:$Q$8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6-32F2-4461-B821-F7205143E38B}"/>
            </c:ext>
          </c:extLst>
        </c:ser>
        <c:ser>
          <c:idx val="87"/>
          <c:order val="8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90:$Q$9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7-32F2-4461-B821-F7205143E38B}"/>
            </c:ext>
          </c:extLst>
        </c:ser>
        <c:ser>
          <c:idx val="88"/>
          <c:order val="8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91:$Q$9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8-32F2-4461-B821-F7205143E38B}"/>
            </c:ext>
          </c:extLst>
        </c:ser>
        <c:ser>
          <c:idx val="89"/>
          <c:order val="8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92:$Q$9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9-32F2-4461-B821-F7205143E38B}"/>
            </c:ext>
          </c:extLst>
        </c:ser>
        <c:ser>
          <c:idx val="90"/>
          <c:order val="9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93:$Q$9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A-32F2-4461-B821-F7205143E38B}"/>
            </c:ext>
          </c:extLst>
        </c:ser>
        <c:ser>
          <c:idx val="91"/>
          <c:order val="9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94:$Q$9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B-32F2-4461-B821-F7205143E38B}"/>
            </c:ext>
          </c:extLst>
        </c:ser>
        <c:ser>
          <c:idx val="92"/>
          <c:order val="9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95:$Q$9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C-32F2-4461-B821-F7205143E38B}"/>
            </c:ext>
          </c:extLst>
        </c:ser>
        <c:ser>
          <c:idx val="93"/>
          <c:order val="9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96:$Q$96</c:f>
              <c:numCache>
                <c:formatCode>0</c:formatCode>
                <c:ptCount val="13"/>
                <c:pt idx="0">
                  <c:v>2507.92</c:v>
                </c:pt>
                <c:pt idx="1">
                  <c:v>2720.3</c:v>
                </c:pt>
                <c:pt idx="2">
                  <c:v>2782.09</c:v>
                </c:pt>
                <c:pt idx="3">
                  <c:v>3079.1</c:v>
                </c:pt>
                <c:pt idx="5">
                  <c:v>3688.37</c:v>
                </c:pt>
                <c:pt idx="6">
                  <c:v>4555.3999999999996</c:v>
                </c:pt>
                <c:pt idx="7">
                  <c:v>5624.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D-32F2-4461-B821-F7205143E38B}"/>
            </c:ext>
          </c:extLst>
        </c:ser>
        <c:ser>
          <c:idx val="94"/>
          <c:order val="9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腎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腎臓CAPD (実測)'!$E$97:$Q$9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E-32F2-4461-B821-F7205143E3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5417520"/>
        <c:axId val="395417912"/>
      </c:lineChart>
      <c:catAx>
        <c:axId val="3954175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 sz="1600" baseline="0"/>
            </a:pPr>
            <a:endParaRPr lang="ja-JP"/>
          </a:p>
        </c:txPr>
        <c:crossAx val="395417912"/>
        <c:crosses val="autoZero"/>
        <c:auto val="1"/>
        <c:lblAlgn val="ctr"/>
        <c:lblOffset val="100"/>
        <c:noMultiLvlLbl val="0"/>
      </c:catAx>
      <c:valAx>
        <c:axId val="395417912"/>
        <c:scaling>
          <c:orientation val="minMax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 lang="ja-JP" sz="1800"/>
                </a:pPr>
                <a:r>
                  <a:rPr lang="en-US" altLang="ja-JP" sz="1800" dirty="0"/>
                  <a:t>TKV</a:t>
                </a:r>
                <a:r>
                  <a:rPr lang="en-US" altLang="ja-JP" sz="1800" baseline="0" dirty="0"/>
                  <a:t> (mL)</a:t>
                </a:r>
                <a:endParaRPr lang="ja-JP" altLang="en-US" sz="1800" dirty="0"/>
              </a:p>
            </c:rich>
          </c:tx>
          <c:layout>
            <c:manualLayout>
              <c:xMode val="edge"/>
              <c:yMode val="edge"/>
              <c:x val="2.5588065972467711E-2"/>
              <c:y val="0.3703944943634583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 sz="1600" baseline="0"/>
            </a:pPr>
            <a:endParaRPr lang="ja-JP"/>
          </a:p>
        </c:txPr>
        <c:crossAx val="395417520"/>
        <c:crosses val="autoZero"/>
        <c:crossBetween val="between"/>
      </c:valAx>
    </c:plotArea>
    <c:plotVisOnly val="1"/>
    <c:dispBlanksAs val="span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6635974585914581E-2"/>
          <c:y val="2.4009210603500131E-2"/>
          <c:w val="0.79024991954745827"/>
          <c:h val="0.85270491103887591"/>
        </c:manualLayout>
      </c:layout>
      <c:lineChart>
        <c:grouping val="standard"/>
        <c:varyColors val="0"/>
        <c:ser>
          <c:idx val="0"/>
          <c:order val="0"/>
          <c:tx>
            <c:v>男性</c:v>
          </c:tx>
          <c:spPr>
            <a:ln>
              <a:solidFill>
                <a:schemeClr val="tx1"/>
              </a:solidFill>
            </a:ln>
          </c:spPr>
          <c:marker>
            <c:symbol val="x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'Tbl2-sub1 腎％ (±6)'!$B$4:$B$16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Tbl2-sub1 腎％ (±6)'!$D$4:$D$16</c:f>
              <c:numCache>
                <c:formatCode>###0.0</c:formatCode>
                <c:ptCount val="13"/>
                <c:pt idx="0">
                  <c:v>57.606350385694256</c:v>
                </c:pt>
                <c:pt idx="1">
                  <c:v>64.894089466606772</c:v>
                </c:pt>
                <c:pt idx="2">
                  <c:v>59.64730109027812</c:v>
                </c:pt>
                <c:pt idx="3">
                  <c:v>67.714958945012938</c:v>
                </c:pt>
                <c:pt idx="4">
                  <c:v>78.741602622688063</c:v>
                </c:pt>
                <c:pt idx="5">
                  <c:v>94.611613513533072</c:v>
                </c:pt>
                <c:pt idx="6">
                  <c:v>100</c:v>
                </c:pt>
                <c:pt idx="7">
                  <c:v>101.75180236741838</c:v>
                </c:pt>
                <c:pt idx="8">
                  <c:v>107.142092606981</c:v>
                </c:pt>
                <c:pt idx="9">
                  <c:v>117.06391667853318</c:v>
                </c:pt>
                <c:pt idx="10">
                  <c:v>112.72187733182406</c:v>
                </c:pt>
                <c:pt idx="11">
                  <c:v>128.54795124226823</c:v>
                </c:pt>
                <c:pt idx="12">
                  <c:v>154.521027105627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8D7-4BA6-8562-09C2C321BEDB}"/>
            </c:ext>
          </c:extLst>
        </c:ser>
        <c:ser>
          <c:idx val="1"/>
          <c:order val="1"/>
          <c:tx>
            <c:v>女性</c:v>
          </c:tx>
          <c:val>
            <c:numRef>
              <c:f>'Tbl2-sub1 腎％ (±6)'!$D$24:$D$36</c:f>
              <c:numCache>
                <c:formatCode>###0.0</c:formatCode>
                <c:ptCount val="13"/>
                <c:pt idx="0">
                  <c:v>65.304040828785048</c:v>
                </c:pt>
                <c:pt idx="1">
                  <c:v>73.544532398541335</c:v>
                </c:pt>
                <c:pt idx="2">
                  <c:v>73.331092044484478</c:v>
                </c:pt>
                <c:pt idx="3">
                  <c:v>81.529703238425043</c:v>
                </c:pt>
                <c:pt idx="4">
                  <c:v>86.056111840719922</c:v>
                </c:pt>
                <c:pt idx="5">
                  <c:v>98.096063685666394</c:v>
                </c:pt>
                <c:pt idx="6">
                  <c:v>100</c:v>
                </c:pt>
                <c:pt idx="7">
                  <c:v>89.935271576674964</c:v>
                </c:pt>
                <c:pt idx="8">
                  <c:v>85.665536369186924</c:v>
                </c:pt>
                <c:pt idx="9">
                  <c:v>82.449872267008075</c:v>
                </c:pt>
                <c:pt idx="10">
                  <c:v>79.164782373224895</c:v>
                </c:pt>
                <c:pt idx="11">
                  <c:v>73.786349477059147</c:v>
                </c:pt>
                <c:pt idx="12">
                  <c:v>75.8456656443965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377-4743-87E3-3708429716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5414384"/>
        <c:axId val="395419088"/>
      </c:lineChart>
      <c:catAx>
        <c:axId val="3954143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600"/>
            </a:pPr>
            <a:endParaRPr lang="ja-JP"/>
          </a:p>
        </c:txPr>
        <c:crossAx val="395419088"/>
        <c:crosses val="autoZero"/>
        <c:auto val="1"/>
        <c:lblAlgn val="ctr"/>
        <c:lblOffset val="100"/>
        <c:noMultiLvlLbl val="0"/>
      </c:catAx>
      <c:valAx>
        <c:axId val="395419088"/>
        <c:scaling>
          <c:orientation val="minMax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#,##0_ " sourceLinked="0"/>
        <c:majorTickMark val="out"/>
        <c:minorTickMark val="none"/>
        <c:tickLblPos val="nextTo"/>
        <c:txPr>
          <a:bodyPr/>
          <a:lstStyle/>
          <a:p>
            <a:pPr>
              <a:defRPr sz="1600"/>
            </a:pPr>
            <a:endParaRPr lang="ja-JP"/>
          </a:p>
        </c:txPr>
        <c:crossAx val="3954143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v>Mayo 1B</c:v>
          </c:tx>
          <c:spPr>
            <a:ln>
              <a:solidFill>
                <a:schemeClr val="tx1"/>
              </a:solidFill>
            </a:ln>
          </c:spPr>
          <c:marker>
            <c:symbol val="x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'Tbl2-sub_腎％(±6) '!$B$4:$B$16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Tbl2-sub_腎％(±6) '!$D$4:$D$16</c:f>
              <c:numCache>
                <c:formatCode>###0.0</c:formatCode>
                <c:ptCount val="13"/>
                <c:pt idx="1">
                  <c:v>89.836504306486745</c:v>
                </c:pt>
                <c:pt idx="2">
                  <c:v>75.843889810074174</c:v>
                </c:pt>
                <c:pt idx="3">
                  <c:v>89.967724172754203</c:v>
                </c:pt>
                <c:pt idx="4">
                  <c:v>96.951101704626353</c:v>
                </c:pt>
                <c:pt idx="5">
                  <c:v>105.24920786547935</c:v>
                </c:pt>
                <c:pt idx="6">
                  <c:v>100.00000000000006</c:v>
                </c:pt>
                <c:pt idx="7">
                  <c:v>87.943385961765046</c:v>
                </c:pt>
                <c:pt idx="8">
                  <c:v>82.518602940144334</c:v>
                </c:pt>
                <c:pt idx="9">
                  <c:v>75.892174377562071</c:v>
                </c:pt>
                <c:pt idx="10">
                  <c:v>76.215828771522496</c:v>
                </c:pt>
                <c:pt idx="11">
                  <c:v>68.5942214577759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F3F-4E38-AE10-9318D7594E49}"/>
            </c:ext>
          </c:extLst>
        </c:ser>
        <c:ser>
          <c:idx val="1"/>
          <c:order val="1"/>
          <c:tx>
            <c:v>Mayo 1C</c:v>
          </c:tx>
          <c:val>
            <c:numRef>
              <c:f>'Tbl2-sub_腎％(±6) '!$D$24:$D$36</c:f>
              <c:numCache>
                <c:formatCode>###0.0</c:formatCode>
                <c:ptCount val="13"/>
                <c:pt idx="0">
                  <c:v>70.159184843687939</c:v>
                </c:pt>
                <c:pt idx="1">
                  <c:v>75.441223370172423</c:v>
                </c:pt>
                <c:pt idx="2">
                  <c:v>74.01906136416217</c:v>
                </c:pt>
                <c:pt idx="3">
                  <c:v>83.040606470490019</c:v>
                </c:pt>
                <c:pt idx="4">
                  <c:v>86.14256224236226</c:v>
                </c:pt>
                <c:pt idx="5">
                  <c:v>98.736749045503714</c:v>
                </c:pt>
                <c:pt idx="6">
                  <c:v>100.00000000000047</c:v>
                </c:pt>
                <c:pt idx="7">
                  <c:v>92.266865823577973</c:v>
                </c:pt>
                <c:pt idx="8">
                  <c:v>84.801922605152811</c:v>
                </c:pt>
                <c:pt idx="9">
                  <c:v>88.555581905845798</c:v>
                </c:pt>
                <c:pt idx="10">
                  <c:v>89.838510074789895</c:v>
                </c:pt>
                <c:pt idx="11">
                  <c:v>91.137641864142921</c:v>
                </c:pt>
                <c:pt idx="12">
                  <c:v>104.183667366611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F3F-4E38-AE10-9318D7594E49}"/>
            </c:ext>
          </c:extLst>
        </c:ser>
        <c:ser>
          <c:idx val="2"/>
          <c:order val="2"/>
          <c:tx>
            <c:v>Mayo 1D</c:v>
          </c:tx>
          <c:marker>
            <c:symbol val="square"/>
            <c:size val="7"/>
          </c:marker>
          <c:val>
            <c:numRef>
              <c:f>'Tbl2-sub_腎％(±6) '!$D$44:$D$56</c:f>
              <c:numCache>
                <c:formatCode>###0.0</c:formatCode>
                <c:ptCount val="13"/>
                <c:pt idx="0">
                  <c:v>58.62168700259253</c:v>
                </c:pt>
                <c:pt idx="1">
                  <c:v>69.127877430827112</c:v>
                </c:pt>
                <c:pt idx="2">
                  <c:v>73.053234557024624</c:v>
                </c:pt>
                <c:pt idx="3">
                  <c:v>75.946588826841548</c:v>
                </c:pt>
                <c:pt idx="4">
                  <c:v>83.215173214568225</c:v>
                </c:pt>
                <c:pt idx="5">
                  <c:v>93.394712700757367</c:v>
                </c:pt>
                <c:pt idx="6">
                  <c:v>99.999999999999801</c:v>
                </c:pt>
                <c:pt idx="7">
                  <c:v>93.145892392732108</c:v>
                </c:pt>
                <c:pt idx="8">
                  <c:v>88.900341086924882</c:v>
                </c:pt>
                <c:pt idx="9">
                  <c:v>83.197477664619612</c:v>
                </c:pt>
                <c:pt idx="10">
                  <c:v>70.215597047662285</c:v>
                </c:pt>
                <c:pt idx="11">
                  <c:v>74.390172868530854</c:v>
                </c:pt>
                <c:pt idx="12">
                  <c:v>84.483571680718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F3F-4E38-AE10-9318D7594E49}"/>
            </c:ext>
          </c:extLst>
        </c:ser>
        <c:ser>
          <c:idx val="3"/>
          <c:order val="3"/>
          <c:tx>
            <c:v>Mayo 1E</c:v>
          </c:tx>
          <c:marker>
            <c:symbol val="square"/>
            <c:size val="7"/>
          </c:marker>
          <c:val>
            <c:numRef>
              <c:f>'Tbl2-sub_腎％(±6) '!$D$64:$D$76</c:f>
              <c:numCache>
                <c:formatCode>###0.0</c:formatCode>
                <c:ptCount val="13"/>
                <c:pt idx="0">
                  <c:v>58.789522146253255</c:v>
                </c:pt>
                <c:pt idx="1">
                  <c:v>60.32675388593163</c:v>
                </c:pt>
                <c:pt idx="2">
                  <c:v>54.126173404370711</c:v>
                </c:pt>
                <c:pt idx="3">
                  <c:v>62.512018870848443</c:v>
                </c:pt>
                <c:pt idx="4">
                  <c:v>75.347093343394675</c:v>
                </c:pt>
                <c:pt idx="5">
                  <c:v>94.344547111159699</c:v>
                </c:pt>
                <c:pt idx="6">
                  <c:v>100.00000000000003</c:v>
                </c:pt>
                <c:pt idx="7">
                  <c:v>100.12441995397808</c:v>
                </c:pt>
                <c:pt idx="8">
                  <c:v>111.0442456376757</c:v>
                </c:pt>
                <c:pt idx="9">
                  <c:v>141.10881891239916</c:v>
                </c:pt>
                <c:pt idx="10">
                  <c:v>111.64465912690041</c:v>
                </c:pt>
                <c:pt idx="11">
                  <c:v>114.572564568851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F3F-4E38-AE10-9318D7594E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5418696"/>
        <c:axId val="395420264"/>
      </c:lineChart>
      <c:catAx>
        <c:axId val="3954186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 sz="1600"/>
            </a:pPr>
            <a:endParaRPr lang="ja-JP"/>
          </a:p>
        </c:txPr>
        <c:crossAx val="395420264"/>
        <c:crosses val="autoZero"/>
        <c:auto val="1"/>
        <c:lblAlgn val="ctr"/>
        <c:lblOffset val="100"/>
        <c:noMultiLvlLbl val="0"/>
      </c:catAx>
      <c:valAx>
        <c:axId val="39542026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#,##0_ " sourceLinked="0"/>
        <c:majorTickMark val="out"/>
        <c:minorTickMark val="none"/>
        <c:tickLblPos val="nextTo"/>
        <c:txPr>
          <a:bodyPr/>
          <a:lstStyle/>
          <a:p>
            <a:pPr>
              <a:defRPr lang="ja-JP" sz="1600"/>
            </a:pPr>
            <a:endParaRPr lang="ja-JP"/>
          </a:p>
        </c:txPr>
        <c:crossAx val="39541869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221896475788405"/>
          <c:y val="0.36359647052176741"/>
          <c:w val="0.15104001341120829"/>
          <c:h val="0.27280705895646506"/>
        </c:manualLayout>
      </c:layout>
      <c:overlay val="0"/>
      <c:txPr>
        <a:bodyPr/>
        <a:lstStyle/>
        <a:p>
          <a:pPr>
            <a:defRPr lang="ja-JP" sz="1800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223606133444835"/>
          <c:y val="3.8960793410931074E-2"/>
          <c:w val="0.85175621462358886"/>
          <c:h val="0.87346863383532025"/>
        </c:manualLayout>
      </c:layout>
      <c:lineChart>
        <c:grouping val="standard"/>
        <c:varyColors val="0"/>
        <c:ser>
          <c:idx val="0"/>
          <c:order val="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3:$Q$3</c:f>
              <c:numCache>
                <c:formatCode>General</c:formatCode>
                <c:ptCount val="13"/>
                <c:pt idx="4" formatCode="0">
                  <c:v>3183.6179999999999</c:v>
                </c:pt>
                <c:pt idx="5" formatCode="0">
                  <c:v>3293.096</c:v>
                </c:pt>
                <c:pt idx="6" formatCode="0">
                  <c:v>3214.7249999999999</c:v>
                </c:pt>
                <c:pt idx="7" formatCode="0">
                  <c:v>3287.7350000000001</c:v>
                </c:pt>
                <c:pt idx="8" formatCode="0">
                  <c:v>3390.9259999999999</c:v>
                </c:pt>
                <c:pt idx="10" formatCode="0">
                  <c:v>3631.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D8D-417F-AE4B-BF126601ADB6}"/>
            </c:ext>
          </c:extLst>
        </c:ser>
        <c:ser>
          <c:idx val="1"/>
          <c:order val="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4:$Q$4</c:f>
              <c:numCache>
                <c:formatCode>General</c:formatCode>
                <c:ptCount val="13"/>
                <c:pt idx="4" formatCode="0">
                  <c:v>3160.4540000000002</c:v>
                </c:pt>
                <c:pt idx="6" formatCode="0">
                  <c:v>3831.9679999999998</c:v>
                </c:pt>
                <c:pt idx="7" formatCode="0">
                  <c:v>4170.672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D8D-417F-AE4B-BF126601ADB6}"/>
            </c:ext>
          </c:extLst>
        </c:ser>
        <c:ser>
          <c:idx val="2"/>
          <c:order val="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5:$Q$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D8D-417F-AE4B-BF126601ADB6}"/>
            </c:ext>
          </c:extLst>
        </c:ser>
        <c:ser>
          <c:idx val="3"/>
          <c:order val="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6:$Q$6</c:f>
              <c:numCache>
                <c:formatCode>General</c:formatCode>
                <c:ptCount val="13"/>
                <c:pt idx="4" formatCode="0">
                  <c:v>3924.2660000000001</c:v>
                </c:pt>
                <c:pt idx="5" formatCode="0">
                  <c:v>4282.4960000000001</c:v>
                </c:pt>
                <c:pt idx="6" formatCode="0">
                  <c:v>4676.3389999999999</c:v>
                </c:pt>
                <c:pt idx="7" formatCode="0">
                  <c:v>4847.695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D8D-417F-AE4B-BF126601ADB6}"/>
            </c:ext>
          </c:extLst>
        </c:ser>
        <c:ser>
          <c:idx val="4"/>
          <c:order val="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7:$Q$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6D8D-417F-AE4B-BF126601ADB6}"/>
            </c:ext>
          </c:extLst>
        </c:ser>
        <c:ser>
          <c:idx val="5"/>
          <c:order val="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8:$Q$8</c:f>
              <c:numCache>
                <c:formatCode>General</c:formatCode>
                <c:ptCount val="13"/>
                <c:pt idx="6" formatCode="0">
                  <c:v>3252.53</c:v>
                </c:pt>
                <c:pt idx="8" formatCode="0">
                  <c:v>3429.35</c:v>
                </c:pt>
                <c:pt idx="9" formatCode="0">
                  <c:v>3347.92</c:v>
                </c:pt>
                <c:pt idx="12" formatCode="0">
                  <c:v>3319.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6D8D-417F-AE4B-BF126601ADB6}"/>
            </c:ext>
          </c:extLst>
        </c:ser>
        <c:ser>
          <c:idx val="6"/>
          <c:order val="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9:$Q$9</c:f>
              <c:numCache>
                <c:formatCode>General</c:formatCode>
                <c:ptCount val="13"/>
                <c:pt idx="5" formatCode="0">
                  <c:v>1479.3440000000001</c:v>
                </c:pt>
                <c:pt idx="6" formatCode="0">
                  <c:v>928.11300000000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6D8D-417F-AE4B-BF126601ADB6}"/>
            </c:ext>
          </c:extLst>
        </c:ser>
        <c:ser>
          <c:idx val="7"/>
          <c:order val="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10:$Q$1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6D8D-417F-AE4B-BF126601ADB6}"/>
            </c:ext>
          </c:extLst>
        </c:ser>
        <c:ser>
          <c:idx val="8"/>
          <c:order val="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11:$Q$1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6D8D-417F-AE4B-BF126601ADB6}"/>
            </c:ext>
          </c:extLst>
        </c:ser>
        <c:ser>
          <c:idx val="9"/>
          <c:order val="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12:$Q$1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6D8D-417F-AE4B-BF126601ADB6}"/>
            </c:ext>
          </c:extLst>
        </c:ser>
        <c:ser>
          <c:idx val="10"/>
          <c:order val="1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13:$Q$1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6D8D-417F-AE4B-BF126601ADB6}"/>
            </c:ext>
          </c:extLst>
        </c:ser>
        <c:ser>
          <c:idx val="11"/>
          <c:order val="1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14:$Q$1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6D8D-417F-AE4B-BF126601ADB6}"/>
            </c:ext>
          </c:extLst>
        </c:ser>
        <c:ser>
          <c:idx val="12"/>
          <c:order val="1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15:$Q$15</c:f>
              <c:numCache>
                <c:formatCode>General</c:formatCode>
                <c:ptCount val="13"/>
                <c:pt idx="4" formatCode="0">
                  <c:v>2633.6669999999999</c:v>
                </c:pt>
                <c:pt idx="6" formatCode="0">
                  <c:v>2496.37</c:v>
                </c:pt>
                <c:pt idx="7" formatCode="0">
                  <c:v>2500.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6D8D-417F-AE4B-BF126601ADB6}"/>
            </c:ext>
          </c:extLst>
        </c:ser>
        <c:ser>
          <c:idx val="13"/>
          <c:order val="1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16:$Q$1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6D8D-417F-AE4B-BF126601ADB6}"/>
            </c:ext>
          </c:extLst>
        </c:ser>
        <c:ser>
          <c:idx val="14"/>
          <c:order val="1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17:$Q$17</c:f>
              <c:numCache>
                <c:formatCode>0</c:formatCode>
                <c:ptCount val="13"/>
                <c:pt idx="1">
                  <c:v>2420.1089999999999</c:v>
                </c:pt>
                <c:pt idx="3">
                  <c:v>2079.9769999999999</c:v>
                </c:pt>
                <c:pt idx="6">
                  <c:v>2342.61</c:v>
                </c:pt>
                <c:pt idx="7">
                  <c:v>2228.4</c:v>
                </c:pt>
                <c:pt idx="8">
                  <c:v>2284.9</c:v>
                </c:pt>
                <c:pt idx="9">
                  <c:v>2321.41</c:v>
                </c:pt>
                <c:pt idx="12">
                  <c:v>2536.05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6D8D-417F-AE4B-BF126601ADB6}"/>
            </c:ext>
          </c:extLst>
        </c:ser>
        <c:ser>
          <c:idx val="15"/>
          <c:order val="1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18:$Q$1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6D8D-417F-AE4B-BF126601ADB6}"/>
            </c:ext>
          </c:extLst>
        </c:ser>
        <c:ser>
          <c:idx val="16"/>
          <c:order val="1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19:$Q$19</c:f>
              <c:numCache>
                <c:formatCode>General</c:formatCode>
                <c:ptCount val="13"/>
                <c:pt idx="3" formatCode="0">
                  <c:v>1605.5</c:v>
                </c:pt>
                <c:pt idx="5" formatCode="0">
                  <c:v>1835.05</c:v>
                </c:pt>
                <c:pt idx="6" formatCode="0">
                  <c:v>1716.61</c:v>
                </c:pt>
                <c:pt idx="7" formatCode="0">
                  <c:v>1728.75</c:v>
                </c:pt>
                <c:pt idx="8" formatCode="0">
                  <c:v>1869.45</c:v>
                </c:pt>
                <c:pt idx="9" formatCode="0">
                  <c:v>1670.74</c:v>
                </c:pt>
                <c:pt idx="10" formatCode="0">
                  <c:v>1719.95</c:v>
                </c:pt>
                <c:pt idx="11" formatCode="0">
                  <c:v>1606.94</c:v>
                </c:pt>
                <c:pt idx="12" formatCode="0">
                  <c:v>1292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6D8D-417F-AE4B-BF126601ADB6}"/>
            </c:ext>
          </c:extLst>
        </c:ser>
        <c:ser>
          <c:idx val="17"/>
          <c:order val="1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20:$Q$20</c:f>
              <c:numCache>
                <c:formatCode>General</c:formatCode>
                <c:ptCount val="13"/>
                <c:pt idx="0" formatCode="0">
                  <c:v>1770.433</c:v>
                </c:pt>
                <c:pt idx="5" formatCode="0">
                  <c:v>1173.9100000000001</c:v>
                </c:pt>
                <c:pt idx="6" formatCode="0">
                  <c:v>1143.7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6D8D-417F-AE4B-BF126601ADB6}"/>
            </c:ext>
          </c:extLst>
        </c:ser>
        <c:ser>
          <c:idx val="18"/>
          <c:order val="1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21:$Q$2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6D8D-417F-AE4B-BF126601ADB6}"/>
            </c:ext>
          </c:extLst>
        </c:ser>
        <c:ser>
          <c:idx val="19"/>
          <c:order val="1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22:$Q$2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6D8D-417F-AE4B-BF126601ADB6}"/>
            </c:ext>
          </c:extLst>
        </c:ser>
        <c:ser>
          <c:idx val="20"/>
          <c:order val="2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23:$Q$23</c:f>
              <c:numCache>
                <c:formatCode>General</c:formatCode>
                <c:ptCount val="13"/>
                <c:pt idx="0" formatCode="0">
                  <c:v>1652.17</c:v>
                </c:pt>
                <c:pt idx="5" formatCode="0">
                  <c:v>2004.7</c:v>
                </c:pt>
                <c:pt idx="6" formatCode="0">
                  <c:v>1871.63</c:v>
                </c:pt>
                <c:pt idx="8" formatCode="0">
                  <c:v>1764.73</c:v>
                </c:pt>
                <c:pt idx="10" formatCode="0">
                  <c:v>1836.93</c:v>
                </c:pt>
                <c:pt idx="11" formatCode="0">
                  <c:v>1964.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6D8D-417F-AE4B-BF126601ADB6}"/>
            </c:ext>
          </c:extLst>
        </c:ser>
        <c:ser>
          <c:idx val="21"/>
          <c:order val="2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24:$Q$24</c:f>
              <c:numCache>
                <c:formatCode>0</c:formatCode>
                <c:ptCount val="13"/>
                <c:pt idx="0">
                  <c:v>936.17499999999995</c:v>
                </c:pt>
                <c:pt idx="1">
                  <c:v>879.27099999999996</c:v>
                </c:pt>
                <c:pt idx="5">
                  <c:v>956.93</c:v>
                </c:pt>
                <c:pt idx="6">
                  <c:v>1077.1600000000001</c:v>
                </c:pt>
                <c:pt idx="8">
                  <c:v>898.43</c:v>
                </c:pt>
                <c:pt idx="9">
                  <c:v>946.71</c:v>
                </c:pt>
                <c:pt idx="11">
                  <c:v>950.7</c:v>
                </c:pt>
                <c:pt idx="12">
                  <c:v>971.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6D8D-417F-AE4B-BF126601ADB6}"/>
            </c:ext>
          </c:extLst>
        </c:ser>
        <c:ser>
          <c:idx val="22"/>
          <c:order val="2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25:$Q$25</c:f>
              <c:numCache>
                <c:formatCode>General</c:formatCode>
                <c:ptCount val="13"/>
                <c:pt idx="2" formatCode="0">
                  <c:v>1677.126</c:v>
                </c:pt>
                <c:pt idx="3" formatCode="0">
                  <c:v>1870.413</c:v>
                </c:pt>
                <c:pt idx="4" formatCode="0">
                  <c:v>2148.06</c:v>
                </c:pt>
                <c:pt idx="6" formatCode="0">
                  <c:v>2703.96</c:v>
                </c:pt>
                <c:pt idx="7" formatCode="0">
                  <c:v>3348.8</c:v>
                </c:pt>
                <c:pt idx="8" formatCode="0">
                  <c:v>3289.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6D8D-417F-AE4B-BF126601ADB6}"/>
            </c:ext>
          </c:extLst>
        </c:ser>
        <c:ser>
          <c:idx val="23"/>
          <c:order val="2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26:$Q$26</c:f>
              <c:numCache>
                <c:formatCode>General</c:formatCode>
                <c:ptCount val="13"/>
                <c:pt idx="6" formatCode="0">
                  <c:v>1984.38</c:v>
                </c:pt>
                <c:pt idx="7" formatCode="0">
                  <c:v>2002.61</c:v>
                </c:pt>
                <c:pt idx="8" formatCode="0">
                  <c:v>1923.72</c:v>
                </c:pt>
                <c:pt idx="9" formatCode="0">
                  <c:v>2035.72</c:v>
                </c:pt>
                <c:pt idx="10" formatCode="0">
                  <c:v>1970.54</c:v>
                </c:pt>
                <c:pt idx="11" formatCode="0">
                  <c:v>2068.71</c:v>
                </c:pt>
                <c:pt idx="12" formatCode="0">
                  <c:v>2104.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6D8D-417F-AE4B-BF126601ADB6}"/>
            </c:ext>
          </c:extLst>
        </c:ser>
        <c:ser>
          <c:idx val="24"/>
          <c:order val="2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27:$Q$27</c:f>
              <c:numCache>
                <c:formatCode>General</c:formatCode>
                <c:ptCount val="13"/>
                <c:pt idx="5" formatCode="0">
                  <c:v>1905.73</c:v>
                </c:pt>
                <c:pt idx="6" formatCode="0">
                  <c:v>1812.85</c:v>
                </c:pt>
                <c:pt idx="7" formatCode="0">
                  <c:v>1682.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6D8D-417F-AE4B-BF126601ADB6}"/>
            </c:ext>
          </c:extLst>
        </c:ser>
        <c:ser>
          <c:idx val="25"/>
          <c:order val="2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28:$Q$28</c:f>
              <c:numCache>
                <c:formatCode>0</c:formatCode>
                <c:ptCount val="13"/>
                <c:pt idx="1">
                  <c:v>2693.4949999999999</c:v>
                </c:pt>
                <c:pt idx="2">
                  <c:v>2669.4560000000001</c:v>
                </c:pt>
                <c:pt idx="3">
                  <c:v>2748.1</c:v>
                </c:pt>
                <c:pt idx="4">
                  <c:v>2912.94</c:v>
                </c:pt>
                <c:pt idx="6">
                  <c:v>3022.31</c:v>
                </c:pt>
                <c:pt idx="8">
                  <c:v>3631.79</c:v>
                </c:pt>
                <c:pt idx="9">
                  <c:v>4283.97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6D8D-417F-AE4B-BF126601ADB6}"/>
            </c:ext>
          </c:extLst>
        </c:ser>
        <c:ser>
          <c:idx val="26"/>
          <c:order val="2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29:$Q$2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6D8D-417F-AE4B-BF126601ADB6}"/>
            </c:ext>
          </c:extLst>
        </c:ser>
        <c:ser>
          <c:idx val="27"/>
          <c:order val="2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30:$Q$30</c:f>
              <c:numCache>
                <c:formatCode>General</c:formatCode>
                <c:ptCount val="13"/>
                <c:pt idx="5" formatCode="0">
                  <c:v>1360.23</c:v>
                </c:pt>
                <c:pt idx="6" formatCode="0">
                  <c:v>1361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6D8D-417F-AE4B-BF126601ADB6}"/>
            </c:ext>
          </c:extLst>
        </c:ser>
        <c:ser>
          <c:idx val="28"/>
          <c:order val="2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31:$Q$31</c:f>
              <c:numCache>
                <c:formatCode>General</c:formatCode>
                <c:ptCount val="13"/>
                <c:pt idx="6" formatCode="0">
                  <c:v>10488.68</c:v>
                </c:pt>
                <c:pt idx="7" formatCode="0">
                  <c:v>7657.49</c:v>
                </c:pt>
                <c:pt idx="8" formatCode="0">
                  <c:v>6701.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6D8D-417F-AE4B-BF126601ADB6}"/>
            </c:ext>
          </c:extLst>
        </c:ser>
        <c:ser>
          <c:idx val="29"/>
          <c:order val="2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32:$Q$3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6D8D-417F-AE4B-BF126601ADB6}"/>
            </c:ext>
          </c:extLst>
        </c:ser>
        <c:ser>
          <c:idx val="30"/>
          <c:order val="3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33:$Q$33</c:f>
              <c:numCache>
                <c:formatCode>0</c:formatCode>
                <c:ptCount val="13"/>
                <c:pt idx="1">
                  <c:v>3056.9450000000002</c:v>
                </c:pt>
                <c:pt idx="3">
                  <c:v>3062.2339999999999</c:v>
                </c:pt>
                <c:pt idx="4">
                  <c:v>3065.87</c:v>
                </c:pt>
                <c:pt idx="5">
                  <c:v>4038.96</c:v>
                </c:pt>
                <c:pt idx="6">
                  <c:v>3666.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6D8D-417F-AE4B-BF126601ADB6}"/>
            </c:ext>
          </c:extLst>
        </c:ser>
        <c:ser>
          <c:idx val="31"/>
          <c:order val="3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34:$Q$34</c:f>
              <c:numCache>
                <c:formatCode>General</c:formatCode>
                <c:ptCount val="13"/>
                <c:pt idx="4" formatCode="0">
                  <c:v>1727.34</c:v>
                </c:pt>
                <c:pt idx="6" formatCode="0">
                  <c:v>2066.38</c:v>
                </c:pt>
                <c:pt idx="7" formatCode="0">
                  <c:v>1882.61</c:v>
                </c:pt>
                <c:pt idx="8" formatCode="0">
                  <c:v>1296.95</c:v>
                </c:pt>
                <c:pt idx="9" formatCode="0">
                  <c:v>1277.94</c:v>
                </c:pt>
                <c:pt idx="10" formatCode="0">
                  <c:v>1259.8699999999999</c:v>
                </c:pt>
                <c:pt idx="11" formatCode="0">
                  <c:v>1099.4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6D8D-417F-AE4B-BF126601ADB6}"/>
            </c:ext>
          </c:extLst>
        </c:ser>
        <c:ser>
          <c:idx val="32"/>
          <c:order val="3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35:$Q$35</c:f>
              <c:numCache>
                <c:formatCode>General</c:formatCode>
                <c:ptCount val="13"/>
                <c:pt idx="2" formatCode="0">
                  <c:v>3858.2629999999999</c:v>
                </c:pt>
                <c:pt idx="4" formatCode="0">
                  <c:v>3875.06</c:v>
                </c:pt>
                <c:pt idx="6" formatCode="0">
                  <c:v>4483.9799999999996</c:v>
                </c:pt>
                <c:pt idx="7" formatCode="0">
                  <c:v>4053.42</c:v>
                </c:pt>
                <c:pt idx="8" formatCode="0">
                  <c:v>4373.1099999999997</c:v>
                </c:pt>
                <c:pt idx="9" formatCode="0">
                  <c:v>4546.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6D8D-417F-AE4B-BF126601ADB6}"/>
            </c:ext>
          </c:extLst>
        </c:ser>
        <c:ser>
          <c:idx val="33"/>
          <c:order val="3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36:$Q$36</c:f>
              <c:numCache>
                <c:formatCode>General</c:formatCode>
                <c:ptCount val="13"/>
                <c:pt idx="6" formatCode="0">
                  <c:v>3999.55</c:v>
                </c:pt>
                <c:pt idx="7" formatCode="0">
                  <c:v>4344.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6D8D-417F-AE4B-BF126601ADB6}"/>
            </c:ext>
          </c:extLst>
        </c:ser>
        <c:ser>
          <c:idx val="34"/>
          <c:order val="3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37:$Q$37</c:f>
              <c:numCache>
                <c:formatCode>0</c:formatCode>
                <c:ptCount val="13"/>
                <c:pt idx="1">
                  <c:v>2390.9380000000001</c:v>
                </c:pt>
                <c:pt idx="4">
                  <c:v>2894.37</c:v>
                </c:pt>
                <c:pt idx="6">
                  <c:v>4024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6D8D-417F-AE4B-BF126601ADB6}"/>
            </c:ext>
          </c:extLst>
        </c:ser>
        <c:ser>
          <c:idx val="35"/>
          <c:order val="3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38:$Q$3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6D8D-417F-AE4B-BF126601ADB6}"/>
            </c:ext>
          </c:extLst>
        </c:ser>
        <c:ser>
          <c:idx val="36"/>
          <c:order val="3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39:$Q$3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6D8D-417F-AE4B-BF126601ADB6}"/>
            </c:ext>
          </c:extLst>
        </c:ser>
        <c:ser>
          <c:idx val="37"/>
          <c:order val="3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40:$Q$40</c:f>
              <c:numCache>
                <c:formatCode>General</c:formatCode>
                <c:ptCount val="13"/>
                <c:pt idx="5" formatCode="0">
                  <c:v>7583.46</c:v>
                </c:pt>
                <c:pt idx="6" formatCode="0">
                  <c:v>6820.21</c:v>
                </c:pt>
                <c:pt idx="7" formatCode="0">
                  <c:v>6036.7</c:v>
                </c:pt>
                <c:pt idx="8" formatCode="0">
                  <c:v>6223.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6D8D-417F-AE4B-BF126601ADB6}"/>
            </c:ext>
          </c:extLst>
        </c:ser>
        <c:ser>
          <c:idx val="38"/>
          <c:order val="3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41:$Q$4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6D8D-417F-AE4B-BF126601ADB6}"/>
            </c:ext>
          </c:extLst>
        </c:ser>
        <c:ser>
          <c:idx val="39"/>
          <c:order val="3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42:$Q$4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6D8D-417F-AE4B-BF126601ADB6}"/>
            </c:ext>
          </c:extLst>
        </c:ser>
        <c:ser>
          <c:idx val="40"/>
          <c:order val="4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43:$Q$43</c:f>
              <c:numCache>
                <c:formatCode>General</c:formatCode>
                <c:ptCount val="13"/>
                <c:pt idx="4" formatCode="0">
                  <c:v>2115</c:v>
                </c:pt>
                <c:pt idx="6" formatCode="0">
                  <c:v>2634.5140000000001</c:v>
                </c:pt>
                <c:pt idx="7" formatCode="0">
                  <c:v>2856.5169999999998</c:v>
                </c:pt>
                <c:pt idx="8" formatCode="0">
                  <c:v>3109.7370000000001</c:v>
                </c:pt>
                <c:pt idx="9" formatCode="0">
                  <c:v>3298.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6D8D-417F-AE4B-BF126601ADB6}"/>
            </c:ext>
          </c:extLst>
        </c:ser>
        <c:ser>
          <c:idx val="41"/>
          <c:order val="4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44:$Q$44</c:f>
              <c:numCache>
                <c:formatCode>General</c:formatCode>
                <c:ptCount val="13"/>
                <c:pt idx="4" formatCode="0">
                  <c:v>2898.4760000000001</c:v>
                </c:pt>
                <c:pt idx="5" formatCode="0">
                  <c:v>2791.3809999999999</c:v>
                </c:pt>
                <c:pt idx="6" formatCode="0">
                  <c:v>2916.8</c:v>
                </c:pt>
                <c:pt idx="7" formatCode="0">
                  <c:v>3295.89</c:v>
                </c:pt>
                <c:pt idx="8" formatCode="0">
                  <c:v>3334.59</c:v>
                </c:pt>
                <c:pt idx="9" formatCode="0">
                  <c:v>3498.05</c:v>
                </c:pt>
                <c:pt idx="10" formatCode="0">
                  <c:v>3848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6D8D-417F-AE4B-BF126601ADB6}"/>
            </c:ext>
          </c:extLst>
        </c:ser>
        <c:ser>
          <c:idx val="42"/>
          <c:order val="4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45:$Q$45</c:f>
              <c:numCache>
                <c:formatCode>General</c:formatCode>
                <c:ptCount val="13"/>
                <c:pt idx="3" formatCode="0">
                  <c:v>3465.99</c:v>
                </c:pt>
                <c:pt idx="4" formatCode="0">
                  <c:v>3416.08</c:v>
                </c:pt>
                <c:pt idx="5" formatCode="0">
                  <c:v>3648.31</c:v>
                </c:pt>
                <c:pt idx="6" formatCode="0">
                  <c:v>3683.56</c:v>
                </c:pt>
                <c:pt idx="7" formatCode="0">
                  <c:v>3187.15</c:v>
                </c:pt>
                <c:pt idx="9" formatCode="0">
                  <c:v>3021.41</c:v>
                </c:pt>
                <c:pt idx="10" formatCode="0">
                  <c:v>3208.73</c:v>
                </c:pt>
                <c:pt idx="11" formatCode="0">
                  <c:v>2467.9699999999998</c:v>
                </c:pt>
                <c:pt idx="12" formatCode="0">
                  <c:v>2572.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6D8D-417F-AE4B-BF126601ADB6}"/>
            </c:ext>
          </c:extLst>
        </c:ser>
        <c:ser>
          <c:idx val="43"/>
          <c:order val="4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46:$Q$4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6D8D-417F-AE4B-BF126601ADB6}"/>
            </c:ext>
          </c:extLst>
        </c:ser>
        <c:ser>
          <c:idx val="44"/>
          <c:order val="4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47:$Q$47</c:f>
              <c:numCache>
                <c:formatCode>General</c:formatCode>
                <c:ptCount val="13"/>
                <c:pt idx="4" formatCode="0">
                  <c:v>2210.71</c:v>
                </c:pt>
                <c:pt idx="5" formatCode="0">
                  <c:v>2020.06</c:v>
                </c:pt>
                <c:pt idx="6" formatCode="0">
                  <c:v>1523.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6D8D-417F-AE4B-BF126601ADB6}"/>
            </c:ext>
          </c:extLst>
        </c:ser>
        <c:ser>
          <c:idx val="45"/>
          <c:order val="4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48:$Q$4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6D8D-417F-AE4B-BF126601ADB6}"/>
            </c:ext>
          </c:extLst>
        </c:ser>
        <c:ser>
          <c:idx val="46"/>
          <c:order val="4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49:$Q$49</c:f>
              <c:numCache>
                <c:formatCode>General</c:formatCode>
                <c:ptCount val="13"/>
                <c:pt idx="3" formatCode="0">
                  <c:v>796.8</c:v>
                </c:pt>
                <c:pt idx="6" formatCode="0">
                  <c:v>756.38</c:v>
                </c:pt>
                <c:pt idx="7" formatCode="0">
                  <c:v>963.12</c:v>
                </c:pt>
                <c:pt idx="8" formatCode="0">
                  <c:v>903.01</c:v>
                </c:pt>
                <c:pt idx="9" formatCode="0">
                  <c:v>777.53</c:v>
                </c:pt>
                <c:pt idx="10" formatCode="0">
                  <c:v>849.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6D8D-417F-AE4B-BF126601ADB6}"/>
            </c:ext>
          </c:extLst>
        </c:ser>
        <c:ser>
          <c:idx val="47"/>
          <c:order val="4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50:$Q$5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6D8D-417F-AE4B-BF126601ADB6}"/>
            </c:ext>
          </c:extLst>
        </c:ser>
        <c:ser>
          <c:idx val="48"/>
          <c:order val="4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51:$Q$5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6D8D-417F-AE4B-BF126601ADB6}"/>
            </c:ext>
          </c:extLst>
        </c:ser>
        <c:ser>
          <c:idx val="49"/>
          <c:order val="4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52:$Q$5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6D8D-417F-AE4B-BF126601ADB6}"/>
            </c:ext>
          </c:extLst>
        </c:ser>
        <c:ser>
          <c:idx val="50"/>
          <c:order val="5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53:$Q$5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2-6D8D-417F-AE4B-BF126601ADB6}"/>
            </c:ext>
          </c:extLst>
        </c:ser>
        <c:ser>
          <c:idx val="51"/>
          <c:order val="5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54:$Q$54</c:f>
              <c:numCache>
                <c:formatCode>General</c:formatCode>
                <c:ptCount val="13"/>
                <c:pt idx="4" formatCode="0">
                  <c:v>5471.56</c:v>
                </c:pt>
                <c:pt idx="6" formatCode="0">
                  <c:v>7058.71</c:v>
                </c:pt>
                <c:pt idx="7" formatCode="0">
                  <c:v>7897.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3-6D8D-417F-AE4B-BF126601ADB6}"/>
            </c:ext>
          </c:extLst>
        </c:ser>
        <c:ser>
          <c:idx val="52"/>
          <c:order val="5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55:$Q$55</c:f>
              <c:numCache>
                <c:formatCode>General</c:formatCode>
                <c:ptCount val="13"/>
                <c:pt idx="5" formatCode="0">
                  <c:v>2295.5349999999999</c:v>
                </c:pt>
                <c:pt idx="6" formatCode="0">
                  <c:v>1948.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4-6D8D-417F-AE4B-BF126601ADB6}"/>
            </c:ext>
          </c:extLst>
        </c:ser>
        <c:ser>
          <c:idx val="53"/>
          <c:order val="5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56:$Q$56</c:f>
              <c:numCache>
                <c:formatCode>General</c:formatCode>
                <c:ptCount val="13"/>
                <c:pt idx="4" formatCode="0">
                  <c:v>2604.13</c:v>
                </c:pt>
                <c:pt idx="5" formatCode="0">
                  <c:v>2939.56</c:v>
                </c:pt>
                <c:pt idx="6" formatCode="0">
                  <c:v>3002.5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5-6D8D-417F-AE4B-BF126601ADB6}"/>
            </c:ext>
          </c:extLst>
        </c:ser>
        <c:ser>
          <c:idx val="54"/>
          <c:order val="5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57:$Q$57</c:f>
              <c:numCache>
                <c:formatCode>General</c:formatCode>
                <c:ptCount val="13"/>
                <c:pt idx="3" formatCode="0">
                  <c:v>3132.82</c:v>
                </c:pt>
                <c:pt idx="4" formatCode="0">
                  <c:v>3281.92</c:v>
                </c:pt>
                <c:pt idx="5" formatCode="0">
                  <c:v>3660.52</c:v>
                </c:pt>
                <c:pt idx="6" formatCode="0">
                  <c:v>3704.38</c:v>
                </c:pt>
                <c:pt idx="7" formatCode="0">
                  <c:v>4207.14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6-6D8D-417F-AE4B-BF126601ADB6}"/>
            </c:ext>
          </c:extLst>
        </c:ser>
        <c:ser>
          <c:idx val="55"/>
          <c:order val="5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58:$Q$58</c:f>
              <c:numCache>
                <c:formatCode>General</c:formatCode>
                <c:ptCount val="13"/>
                <c:pt idx="3" formatCode="0">
                  <c:v>2089.16</c:v>
                </c:pt>
                <c:pt idx="4" formatCode="0">
                  <c:v>2160.2199999999998</c:v>
                </c:pt>
                <c:pt idx="5" formatCode="0">
                  <c:v>2497.21</c:v>
                </c:pt>
                <c:pt idx="6" formatCode="0">
                  <c:v>2487.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7-6D8D-417F-AE4B-BF126601ADB6}"/>
            </c:ext>
          </c:extLst>
        </c:ser>
        <c:ser>
          <c:idx val="56"/>
          <c:order val="5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59:$Q$59</c:f>
              <c:numCache>
                <c:formatCode>General</c:formatCode>
                <c:ptCount val="13"/>
                <c:pt idx="3" formatCode="0">
                  <c:v>1206.47</c:v>
                </c:pt>
                <c:pt idx="5" formatCode="0">
                  <c:v>1579.19</c:v>
                </c:pt>
                <c:pt idx="6" formatCode="0">
                  <c:v>1203.43</c:v>
                </c:pt>
                <c:pt idx="8" formatCode="0">
                  <c:v>1307.51</c:v>
                </c:pt>
                <c:pt idx="9" formatCode="0">
                  <c:v>1299.14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8-6D8D-417F-AE4B-BF126601ADB6}"/>
            </c:ext>
          </c:extLst>
        </c:ser>
        <c:ser>
          <c:idx val="57"/>
          <c:order val="5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60:$Q$60</c:f>
              <c:numCache>
                <c:formatCode>General</c:formatCode>
                <c:ptCount val="13"/>
                <c:pt idx="3" formatCode="0">
                  <c:v>3945.11</c:v>
                </c:pt>
                <c:pt idx="4" formatCode="0">
                  <c:v>4430.8100000000004</c:v>
                </c:pt>
                <c:pt idx="6" formatCode="0">
                  <c:v>5866.02</c:v>
                </c:pt>
                <c:pt idx="7" formatCode="0">
                  <c:v>4466.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9-6D8D-417F-AE4B-BF126601ADB6}"/>
            </c:ext>
          </c:extLst>
        </c:ser>
        <c:ser>
          <c:idx val="58"/>
          <c:order val="5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61:$Q$6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A-6D8D-417F-AE4B-BF126601ADB6}"/>
            </c:ext>
          </c:extLst>
        </c:ser>
        <c:ser>
          <c:idx val="59"/>
          <c:order val="5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62:$Q$6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B-6D8D-417F-AE4B-BF126601ADB6}"/>
            </c:ext>
          </c:extLst>
        </c:ser>
        <c:ser>
          <c:idx val="60"/>
          <c:order val="6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63:$Q$6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C-6D8D-417F-AE4B-BF126601ADB6}"/>
            </c:ext>
          </c:extLst>
        </c:ser>
        <c:ser>
          <c:idx val="61"/>
          <c:order val="6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64:$Q$6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D-6D8D-417F-AE4B-BF126601ADB6}"/>
            </c:ext>
          </c:extLst>
        </c:ser>
        <c:ser>
          <c:idx val="62"/>
          <c:order val="6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65:$Q$65</c:f>
              <c:numCache>
                <c:formatCode>General</c:formatCode>
                <c:ptCount val="13"/>
                <c:pt idx="3" formatCode="0">
                  <c:v>13032.67</c:v>
                </c:pt>
                <c:pt idx="4" formatCode="0">
                  <c:v>12875.29</c:v>
                </c:pt>
                <c:pt idx="5" formatCode="0">
                  <c:v>12516.29</c:v>
                </c:pt>
                <c:pt idx="6" formatCode="0">
                  <c:v>13666.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E-6D8D-417F-AE4B-BF126601ADB6}"/>
            </c:ext>
          </c:extLst>
        </c:ser>
        <c:ser>
          <c:idx val="63"/>
          <c:order val="6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66:$Q$66</c:f>
              <c:numCache>
                <c:formatCode>General</c:formatCode>
                <c:ptCount val="13"/>
                <c:pt idx="3" formatCode="0">
                  <c:v>1372.48</c:v>
                </c:pt>
                <c:pt idx="5" formatCode="0">
                  <c:v>1489.79</c:v>
                </c:pt>
                <c:pt idx="6" formatCode="0">
                  <c:v>1465.27</c:v>
                </c:pt>
                <c:pt idx="7" formatCode="0">
                  <c:v>1504.76</c:v>
                </c:pt>
                <c:pt idx="8" formatCode="0">
                  <c:v>1620.31</c:v>
                </c:pt>
                <c:pt idx="9" formatCode="0">
                  <c:v>1515.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F-6D8D-417F-AE4B-BF126601ADB6}"/>
            </c:ext>
          </c:extLst>
        </c:ser>
        <c:ser>
          <c:idx val="64"/>
          <c:order val="6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67:$Q$6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0-6D8D-417F-AE4B-BF126601ADB6}"/>
            </c:ext>
          </c:extLst>
        </c:ser>
        <c:ser>
          <c:idx val="65"/>
          <c:order val="6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68:$Q$68</c:f>
              <c:numCache>
                <c:formatCode>0</c:formatCode>
                <c:ptCount val="13"/>
                <c:pt idx="1">
                  <c:v>3957.04</c:v>
                </c:pt>
                <c:pt idx="3">
                  <c:v>3977.82</c:v>
                </c:pt>
                <c:pt idx="6">
                  <c:v>3804.23</c:v>
                </c:pt>
                <c:pt idx="7">
                  <c:v>2986.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1-6D8D-417F-AE4B-BF126601ADB6}"/>
            </c:ext>
          </c:extLst>
        </c:ser>
        <c:ser>
          <c:idx val="66"/>
          <c:order val="6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69:$Q$69</c:f>
              <c:numCache>
                <c:formatCode>General</c:formatCode>
                <c:ptCount val="13"/>
                <c:pt idx="4" formatCode="0">
                  <c:v>8017.3</c:v>
                </c:pt>
                <c:pt idx="5" formatCode="0">
                  <c:v>8693.33</c:v>
                </c:pt>
                <c:pt idx="6" formatCode="0">
                  <c:v>9958.43</c:v>
                </c:pt>
                <c:pt idx="7" formatCode="0">
                  <c:v>9763.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2-6D8D-417F-AE4B-BF126601ADB6}"/>
            </c:ext>
          </c:extLst>
        </c:ser>
        <c:ser>
          <c:idx val="67"/>
          <c:order val="6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70:$Q$70</c:f>
              <c:numCache>
                <c:formatCode>General</c:formatCode>
                <c:ptCount val="13"/>
                <c:pt idx="2" formatCode="0">
                  <c:v>4376.6899999999996</c:v>
                </c:pt>
                <c:pt idx="3" formatCode="0">
                  <c:v>4231.29</c:v>
                </c:pt>
                <c:pt idx="5" formatCode="0">
                  <c:v>2994.76</c:v>
                </c:pt>
                <c:pt idx="6" formatCode="0">
                  <c:v>3337.09</c:v>
                </c:pt>
                <c:pt idx="7" formatCode="0">
                  <c:v>2382.1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3-6D8D-417F-AE4B-BF126601ADB6}"/>
            </c:ext>
          </c:extLst>
        </c:ser>
        <c:ser>
          <c:idx val="68"/>
          <c:order val="6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71:$Q$71</c:f>
              <c:numCache>
                <c:formatCode>0</c:formatCode>
                <c:ptCount val="13"/>
                <c:pt idx="1">
                  <c:v>1596.18</c:v>
                </c:pt>
                <c:pt idx="3">
                  <c:v>1567.92</c:v>
                </c:pt>
                <c:pt idx="6">
                  <c:v>1677.72</c:v>
                </c:pt>
                <c:pt idx="7">
                  <c:v>1785.12</c:v>
                </c:pt>
                <c:pt idx="8">
                  <c:v>1872.04</c:v>
                </c:pt>
                <c:pt idx="9">
                  <c:v>2148.9299999999998</c:v>
                </c:pt>
                <c:pt idx="10">
                  <c:v>1748.17</c:v>
                </c:pt>
                <c:pt idx="11">
                  <c:v>1800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4-6D8D-417F-AE4B-BF126601ADB6}"/>
            </c:ext>
          </c:extLst>
        </c:ser>
        <c:ser>
          <c:idx val="69"/>
          <c:order val="6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72:$Q$72</c:f>
              <c:numCache>
                <c:formatCode>General</c:formatCode>
                <c:ptCount val="13"/>
                <c:pt idx="2" formatCode="0">
                  <c:v>8791.19</c:v>
                </c:pt>
                <c:pt idx="3" formatCode="0">
                  <c:v>8632.67</c:v>
                </c:pt>
                <c:pt idx="4" formatCode="0">
                  <c:v>8400.4</c:v>
                </c:pt>
                <c:pt idx="5" formatCode="0">
                  <c:v>8140.93</c:v>
                </c:pt>
                <c:pt idx="6" formatCode="0">
                  <c:v>8087.05</c:v>
                </c:pt>
                <c:pt idx="7" formatCode="0">
                  <c:v>8017.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5-6D8D-417F-AE4B-BF126601ADB6}"/>
            </c:ext>
          </c:extLst>
        </c:ser>
        <c:ser>
          <c:idx val="70"/>
          <c:order val="7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73:$Q$73</c:f>
              <c:numCache>
                <c:formatCode>General</c:formatCode>
                <c:ptCount val="13"/>
                <c:pt idx="2" formatCode="0">
                  <c:v>2114.94</c:v>
                </c:pt>
                <c:pt idx="4" formatCode="0">
                  <c:v>1776.45</c:v>
                </c:pt>
                <c:pt idx="6" formatCode="0">
                  <c:v>1629.8</c:v>
                </c:pt>
                <c:pt idx="8" formatCode="0">
                  <c:v>1953.62</c:v>
                </c:pt>
                <c:pt idx="10" formatCode="0">
                  <c:v>2124.94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6-6D8D-417F-AE4B-BF126601ADB6}"/>
            </c:ext>
          </c:extLst>
        </c:ser>
        <c:ser>
          <c:idx val="71"/>
          <c:order val="7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74:$Q$74</c:f>
              <c:numCache>
                <c:formatCode>General</c:formatCode>
                <c:ptCount val="13"/>
                <c:pt idx="5" formatCode="0">
                  <c:v>5143.5129999999999</c:v>
                </c:pt>
                <c:pt idx="6" formatCode="0">
                  <c:v>5507.2250000000004</c:v>
                </c:pt>
                <c:pt idx="7" formatCode="0">
                  <c:v>4600.162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7-6D8D-417F-AE4B-BF126601ADB6}"/>
            </c:ext>
          </c:extLst>
        </c:ser>
        <c:ser>
          <c:idx val="72"/>
          <c:order val="7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75:$Q$75</c:f>
              <c:numCache>
                <c:formatCode>General</c:formatCode>
                <c:ptCount val="13"/>
                <c:pt idx="5" formatCode="0">
                  <c:v>1547.7049999999999</c:v>
                </c:pt>
                <c:pt idx="6" formatCode="0">
                  <c:v>1545.5989999999999</c:v>
                </c:pt>
                <c:pt idx="7" formatCode="0">
                  <c:v>1585.625</c:v>
                </c:pt>
                <c:pt idx="8" formatCode="0">
                  <c:v>1737.445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8-6D8D-417F-AE4B-BF126601ADB6}"/>
            </c:ext>
          </c:extLst>
        </c:ser>
        <c:ser>
          <c:idx val="73"/>
          <c:order val="7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76:$Q$7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9-6D8D-417F-AE4B-BF126601ADB6}"/>
            </c:ext>
          </c:extLst>
        </c:ser>
        <c:ser>
          <c:idx val="74"/>
          <c:order val="7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77:$Q$77</c:f>
              <c:numCache>
                <c:formatCode>General</c:formatCode>
                <c:ptCount val="13"/>
                <c:pt idx="4" formatCode="0">
                  <c:v>3624.1860000000001</c:v>
                </c:pt>
                <c:pt idx="5" formatCode="0">
                  <c:v>3874.82</c:v>
                </c:pt>
                <c:pt idx="6" formatCode="0">
                  <c:v>4425.902</c:v>
                </c:pt>
                <c:pt idx="7" formatCode="0">
                  <c:v>4575.6210000000001</c:v>
                </c:pt>
                <c:pt idx="8" formatCode="0">
                  <c:v>4569.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A-6D8D-417F-AE4B-BF126601ADB6}"/>
            </c:ext>
          </c:extLst>
        </c:ser>
        <c:ser>
          <c:idx val="75"/>
          <c:order val="7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78:$Q$78</c:f>
              <c:numCache>
                <c:formatCode>General</c:formatCode>
                <c:ptCount val="13"/>
                <c:pt idx="4" formatCode="0">
                  <c:v>2025.4169999999999</c:v>
                </c:pt>
                <c:pt idx="5" formatCode="0">
                  <c:v>2278.2689999999998</c:v>
                </c:pt>
                <c:pt idx="6" formatCode="0">
                  <c:v>2204.286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B-6D8D-417F-AE4B-BF126601ADB6}"/>
            </c:ext>
          </c:extLst>
        </c:ser>
        <c:ser>
          <c:idx val="76"/>
          <c:order val="7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79:$Q$79</c:f>
              <c:numCache>
                <c:formatCode>General</c:formatCode>
                <c:ptCount val="13"/>
                <c:pt idx="4" formatCode="0">
                  <c:v>5256.2870000000003</c:v>
                </c:pt>
                <c:pt idx="6" formatCode="0">
                  <c:v>5248.9859999999999</c:v>
                </c:pt>
                <c:pt idx="7" formatCode="0">
                  <c:v>5349.582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C-6D8D-417F-AE4B-BF126601ADB6}"/>
            </c:ext>
          </c:extLst>
        </c:ser>
        <c:ser>
          <c:idx val="77"/>
          <c:order val="7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80:$Q$8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D-6D8D-417F-AE4B-BF126601ADB6}"/>
            </c:ext>
          </c:extLst>
        </c:ser>
        <c:ser>
          <c:idx val="78"/>
          <c:order val="7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81:$Q$81</c:f>
              <c:numCache>
                <c:formatCode>General</c:formatCode>
                <c:ptCount val="13"/>
                <c:pt idx="4" formatCode="0">
                  <c:v>1550.2940000000001</c:v>
                </c:pt>
                <c:pt idx="6" formatCode="0">
                  <c:v>1568.9469999999999</c:v>
                </c:pt>
                <c:pt idx="7" formatCode="0">
                  <c:v>1509.838</c:v>
                </c:pt>
                <c:pt idx="9" formatCode="0">
                  <c:v>1372.75</c:v>
                </c:pt>
                <c:pt idx="11" formatCode="0">
                  <c:v>1356.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E-6D8D-417F-AE4B-BF126601ADB6}"/>
            </c:ext>
          </c:extLst>
        </c:ser>
        <c:ser>
          <c:idx val="79"/>
          <c:order val="7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82:$Q$8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F-6D8D-417F-AE4B-BF126601ADB6}"/>
            </c:ext>
          </c:extLst>
        </c:ser>
        <c:ser>
          <c:idx val="80"/>
          <c:order val="8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83:$Q$83</c:f>
              <c:numCache>
                <c:formatCode>General</c:formatCode>
                <c:ptCount val="13"/>
                <c:pt idx="5" formatCode="0">
                  <c:v>7058.3</c:v>
                </c:pt>
                <c:pt idx="6" formatCode="0">
                  <c:v>6830.12</c:v>
                </c:pt>
                <c:pt idx="7" formatCode="0">
                  <c:v>6123.05</c:v>
                </c:pt>
                <c:pt idx="8" formatCode="0">
                  <c:v>6070.46</c:v>
                </c:pt>
                <c:pt idx="9" formatCode="0">
                  <c:v>6401.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0-6D8D-417F-AE4B-BF126601ADB6}"/>
            </c:ext>
          </c:extLst>
        </c:ser>
        <c:ser>
          <c:idx val="81"/>
          <c:order val="8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84:$Q$84</c:f>
              <c:numCache>
                <c:formatCode>General</c:formatCode>
                <c:ptCount val="13"/>
                <c:pt idx="4" formatCode="0">
                  <c:v>1239.4880000000001</c:v>
                </c:pt>
                <c:pt idx="6" formatCode="0">
                  <c:v>1335.9449999999999</c:v>
                </c:pt>
                <c:pt idx="11" formatCode="0">
                  <c:v>2057.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1-6D8D-417F-AE4B-BF126601ADB6}"/>
            </c:ext>
          </c:extLst>
        </c:ser>
        <c:ser>
          <c:idx val="82"/>
          <c:order val="8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85:$Q$8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2-6D8D-417F-AE4B-BF126601ADB6}"/>
            </c:ext>
          </c:extLst>
        </c:ser>
        <c:ser>
          <c:idx val="83"/>
          <c:order val="8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86:$Q$8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3-6D8D-417F-AE4B-BF126601ADB6}"/>
            </c:ext>
          </c:extLst>
        </c:ser>
        <c:ser>
          <c:idx val="84"/>
          <c:order val="8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87:$Q$87</c:f>
              <c:numCache>
                <c:formatCode>0</c:formatCode>
                <c:ptCount val="13"/>
                <c:pt idx="1">
                  <c:v>3142.49</c:v>
                </c:pt>
                <c:pt idx="2">
                  <c:v>3083.88</c:v>
                </c:pt>
                <c:pt idx="3">
                  <c:v>3035.84</c:v>
                </c:pt>
                <c:pt idx="4">
                  <c:v>3052.39</c:v>
                </c:pt>
                <c:pt idx="5">
                  <c:v>3252.25</c:v>
                </c:pt>
                <c:pt idx="6">
                  <c:v>3539.75</c:v>
                </c:pt>
                <c:pt idx="7">
                  <c:v>3965.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4-6D8D-417F-AE4B-BF126601ADB6}"/>
            </c:ext>
          </c:extLst>
        </c:ser>
        <c:ser>
          <c:idx val="85"/>
          <c:order val="8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88:$Q$88</c:f>
              <c:numCache>
                <c:formatCode>General</c:formatCode>
                <c:ptCount val="13"/>
                <c:pt idx="5" formatCode="0">
                  <c:v>1918.01</c:v>
                </c:pt>
                <c:pt idx="6" formatCode="0">
                  <c:v>1953.22</c:v>
                </c:pt>
                <c:pt idx="8" formatCode="0">
                  <c:v>2090.1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5-6D8D-417F-AE4B-BF126601ADB6}"/>
            </c:ext>
          </c:extLst>
        </c:ser>
        <c:ser>
          <c:idx val="86"/>
          <c:order val="8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89:$Q$89</c:f>
              <c:numCache>
                <c:formatCode>0</c:formatCode>
                <c:ptCount val="13"/>
                <c:pt idx="0">
                  <c:v>2494.4499999999998</c:v>
                </c:pt>
                <c:pt idx="1">
                  <c:v>2888.79</c:v>
                </c:pt>
                <c:pt idx="2">
                  <c:v>3159.75</c:v>
                </c:pt>
                <c:pt idx="3">
                  <c:v>3304.27</c:v>
                </c:pt>
                <c:pt idx="4">
                  <c:v>3334.08</c:v>
                </c:pt>
                <c:pt idx="6">
                  <c:v>3459.23</c:v>
                </c:pt>
                <c:pt idx="8">
                  <c:v>4084.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6-6D8D-417F-AE4B-BF126601ADB6}"/>
            </c:ext>
          </c:extLst>
        </c:ser>
        <c:ser>
          <c:idx val="87"/>
          <c:order val="8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90:$Q$90</c:f>
              <c:numCache>
                <c:formatCode>General</c:formatCode>
                <c:ptCount val="13"/>
                <c:pt idx="4" formatCode="0">
                  <c:v>825.79</c:v>
                </c:pt>
                <c:pt idx="5" formatCode="0">
                  <c:v>807.34</c:v>
                </c:pt>
                <c:pt idx="6" formatCode="0">
                  <c:v>840.13</c:v>
                </c:pt>
                <c:pt idx="7" formatCode="0">
                  <c:v>873.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7-6D8D-417F-AE4B-BF126601ADB6}"/>
            </c:ext>
          </c:extLst>
        </c:ser>
        <c:ser>
          <c:idx val="88"/>
          <c:order val="8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91:$Q$91</c:f>
              <c:numCache>
                <c:formatCode>0</c:formatCode>
                <c:ptCount val="13"/>
                <c:pt idx="0">
                  <c:v>1770.23</c:v>
                </c:pt>
                <c:pt idx="1">
                  <c:v>1832.25</c:v>
                </c:pt>
                <c:pt idx="2">
                  <c:v>2109.54</c:v>
                </c:pt>
                <c:pt idx="4">
                  <c:v>2255.37</c:v>
                </c:pt>
                <c:pt idx="5">
                  <c:v>2524.0700000000002</c:v>
                </c:pt>
                <c:pt idx="6">
                  <c:v>2638.57</c:v>
                </c:pt>
                <c:pt idx="7">
                  <c:v>2760.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8-6D8D-417F-AE4B-BF126601ADB6}"/>
            </c:ext>
          </c:extLst>
        </c:ser>
        <c:ser>
          <c:idx val="89"/>
          <c:order val="8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92:$Q$9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9-6D8D-417F-AE4B-BF126601ADB6}"/>
            </c:ext>
          </c:extLst>
        </c:ser>
        <c:ser>
          <c:idx val="90"/>
          <c:order val="9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93:$Q$93</c:f>
              <c:numCache>
                <c:formatCode>0</c:formatCode>
                <c:ptCount val="13"/>
                <c:pt idx="1">
                  <c:v>4126.88</c:v>
                </c:pt>
                <c:pt idx="2">
                  <c:v>4992.28</c:v>
                </c:pt>
                <c:pt idx="6">
                  <c:v>6028.94</c:v>
                </c:pt>
                <c:pt idx="7">
                  <c:v>6154.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A-6D8D-417F-AE4B-BF126601ADB6}"/>
            </c:ext>
          </c:extLst>
        </c:ser>
        <c:ser>
          <c:idx val="91"/>
          <c:order val="9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94:$Q$94</c:f>
              <c:numCache>
                <c:formatCode>General</c:formatCode>
                <c:ptCount val="13"/>
                <c:pt idx="3" formatCode="0">
                  <c:v>4362.32</c:v>
                </c:pt>
                <c:pt idx="4" formatCode="0">
                  <c:v>4833.2299999999996</c:v>
                </c:pt>
                <c:pt idx="5" formatCode="0">
                  <c:v>5345.24</c:v>
                </c:pt>
                <c:pt idx="6" formatCode="0">
                  <c:v>5230.45</c:v>
                </c:pt>
                <c:pt idx="7" formatCode="0">
                  <c:v>5301.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B-6D8D-417F-AE4B-BF126601ADB6}"/>
            </c:ext>
          </c:extLst>
        </c:ser>
        <c:ser>
          <c:idx val="92"/>
          <c:order val="9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95:$Q$9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C-6D8D-417F-AE4B-BF126601ADB6}"/>
            </c:ext>
          </c:extLst>
        </c:ser>
        <c:ser>
          <c:idx val="93"/>
          <c:order val="9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96:$Q$9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D-6D8D-417F-AE4B-BF126601ADB6}"/>
            </c:ext>
          </c:extLst>
        </c:ser>
        <c:ser>
          <c:idx val="94"/>
          <c:order val="9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H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HD (実測)'!$E$97:$Q$9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E-6D8D-417F-AE4B-BF126601AD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7146136"/>
        <c:axId val="397148488"/>
      </c:lineChart>
      <c:catAx>
        <c:axId val="3971461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 sz="1600" baseline="0"/>
            </a:pPr>
            <a:endParaRPr lang="ja-JP"/>
          </a:p>
        </c:txPr>
        <c:crossAx val="397148488"/>
        <c:crosses val="autoZero"/>
        <c:auto val="1"/>
        <c:lblAlgn val="ctr"/>
        <c:lblOffset val="100"/>
        <c:noMultiLvlLbl val="0"/>
      </c:catAx>
      <c:valAx>
        <c:axId val="397148488"/>
        <c:scaling>
          <c:orientation val="minMax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 lang="ja-JP" sz="1800" baseline="0"/>
                </a:pPr>
                <a:r>
                  <a:rPr lang="en-US" altLang="ja-JP" sz="1800" baseline="0" dirty="0"/>
                  <a:t>TLV (mL)</a:t>
                </a:r>
                <a:endParaRPr lang="ja-JP" altLang="en-US" sz="1800" baseline="0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 sz="1600" baseline="0"/>
            </a:pPr>
            <a:endParaRPr lang="ja-JP"/>
          </a:p>
        </c:txPr>
        <c:crossAx val="397146136"/>
        <c:crosses val="autoZero"/>
        <c:crossBetween val="between"/>
      </c:valAx>
    </c:plotArea>
    <c:plotVisOnly val="1"/>
    <c:dispBlanksAs val="span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40026058619788"/>
          <c:y val="3.968040006280607E-2"/>
          <c:w val="0.86433638530249135"/>
          <c:h val="0.8711315969120067"/>
        </c:manualLayout>
      </c:layout>
      <c:lineChart>
        <c:grouping val="standard"/>
        <c:varyColors val="0"/>
        <c:ser>
          <c:idx val="0"/>
          <c:order val="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3:$Q$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9F2-46FE-9D71-760AF53C7678}"/>
            </c:ext>
          </c:extLst>
        </c:ser>
        <c:ser>
          <c:idx val="1"/>
          <c:order val="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4:$Q$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9F2-46FE-9D71-760AF53C7678}"/>
            </c:ext>
          </c:extLst>
        </c:ser>
        <c:ser>
          <c:idx val="2"/>
          <c:order val="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5:$Q$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9F2-46FE-9D71-760AF53C7678}"/>
            </c:ext>
          </c:extLst>
        </c:ser>
        <c:ser>
          <c:idx val="3"/>
          <c:order val="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6:$Q$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9F2-46FE-9D71-760AF53C7678}"/>
            </c:ext>
          </c:extLst>
        </c:ser>
        <c:ser>
          <c:idx val="4"/>
          <c:order val="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7:$Q$7</c:f>
              <c:numCache>
                <c:formatCode>General</c:formatCode>
                <c:ptCount val="13"/>
                <c:pt idx="3" formatCode="0">
                  <c:v>2239.2240000000002</c:v>
                </c:pt>
                <c:pt idx="5" formatCode="0">
                  <c:v>2570.7869999999998</c:v>
                </c:pt>
                <c:pt idx="6" formatCode="0">
                  <c:v>2604.5529999999999</c:v>
                </c:pt>
                <c:pt idx="7" formatCode="0">
                  <c:v>3229.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9F2-46FE-9D71-760AF53C7678}"/>
            </c:ext>
          </c:extLst>
        </c:ser>
        <c:ser>
          <c:idx val="5"/>
          <c:order val="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8:$Q$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9F2-46FE-9D71-760AF53C7678}"/>
            </c:ext>
          </c:extLst>
        </c:ser>
        <c:ser>
          <c:idx val="6"/>
          <c:order val="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9:$Q$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19F2-46FE-9D71-760AF53C7678}"/>
            </c:ext>
          </c:extLst>
        </c:ser>
        <c:ser>
          <c:idx val="7"/>
          <c:order val="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10:$Q$10</c:f>
              <c:numCache>
                <c:formatCode>General</c:formatCode>
                <c:ptCount val="13"/>
                <c:pt idx="4" formatCode="0">
                  <c:v>1965.5650000000001</c:v>
                </c:pt>
                <c:pt idx="6" formatCode="0">
                  <c:v>1665.63</c:v>
                </c:pt>
                <c:pt idx="7" formatCode="0">
                  <c:v>1987.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19F2-46FE-9D71-760AF53C7678}"/>
            </c:ext>
          </c:extLst>
        </c:ser>
        <c:ser>
          <c:idx val="8"/>
          <c:order val="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11:$Q$1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19F2-46FE-9D71-760AF53C7678}"/>
            </c:ext>
          </c:extLst>
        </c:ser>
        <c:ser>
          <c:idx val="9"/>
          <c:order val="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12:$Q$1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19F2-46FE-9D71-760AF53C7678}"/>
            </c:ext>
          </c:extLst>
        </c:ser>
        <c:ser>
          <c:idx val="10"/>
          <c:order val="1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13:$Q$1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19F2-46FE-9D71-760AF53C7678}"/>
            </c:ext>
          </c:extLst>
        </c:ser>
        <c:ser>
          <c:idx val="11"/>
          <c:order val="1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14:$Q$1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19F2-46FE-9D71-760AF53C7678}"/>
            </c:ext>
          </c:extLst>
        </c:ser>
        <c:ser>
          <c:idx val="12"/>
          <c:order val="1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15:$Q$1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19F2-46FE-9D71-760AF53C7678}"/>
            </c:ext>
          </c:extLst>
        </c:ser>
        <c:ser>
          <c:idx val="13"/>
          <c:order val="1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16:$Q$1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19F2-46FE-9D71-760AF53C7678}"/>
            </c:ext>
          </c:extLst>
        </c:ser>
        <c:ser>
          <c:idx val="14"/>
          <c:order val="1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17:$Q$1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19F2-46FE-9D71-760AF53C7678}"/>
            </c:ext>
          </c:extLst>
        </c:ser>
        <c:ser>
          <c:idx val="15"/>
          <c:order val="1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18:$Q$1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19F2-46FE-9D71-760AF53C7678}"/>
            </c:ext>
          </c:extLst>
        </c:ser>
        <c:ser>
          <c:idx val="16"/>
          <c:order val="1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19:$Q$1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19F2-46FE-9D71-760AF53C7678}"/>
            </c:ext>
          </c:extLst>
        </c:ser>
        <c:ser>
          <c:idx val="17"/>
          <c:order val="1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20:$Q$2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19F2-46FE-9D71-760AF53C7678}"/>
            </c:ext>
          </c:extLst>
        </c:ser>
        <c:ser>
          <c:idx val="18"/>
          <c:order val="1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21:$Q$21</c:f>
              <c:numCache>
                <c:formatCode>General</c:formatCode>
                <c:ptCount val="13"/>
                <c:pt idx="2" formatCode="0">
                  <c:v>1403.768</c:v>
                </c:pt>
                <c:pt idx="4" formatCode="0">
                  <c:v>1513.33</c:v>
                </c:pt>
                <c:pt idx="6" formatCode="0">
                  <c:v>1689.31</c:v>
                </c:pt>
                <c:pt idx="7" formatCode="0">
                  <c:v>182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19F2-46FE-9D71-760AF53C7678}"/>
            </c:ext>
          </c:extLst>
        </c:ser>
        <c:ser>
          <c:idx val="19"/>
          <c:order val="1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22:$Q$2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19F2-46FE-9D71-760AF53C7678}"/>
            </c:ext>
          </c:extLst>
        </c:ser>
        <c:ser>
          <c:idx val="20"/>
          <c:order val="2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23:$Q$2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19F2-46FE-9D71-760AF53C7678}"/>
            </c:ext>
          </c:extLst>
        </c:ser>
        <c:ser>
          <c:idx val="21"/>
          <c:order val="2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24:$Q$2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19F2-46FE-9D71-760AF53C7678}"/>
            </c:ext>
          </c:extLst>
        </c:ser>
        <c:ser>
          <c:idx val="22"/>
          <c:order val="2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25:$Q$2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19F2-46FE-9D71-760AF53C7678}"/>
            </c:ext>
          </c:extLst>
        </c:ser>
        <c:ser>
          <c:idx val="23"/>
          <c:order val="2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26:$Q$2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19F2-46FE-9D71-760AF53C7678}"/>
            </c:ext>
          </c:extLst>
        </c:ser>
        <c:ser>
          <c:idx val="24"/>
          <c:order val="2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27:$Q$2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19F2-46FE-9D71-760AF53C7678}"/>
            </c:ext>
          </c:extLst>
        </c:ser>
        <c:ser>
          <c:idx val="25"/>
          <c:order val="2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28:$Q$2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19F2-46FE-9D71-760AF53C7678}"/>
            </c:ext>
          </c:extLst>
        </c:ser>
        <c:ser>
          <c:idx val="26"/>
          <c:order val="2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29:$Q$2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19F2-46FE-9D71-760AF53C7678}"/>
            </c:ext>
          </c:extLst>
        </c:ser>
        <c:ser>
          <c:idx val="27"/>
          <c:order val="2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30:$Q$3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19F2-46FE-9D71-760AF53C7678}"/>
            </c:ext>
          </c:extLst>
        </c:ser>
        <c:ser>
          <c:idx val="28"/>
          <c:order val="2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31:$Q$3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19F2-46FE-9D71-760AF53C7678}"/>
            </c:ext>
          </c:extLst>
        </c:ser>
        <c:ser>
          <c:idx val="29"/>
          <c:order val="2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32:$Q$32</c:f>
              <c:numCache>
                <c:formatCode>General</c:formatCode>
                <c:ptCount val="13"/>
                <c:pt idx="2" formatCode="0">
                  <c:v>1702.69</c:v>
                </c:pt>
                <c:pt idx="4" formatCode="0">
                  <c:v>1794.95</c:v>
                </c:pt>
                <c:pt idx="5" formatCode="0">
                  <c:v>1563.41</c:v>
                </c:pt>
                <c:pt idx="6" formatCode="0">
                  <c:v>1570.53</c:v>
                </c:pt>
                <c:pt idx="7" formatCode="0">
                  <c:v>1800.94</c:v>
                </c:pt>
                <c:pt idx="8" formatCode="0">
                  <c:v>1911.51</c:v>
                </c:pt>
                <c:pt idx="9" formatCode="0">
                  <c:v>1915.37</c:v>
                </c:pt>
                <c:pt idx="10" formatCode="0">
                  <c:v>2132.07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19F2-46FE-9D71-760AF53C7678}"/>
            </c:ext>
          </c:extLst>
        </c:ser>
        <c:ser>
          <c:idx val="30"/>
          <c:order val="3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33:$Q$3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19F2-46FE-9D71-760AF53C7678}"/>
            </c:ext>
          </c:extLst>
        </c:ser>
        <c:ser>
          <c:idx val="31"/>
          <c:order val="3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34:$Q$3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19F2-46FE-9D71-760AF53C7678}"/>
            </c:ext>
          </c:extLst>
        </c:ser>
        <c:ser>
          <c:idx val="32"/>
          <c:order val="3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35:$Q$3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19F2-46FE-9D71-760AF53C7678}"/>
            </c:ext>
          </c:extLst>
        </c:ser>
        <c:ser>
          <c:idx val="33"/>
          <c:order val="3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36:$Q$3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19F2-46FE-9D71-760AF53C7678}"/>
            </c:ext>
          </c:extLst>
        </c:ser>
        <c:ser>
          <c:idx val="34"/>
          <c:order val="3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37:$Q$3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19F2-46FE-9D71-760AF53C7678}"/>
            </c:ext>
          </c:extLst>
        </c:ser>
        <c:ser>
          <c:idx val="35"/>
          <c:order val="3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38:$Q$3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19F2-46FE-9D71-760AF53C7678}"/>
            </c:ext>
          </c:extLst>
        </c:ser>
        <c:ser>
          <c:idx val="36"/>
          <c:order val="3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39:$Q$39</c:f>
              <c:numCache>
                <c:formatCode>General</c:formatCode>
                <c:ptCount val="13"/>
                <c:pt idx="5" formatCode="0">
                  <c:v>1487.59</c:v>
                </c:pt>
                <c:pt idx="6" formatCode="0">
                  <c:v>1674.72</c:v>
                </c:pt>
                <c:pt idx="7" formatCode="0">
                  <c:v>1878.75</c:v>
                </c:pt>
                <c:pt idx="8" formatCode="0">
                  <c:v>1805.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4-19F2-46FE-9D71-760AF53C7678}"/>
            </c:ext>
          </c:extLst>
        </c:ser>
        <c:ser>
          <c:idx val="37"/>
          <c:order val="3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40:$Q$4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19F2-46FE-9D71-760AF53C7678}"/>
            </c:ext>
          </c:extLst>
        </c:ser>
        <c:ser>
          <c:idx val="38"/>
          <c:order val="3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41:$Q$4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6-19F2-46FE-9D71-760AF53C7678}"/>
            </c:ext>
          </c:extLst>
        </c:ser>
        <c:ser>
          <c:idx val="39"/>
          <c:order val="3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42:$Q$42</c:f>
              <c:numCache>
                <c:formatCode>General</c:formatCode>
                <c:ptCount val="13"/>
                <c:pt idx="2" formatCode="0">
                  <c:v>1274.453</c:v>
                </c:pt>
                <c:pt idx="5" formatCode="0">
                  <c:v>1381.4</c:v>
                </c:pt>
                <c:pt idx="6" formatCode="0">
                  <c:v>1634.37</c:v>
                </c:pt>
                <c:pt idx="7" formatCode="0">
                  <c:v>1581.16</c:v>
                </c:pt>
                <c:pt idx="8" formatCode="0">
                  <c:v>1713.96</c:v>
                </c:pt>
                <c:pt idx="9" formatCode="0">
                  <c:v>1953.15</c:v>
                </c:pt>
                <c:pt idx="10" formatCode="0">
                  <c:v>1708.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19F2-46FE-9D71-760AF53C7678}"/>
            </c:ext>
          </c:extLst>
        </c:ser>
        <c:ser>
          <c:idx val="40"/>
          <c:order val="4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43:$Q$4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8-19F2-46FE-9D71-760AF53C7678}"/>
            </c:ext>
          </c:extLst>
        </c:ser>
        <c:ser>
          <c:idx val="41"/>
          <c:order val="4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44:$Q$4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9-19F2-46FE-9D71-760AF53C7678}"/>
            </c:ext>
          </c:extLst>
        </c:ser>
        <c:ser>
          <c:idx val="42"/>
          <c:order val="4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45:$Q$4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19F2-46FE-9D71-760AF53C7678}"/>
            </c:ext>
          </c:extLst>
        </c:ser>
        <c:ser>
          <c:idx val="43"/>
          <c:order val="4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46:$Q$4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19F2-46FE-9D71-760AF53C7678}"/>
            </c:ext>
          </c:extLst>
        </c:ser>
        <c:ser>
          <c:idx val="44"/>
          <c:order val="4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47:$Q$4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C-19F2-46FE-9D71-760AF53C7678}"/>
            </c:ext>
          </c:extLst>
        </c:ser>
        <c:ser>
          <c:idx val="45"/>
          <c:order val="4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48:$Q$4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D-19F2-46FE-9D71-760AF53C7678}"/>
            </c:ext>
          </c:extLst>
        </c:ser>
        <c:ser>
          <c:idx val="46"/>
          <c:order val="4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49:$Q$4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E-19F2-46FE-9D71-760AF53C7678}"/>
            </c:ext>
          </c:extLst>
        </c:ser>
        <c:ser>
          <c:idx val="47"/>
          <c:order val="4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50:$Q$5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F-19F2-46FE-9D71-760AF53C7678}"/>
            </c:ext>
          </c:extLst>
        </c:ser>
        <c:ser>
          <c:idx val="48"/>
          <c:order val="4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51:$Q$5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0-19F2-46FE-9D71-760AF53C7678}"/>
            </c:ext>
          </c:extLst>
        </c:ser>
        <c:ser>
          <c:idx val="49"/>
          <c:order val="4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52:$Q$5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1-19F2-46FE-9D71-760AF53C7678}"/>
            </c:ext>
          </c:extLst>
        </c:ser>
        <c:ser>
          <c:idx val="50"/>
          <c:order val="5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53:$Q$5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2-19F2-46FE-9D71-760AF53C7678}"/>
            </c:ext>
          </c:extLst>
        </c:ser>
        <c:ser>
          <c:idx val="51"/>
          <c:order val="5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54:$Q$5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3-19F2-46FE-9D71-760AF53C7678}"/>
            </c:ext>
          </c:extLst>
        </c:ser>
        <c:ser>
          <c:idx val="52"/>
          <c:order val="5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55:$Q$5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4-19F2-46FE-9D71-760AF53C7678}"/>
            </c:ext>
          </c:extLst>
        </c:ser>
        <c:ser>
          <c:idx val="53"/>
          <c:order val="5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56:$Q$5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5-19F2-46FE-9D71-760AF53C7678}"/>
            </c:ext>
          </c:extLst>
        </c:ser>
        <c:ser>
          <c:idx val="54"/>
          <c:order val="5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57:$Q$5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6-19F2-46FE-9D71-760AF53C7678}"/>
            </c:ext>
          </c:extLst>
        </c:ser>
        <c:ser>
          <c:idx val="55"/>
          <c:order val="5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58:$Q$5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7-19F2-46FE-9D71-760AF53C7678}"/>
            </c:ext>
          </c:extLst>
        </c:ser>
        <c:ser>
          <c:idx val="56"/>
          <c:order val="5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59:$Q$5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8-19F2-46FE-9D71-760AF53C7678}"/>
            </c:ext>
          </c:extLst>
        </c:ser>
        <c:ser>
          <c:idx val="57"/>
          <c:order val="5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60:$Q$6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9-19F2-46FE-9D71-760AF53C7678}"/>
            </c:ext>
          </c:extLst>
        </c:ser>
        <c:ser>
          <c:idx val="58"/>
          <c:order val="5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61:$Q$6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A-19F2-46FE-9D71-760AF53C7678}"/>
            </c:ext>
          </c:extLst>
        </c:ser>
        <c:ser>
          <c:idx val="59"/>
          <c:order val="5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62:$Q$6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B-19F2-46FE-9D71-760AF53C7678}"/>
            </c:ext>
          </c:extLst>
        </c:ser>
        <c:ser>
          <c:idx val="60"/>
          <c:order val="6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63:$Q$63</c:f>
              <c:numCache>
                <c:formatCode>General</c:formatCode>
                <c:ptCount val="13"/>
                <c:pt idx="2" formatCode="0">
                  <c:v>1956.68</c:v>
                </c:pt>
                <c:pt idx="3" formatCode="0">
                  <c:v>2064.34</c:v>
                </c:pt>
                <c:pt idx="4" formatCode="0">
                  <c:v>1646.74</c:v>
                </c:pt>
                <c:pt idx="5" formatCode="0">
                  <c:v>1950.87</c:v>
                </c:pt>
                <c:pt idx="6" formatCode="0">
                  <c:v>2069.0300000000002</c:v>
                </c:pt>
                <c:pt idx="7" formatCode="0">
                  <c:v>2104.85</c:v>
                </c:pt>
                <c:pt idx="8" formatCode="0">
                  <c:v>2099.16</c:v>
                </c:pt>
                <c:pt idx="9" formatCode="0">
                  <c:v>2091.67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C-19F2-46FE-9D71-760AF53C7678}"/>
            </c:ext>
          </c:extLst>
        </c:ser>
        <c:ser>
          <c:idx val="61"/>
          <c:order val="6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64:$Q$6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D-19F2-46FE-9D71-760AF53C7678}"/>
            </c:ext>
          </c:extLst>
        </c:ser>
        <c:ser>
          <c:idx val="62"/>
          <c:order val="6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65:$Q$6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E-19F2-46FE-9D71-760AF53C7678}"/>
            </c:ext>
          </c:extLst>
        </c:ser>
        <c:ser>
          <c:idx val="63"/>
          <c:order val="6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66:$Q$6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F-19F2-46FE-9D71-760AF53C7678}"/>
            </c:ext>
          </c:extLst>
        </c:ser>
        <c:ser>
          <c:idx val="64"/>
          <c:order val="6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67:$Q$6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0-19F2-46FE-9D71-760AF53C7678}"/>
            </c:ext>
          </c:extLst>
        </c:ser>
        <c:ser>
          <c:idx val="65"/>
          <c:order val="6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68:$Q$6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1-19F2-46FE-9D71-760AF53C7678}"/>
            </c:ext>
          </c:extLst>
        </c:ser>
        <c:ser>
          <c:idx val="66"/>
          <c:order val="6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69:$Q$6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2-19F2-46FE-9D71-760AF53C7678}"/>
            </c:ext>
          </c:extLst>
        </c:ser>
        <c:ser>
          <c:idx val="67"/>
          <c:order val="6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70:$Q$7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3-19F2-46FE-9D71-760AF53C7678}"/>
            </c:ext>
          </c:extLst>
        </c:ser>
        <c:ser>
          <c:idx val="68"/>
          <c:order val="6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71:$Q$7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4-19F2-46FE-9D71-760AF53C7678}"/>
            </c:ext>
          </c:extLst>
        </c:ser>
        <c:ser>
          <c:idx val="69"/>
          <c:order val="6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72:$Q$7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5-19F2-46FE-9D71-760AF53C7678}"/>
            </c:ext>
          </c:extLst>
        </c:ser>
        <c:ser>
          <c:idx val="70"/>
          <c:order val="7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73:$Q$7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6-19F2-46FE-9D71-760AF53C7678}"/>
            </c:ext>
          </c:extLst>
        </c:ser>
        <c:ser>
          <c:idx val="71"/>
          <c:order val="7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74:$Q$7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7-19F2-46FE-9D71-760AF53C7678}"/>
            </c:ext>
          </c:extLst>
        </c:ser>
        <c:ser>
          <c:idx val="72"/>
          <c:order val="7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75:$Q$7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8-19F2-46FE-9D71-760AF53C7678}"/>
            </c:ext>
          </c:extLst>
        </c:ser>
        <c:ser>
          <c:idx val="73"/>
          <c:order val="7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76:$Q$7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9-19F2-46FE-9D71-760AF53C7678}"/>
            </c:ext>
          </c:extLst>
        </c:ser>
        <c:ser>
          <c:idx val="74"/>
          <c:order val="7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77:$Q$7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A-19F2-46FE-9D71-760AF53C7678}"/>
            </c:ext>
          </c:extLst>
        </c:ser>
        <c:ser>
          <c:idx val="75"/>
          <c:order val="7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78:$Q$7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B-19F2-46FE-9D71-760AF53C7678}"/>
            </c:ext>
          </c:extLst>
        </c:ser>
        <c:ser>
          <c:idx val="76"/>
          <c:order val="7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79:$Q$7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C-19F2-46FE-9D71-760AF53C7678}"/>
            </c:ext>
          </c:extLst>
        </c:ser>
        <c:ser>
          <c:idx val="77"/>
          <c:order val="7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80:$Q$8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D-19F2-46FE-9D71-760AF53C7678}"/>
            </c:ext>
          </c:extLst>
        </c:ser>
        <c:ser>
          <c:idx val="78"/>
          <c:order val="7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81:$Q$8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E-19F2-46FE-9D71-760AF53C7678}"/>
            </c:ext>
          </c:extLst>
        </c:ser>
        <c:ser>
          <c:idx val="79"/>
          <c:order val="7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82:$Q$8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4F-19F2-46FE-9D71-760AF53C7678}"/>
            </c:ext>
          </c:extLst>
        </c:ser>
        <c:ser>
          <c:idx val="80"/>
          <c:order val="8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83:$Q$8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0-19F2-46FE-9D71-760AF53C7678}"/>
            </c:ext>
          </c:extLst>
        </c:ser>
        <c:ser>
          <c:idx val="81"/>
          <c:order val="8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84:$Q$8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1-19F2-46FE-9D71-760AF53C7678}"/>
            </c:ext>
          </c:extLst>
        </c:ser>
        <c:ser>
          <c:idx val="82"/>
          <c:order val="8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85:$Q$85</c:f>
              <c:numCache>
                <c:formatCode>General</c:formatCode>
                <c:ptCount val="13"/>
                <c:pt idx="0" formatCode="0">
                  <c:v>1704.69</c:v>
                </c:pt>
                <c:pt idx="2" formatCode="0">
                  <c:v>1543.13</c:v>
                </c:pt>
                <c:pt idx="3" formatCode="0">
                  <c:v>1448.32</c:v>
                </c:pt>
                <c:pt idx="4" formatCode="0">
                  <c:v>1590.89</c:v>
                </c:pt>
                <c:pt idx="5" formatCode="0">
                  <c:v>1472.02</c:v>
                </c:pt>
                <c:pt idx="6" formatCode="0">
                  <c:v>1549.04</c:v>
                </c:pt>
                <c:pt idx="7" formatCode="0">
                  <c:v>1662.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2-19F2-46FE-9D71-760AF53C7678}"/>
            </c:ext>
          </c:extLst>
        </c:ser>
        <c:ser>
          <c:idx val="83"/>
          <c:order val="8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86:$Q$86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3-19F2-46FE-9D71-760AF53C7678}"/>
            </c:ext>
          </c:extLst>
        </c:ser>
        <c:ser>
          <c:idx val="84"/>
          <c:order val="8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87:$Q$8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4-19F2-46FE-9D71-760AF53C7678}"/>
            </c:ext>
          </c:extLst>
        </c:ser>
        <c:ser>
          <c:idx val="85"/>
          <c:order val="85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88:$Q$88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5-19F2-46FE-9D71-760AF53C7678}"/>
            </c:ext>
          </c:extLst>
        </c:ser>
        <c:ser>
          <c:idx val="86"/>
          <c:order val="86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89:$Q$89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6-19F2-46FE-9D71-760AF53C7678}"/>
            </c:ext>
          </c:extLst>
        </c:ser>
        <c:ser>
          <c:idx val="87"/>
          <c:order val="87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90:$Q$90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7-19F2-46FE-9D71-760AF53C7678}"/>
            </c:ext>
          </c:extLst>
        </c:ser>
        <c:ser>
          <c:idx val="88"/>
          <c:order val="88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91:$Q$91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8-19F2-46FE-9D71-760AF53C7678}"/>
            </c:ext>
          </c:extLst>
        </c:ser>
        <c:ser>
          <c:idx val="89"/>
          <c:order val="89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92:$Q$92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9-19F2-46FE-9D71-760AF53C7678}"/>
            </c:ext>
          </c:extLst>
        </c:ser>
        <c:ser>
          <c:idx val="90"/>
          <c:order val="90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93:$Q$93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A-19F2-46FE-9D71-760AF53C7678}"/>
            </c:ext>
          </c:extLst>
        </c:ser>
        <c:ser>
          <c:idx val="91"/>
          <c:order val="91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94:$Q$94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B-19F2-46FE-9D71-760AF53C7678}"/>
            </c:ext>
          </c:extLst>
        </c:ser>
        <c:ser>
          <c:idx val="92"/>
          <c:order val="92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95:$Q$95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C-19F2-46FE-9D71-760AF53C7678}"/>
            </c:ext>
          </c:extLst>
        </c:ser>
        <c:ser>
          <c:idx val="93"/>
          <c:order val="93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96:$Q$96</c:f>
              <c:numCache>
                <c:formatCode>0</c:formatCode>
                <c:ptCount val="13"/>
                <c:pt idx="0">
                  <c:v>1593.32</c:v>
                </c:pt>
                <c:pt idx="1">
                  <c:v>1464.38</c:v>
                </c:pt>
                <c:pt idx="2">
                  <c:v>1253.4100000000001</c:v>
                </c:pt>
                <c:pt idx="3">
                  <c:v>1519.64</c:v>
                </c:pt>
                <c:pt idx="5">
                  <c:v>1493.08</c:v>
                </c:pt>
                <c:pt idx="6">
                  <c:v>1560.66</c:v>
                </c:pt>
                <c:pt idx="7">
                  <c:v>1474.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D-19F2-46FE-9D71-760AF53C7678}"/>
            </c:ext>
          </c:extLst>
        </c:ser>
        <c:ser>
          <c:idx val="94"/>
          <c:order val="94"/>
          <c:marker>
            <c:symbol val="square"/>
            <c:size val="5"/>
            <c:spPr>
              <a:noFill/>
            </c:spPr>
          </c:marker>
          <c:cat>
            <c:numRef>
              <c:f>'[Microsoft PowerPoint 内のグラフ]肝臓CAPD (実測)'!$S$91:$AE$91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[Microsoft PowerPoint 内のグラフ]肝臓CAPD (実測)'!$E$97:$Q$97</c:f>
              <c:numCache>
                <c:formatCode>General</c:formatCode>
                <c:ptCount val="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5E-19F2-46FE-9D71-760AF53C76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97476400"/>
        <c:axId val="497474832"/>
      </c:lineChart>
      <c:catAx>
        <c:axId val="4974764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 sz="1600" baseline="0"/>
            </a:pPr>
            <a:endParaRPr lang="ja-JP"/>
          </a:p>
        </c:txPr>
        <c:crossAx val="497474832"/>
        <c:crosses val="autoZero"/>
        <c:auto val="1"/>
        <c:lblAlgn val="ctr"/>
        <c:lblOffset val="100"/>
        <c:noMultiLvlLbl val="0"/>
      </c:catAx>
      <c:valAx>
        <c:axId val="49747483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lang="ja-JP" sz="1800" baseline="0"/>
                </a:pPr>
                <a:r>
                  <a:rPr lang="en-US" altLang="ja-JP" sz="1800" baseline="0" dirty="0"/>
                  <a:t>TLV (mL)</a:t>
                </a:r>
                <a:endParaRPr lang="ja-JP" altLang="en-US" sz="1800" baseline="0" dirty="0"/>
              </a:p>
            </c:rich>
          </c:tx>
          <c:layout>
            <c:manualLayout>
              <c:xMode val="edge"/>
              <c:yMode val="edge"/>
              <c:x val="8.9594293055172448E-3"/>
              <c:y val="0.3897245632248462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 sz="1600" baseline="0"/>
            </a:pPr>
            <a:endParaRPr lang="ja-JP"/>
          </a:p>
        </c:txPr>
        <c:crossAx val="497476400"/>
        <c:crosses val="autoZero"/>
        <c:crossBetween val="between"/>
      </c:valAx>
    </c:plotArea>
    <c:plotVisOnly val="1"/>
    <c:dispBlanksAs val="span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6765453530907061E-2"/>
          <c:y val="2.6915204374174065E-2"/>
          <c:w val="0.79024991954745827"/>
          <c:h val="0.85270491103887591"/>
        </c:manualLayout>
      </c:layout>
      <c:lineChart>
        <c:grouping val="standard"/>
        <c:varyColors val="0"/>
        <c:ser>
          <c:idx val="0"/>
          <c:order val="0"/>
          <c:tx>
            <c:v>男性</c:v>
          </c:tx>
          <c:spPr>
            <a:ln>
              <a:solidFill>
                <a:schemeClr val="tx1"/>
              </a:solidFill>
            </a:ln>
          </c:spPr>
          <c:marker>
            <c:symbol val="x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'Tbl1-sub1 肝％ (±6) '!$B$4:$B$16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Tbl1-sub1 肝％ (±6) '!$D$4:$D$16</c:f>
              <c:numCache>
                <c:formatCode>###0.0</c:formatCode>
                <c:ptCount val="13"/>
                <c:pt idx="0">
                  <c:v>96.988374542816175</c:v>
                </c:pt>
                <c:pt idx="1">
                  <c:v>86.426269569655602</c:v>
                </c:pt>
                <c:pt idx="2">
                  <c:v>93.144072944555433</c:v>
                </c:pt>
                <c:pt idx="3">
                  <c:v>93.931123287020469</c:v>
                </c:pt>
                <c:pt idx="4">
                  <c:v>93.849254242019384</c:v>
                </c:pt>
                <c:pt idx="5">
                  <c:v>99.432785773424484</c:v>
                </c:pt>
                <c:pt idx="6">
                  <c:v>99.999999999999829</c:v>
                </c:pt>
                <c:pt idx="7">
                  <c:v>104.99563862628632</c:v>
                </c:pt>
                <c:pt idx="8">
                  <c:v>106.35724171845339</c:v>
                </c:pt>
                <c:pt idx="9">
                  <c:v>106.83916978767991</c:v>
                </c:pt>
                <c:pt idx="10">
                  <c:v>109.1121853056048</c:v>
                </c:pt>
                <c:pt idx="11">
                  <c:v>101.57471413651004</c:v>
                </c:pt>
                <c:pt idx="12">
                  <c:v>106.361193681063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71B-4AC8-83E4-DCC677CAAD3E}"/>
            </c:ext>
          </c:extLst>
        </c:ser>
        <c:ser>
          <c:idx val="1"/>
          <c:order val="1"/>
          <c:tx>
            <c:v>女性</c:v>
          </c:tx>
          <c:val>
            <c:numRef>
              <c:f>'Tbl1-sub1 肝％ (±6) '!$D$24:$D$36</c:f>
              <c:numCache>
                <c:formatCode>###0.0</c:formatCode>
                <c:ptCount val="13"/>
                <c:pt idx="0">
                  <c:v>98.693292598831903</c:v>
                </c:pt>
                <c:pt idx="1">
                  <c:v>86.66599013432517</c:v>
                </c:pt>
                <c:pt idx="2">
                  <c:v>92.328268275231295</c:v>
                </c:pt>
                <c:pt idx="3">
                  <c:v>91.995168838845416</c:v>
                </c:pt>
                <c:pt idx="4">
                  <c:v>92.222605378271382</c:v>
                </c:pt>
                <c:pt idx="5">
                  <c:v>102.29522776929248</c:v>
                </c:pt>
                <c:pt idx="6">
                  <c:v>100.00000000000003</c:v>
                </c:pt>
                <c:pt idx="7">
                  <c:v>100.37854898893326</c:v>
                </c:pt>
                <c:pt idx="8">
                  <c:v>103.32568095387074</c:v>
                </c:pt>
                <c:pt idx="9">
                  <c:v>104.25915848501387</c:v>
                </c:pt>
                <c:pt idx="10">
                  <c:v>104.63764219023194</c:v>
                </c:pt>
                <c:pt idx="11">
                  <c:v>98.098794399237335</c:v>
                </c:pt>
                <c:pt idx="12">
                  <c:v>90.743444131540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71B-4AC8-83E4-DCC677CAAD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97481888"/>
        <c:axId val="497480712"/>
      </c:lineChart>
      <c:catAx>
        <c:axId val="4974818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 sz="1600"/>
            </a:pPr>
            <a:endParaRPr lang="ja-JP"/>
          </a:p>
        </c:txPr>
        <c:crossAx val="497480712"/>
        <c:crosses val="autoZero"/>
        <c:auto val="1"/>
        <c:lblAlgn val="ctr"/>
        <c:lblOffset val="100"/>
        <c:noMultiLvlLbl val="0"/>
      </c:catAx>
      <c:valAx>
        <c:axId val="497480712"/>
        <c:scaling>
          <c:orientation val="minMax"/>
          <c:min val="60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#,##0_ " sourceLinked="0"/>
        <c:majorTickMark val="out"/>
        <c:minorTickMark val="none"/>
        <c:tickLblPos val="nextTo"/>
        <c:txPr>
          <a:bodyPr/>
          <a:lstStyle/>
          <a:p>
            <a:pPr>
              <a:defRPr lang="ja-JP" sz="1600"/>
            </a:pPr>
            <a:endParaRPr lang="ja-JP"/>
          </a:p>
        </c:txPr>
        <c:crossAx val="497481888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 sz="1400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6717422857971354E-2"/>
          <c:y val="3.5369606312341866E-2"/>
          <c:w val="0.7440593489688434"/>
          <c:h val="0.87794509370165386"/>
        </c:manualLayout>
      </c:layout>
      <c:lineChart>
        <c:grouping val="standard"/>
        <c:varyColors val="0"/>
        <c:ser>
          <c:idx val="0"/>
          <c:order val="0"/>
          <c:tx>
            <c:v>HT-TLVクラス1</c:v>
          </c:tx>
          <c:spPr>
            <a:ln>
              <a:solidFill>
                <a:schemeClr val="tx1"/>
              </a:solidFill>
            </a:ln>
          </c:spPr>
          <c:marker>
            <c:symbol val="x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'Tbl1-sub2 肝％ (±6)'!$B$4:$B$16</c:f>
              <c:numCache>
                <c:formatCode>General</c:formatCode>
                <c:ptCount val="13"/>
                <c:pt idx="0">
                  <c:v>-6</c:v>
                </c:pt>
                <c:pt idx="1">
                  <c:v>-5</c:v>
                </c:pt>
                <c:pt idx="2">
                  <c:v>-4</c:v>
                </c:pt>
                <c:pt idx="3">
                  <c:v>-3</c:v>
                </c:pt>
                <c:pt idx="4">
                  <c:v>-2</c:v>
                </c:pt>
                <c:pt idx="5">
                  <c:v>-1</c:v>
                </c:pt>
                <c:pt idx="6">
                  <c:v>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4</c:v>
                </c:pt>
                <c:pt idx="11">
                  <c:v>5</c:v>
                </c:pt>
                <c:pt idx="12">
                  <c:v>6</c:v>
                </c:pt>
              </c:numCache>
            </c:numRef>
          </c:cat>
          <c:val>
            <c:numRef>
              <c:f>'Tbl1-sub2 肝％ (±6)'!$D$4:$D$16</c:f>
              <c:numCache>
                <c:formatCode>###0.0</c:formatCode>
                <c:ptCount val="13"/>
                <c:pt idx="0">
                  <c:v>119.48376526659317</c:v>
                </c:pt>
                <c:pt idx="1">
                  <c:v>100.68604851563536</c:v>
                </c:pt>
                <c:pt idx="2">
                  <c:v>105.12869994528891</c:v>
                </c:pt>
                <c:pt idx="3">
                  <c:v>100.19962536067131</c:v>
                </c:pt>
                <c:pt idx="4">
                  <c:v>107.30139657580798</c:v>
                </c:pt>
                <c:pt idx="5">
                  <c:v>107.2880745344648</c:v>
                </c:pt>
                <c:pt idx="6">
                  <c:v>100</c:v>
                </c:pt>
                <c:pt idx="7">
                  <c:v>110.27182586605474</c:v>
                </c:pt>
                <c:pt idx="8">
                  <c:v>111.48269494103786</c:v>
                </c:pt>
                <c:pt idx="9">
                  <c:v>105.12795242787907</c:v>
                </c:pt>
                <c:pt idx="10">
                  <c:v>121.4800148216338</c:v>
                </c:pt>
                <c:pt idx="11">
                  <c:v>117.10725694611753</c:v>
                </c:pt>
                <c:pt idx="12">
                  <c:v>106.920645196716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061-43A3-AC49-F1A297D25F16}"/>
            </c:ext>
          </c:extLst>
        </c:ser>
        <c:ser>
          <c:idx val="1"/>
          <c:order val="1"/>
          <c:tx>
            <c:v>HT-TLVクラス2</c:v>
          </c:tx>
          <c:val>
            <c:numRef>
              <c:f>'Tbl1-sub2 肝％ (±6)'!$D$24:$D$36</c:f>
              <c:numCache>
                <c:formatCode>###0.0</c:formatCode>
                <c:ptCount val="13"/>
                <c:pt idx="0">
                  <c:v>86.387213560857859</c:v>
                </c:pt>
                <c:pt idx="1">
                  <c:v>102.91199653106987</c:v>
                </c:pt>
                <c:pt idx="2">
                  <c:v>85.758657667344451</c:v>
                </c:pt>
                <c:pt idx="3">
                  <c:v>90.980775890821093</c:v>
                </c:pt>
                <c:pt idx="4">
                  <c:v>92.940156503966591</c:v>
                </c:pt>
                <c:pt idx="5">
                  <c:v>101.46989371019065</c:v>
                </c:pt>
                <c:pt idx="6">
                  <c:v>100</c:v>
                </c:pt>
                <c:pt idx="7">
                  <c:v>103.09823383469129</c:v>
                </c:pt>
                <c:pt idx="8">
                  <c:v>100.24928830080417</c:v>
                </c:pt>
                <c:pt idx="9">
                  <c:v>102.80208935247568</c:v>
                </c:pt>
                <c:pt idx="10">
                  <c:v>95.69662474301667</c:v>
                </c:pt>
                <c:pt idx="11">
                  <c:v>92.823560136870199</c:v>
                </c:pt>
                <c:pt idx="12">
                  <c:v>96.0571700182881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061-43A3-AC49-F1A297D25F16}"/>
            </c:ext>
          </c:extLst>
        </c:ser>
        <c:ser>
          <c:idx val="2"/>
          <c:order val="2"/>
          <c:tx>
            <c:v>HT-TLVクラス3</c:v>
          </c:tx>
          <c:marker>
            <c:symbol val="square"/>
            <c:size val="7"/>
          </c:marker>
          <c:val>
            <c:numRef>
              <c:f>'Tbl1-sub2 肝％ (±6)'!$D$44:$D$56</c:f>
              <c:numCache>
                <c:formatCode>###0.0</c:formatCode>
                <c:ptCount val="13"/>
                <c:pt idx="0">
                  <c:v>69.75208056300707</c:v>
                </c:pt>
                <c:pt idx="1">
                  <c:v>82.466810679018138</c:v>
                </c:pt>
                <c:pt idx="2">
                  <c:v>89.724115222349951</c:v>
                </c:pt>
                <c:pt idx="3">
                  <c:v>92.709298487715216</c:v>
                </c:pt>
                <c:pt idx="4">
                  <c:v>88.400512358603251</c:v>
                </c:pt>
                <c:pt idx="5">
                  <c:v>97.835118475488542</c:v>
                </c:pt>
                <c:pt idx="6">
                  <c:v>100</c:v>
                </c:pt>
                <c:pt idx="7">
                  <c:v>102.09264684558926</c:v>
                </c:pt>
                <c:pt idx="8">
                  <c:v>113.59916170934824</c:v>
                </c:pt>
                <c:pt idx="9">
                  <c:v>111.50744278339245</c:v>
                </c:pt>
                <c:pt idx="10">
                  <c:v>110.56358154468165</c:v>
                </c:pt>
                <c:pt idx="11">
                  <c:v>70.010941110925828</c:v>
                </c:pt>
                <c:pt idx="12">
                  <c:v>88.0691401654219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061-43A3-AC49-F1A297D25F16}"/>
            </c:ext>
          </c:extLst>
        </c:ser>
        <c:ser>
          <c:idx val="3"/>
          <c:order val="3"/>
          <c:tx>
            <c:v>HT-TLVクラス4</c:v>
          </c:tx>
          <c:marker>
            <c:symbol val="square"/>
            <c:size val="7"/>
          </c:marker>
          <c:val>
            <c:numRef>
              <c:f>'Tbl1-sub2 肝％ (±6)'!$D$64:$D$76</c:f>
              <c:numCache>
                <c:formatCode>###0.0</c:formatCode>
                <c:ptCount val="13"/>
                <c:pt idx="1">
                  <c:v>77.880051343949333</c:v>
                </c:pt>
                <c:pt idx="2">
                  <c:v>90.872700876782091</c:v>
                </c:pt>
                <c:pt idx="3">
                  <c:v>86.56328521315416</c:v>
                </c:pt>
                <c:pt idx="4">
                  <c:v>86.971107399950085</c:v>
                </c:pt>
                <c:pt idx="5">
                  <c:v>95.736979232966604</c:v>
                </c:pt>
                <c:pt idx="6">
                  <c:v>100.00000000000009</c:v>
                </c:pt>
                <c:pt idx="7">
                  <c:v>95.409695451753578</c:v>
                </c:pt>
                <c:pt idx="8">
                  <c:v>93.147255129440296</c:v>
                </c:pt>
                <c:pt idx="9">
                  <c:v>105.63842585530554</c:v>
                </c:pt>
                <c:pt idx="10">
                  <c:v>94.518563137002275</c:v>
                </c:pt>
                <c:pt idx="11">
                  <c:v>97.6317167025546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061-43A3-AC49-F1A297D25F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97475616"/>
        <c:axId val="497476008"/>
      </c:lineChart>
      <c:catAx>
        <c:axId val="4974756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 sz="1600"/>
            </a:pPr>
            <a:endParaRPr lang="ja-JP"/>
          </a:p>
        </c:txPr>
        <c:crossAx val="497476008"/>
        <c:crosses val="autoZero"/>
        <c:auto val="1"/>
        <c:lblAlgn val="ctr"/>
        <c:lblOffset val="100"/>
        <c:noMultiLvlLbl val="0"/>
      </c:catAx>
      <c:valAx>
        <c:axId val="497476008"/>
        <c:scaling>
          <c:orientation val="minMax"/>
          <c:min val="60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#,##0_ " sourceLinked="0"/>
        <c:majorTickMark val="out"/>
        <c:minorTickMark val="none"/>
        <c:tickLblPos val="nextTo"/>
        <c:txPr>
          <a:bodyPr/>
          <a:lstStyle/>
          <a:p>
            <a:pPr>
              <a:defRPr lang="ja-JP" sz="1600"/>
            </a:pPr>
            <a:endParaRPr lang="ja-JP"/>
          </a:p>
        </c:txPr>
        <c:crossAx val="497475616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 sz="1400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8662</cdr:x>
      <cdr:y>0.47542</cdr:y>
    </cdr:from>
    <cdr:to>
      <cdr:x>1</cdr:x>
      <cdr:y>0.64196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84F2200D-D88F-2D8A-FE6E-F78B63C492E8}"/>
            </a:ext>
          </a:extLst>
        </cdr:cNvPr>
        <cdr:cNvSpPr txBox="1"/>
      </cdr:nvSpPr>
      <cdr:spPr>
        <a:xfrm xmlns:a="http://schemas.openxmlformats.org/drawingml/2006/main">
          <a:off x="7632848" y="261040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 dirty="0"/>
        </a:p>
      </cdr:txBody>
    </cdr:sp>
  </cdr:relSizeAnchor>
  <cdr:relSizeAnchor xmlns:cdr="http://schemas.openxmlformats.org/drawingml/2006/chartDrawing">
    <cdr:from>
      <cdr:x>0.88662</cdr:x>
      <cdr:y>0.35739</cdr:y>
    </cdr:from>
    <cdr:to>
      <cdr:x>1</cdr:x>
      <cdr:y>0.52393</cdr:y>
    </cdr:to>
    <cdr:sp macro="" textlink="">
      <cdr:nvSpPr>
        <cdr:cNvPr id="3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EC94A69E-D700-14AA-4AB6-7F749B58EF7B}"/>
            </a:ext>
          </a:extLst>
        </cdr:cNvPr>
        <cdr:cNvSpPr txBox="1"/>
      </cdr:nvSpPr>
      <cdr:spPr>
        <a:xfrm xmlns:a="http://schemas.openxmlformats.org/drawingml/2006/main">
          <a:off x="7632848" y="1962328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A06BF3-F4AC-412C-A2D3-844C1E831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0C001B-60EA-46BF-985E-D41B12969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2125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0C001B-60EA-46BF-985E-D41B12969413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56794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6" name="スライド イメージ プレースホルダー 1">
            <a:extLst>
              <a:ext uri="{FF2B5EF4-FFF2-40B4-BE49-F238E27FC236}">
                <a16:creationId xmlns:a16="http://schemas.microsoft.com/office/drawing/2014/main" id="{D838B4EA-7F35-E349-F6B5-D9960AED16A3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6867" name="ノート プレースホルダー 2">
            <a:extLst>
              <a:ext uri="{FF2B5EF4-FFF2-40B4-BE49-F238E27FC236}">
                <a16:creationId xmlns:a16="http://schemas.microsoft.com/office/drawing/2014/main" id="{E86801B2-FF8F-3F12-374A-0E4B60A0A7D1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6868" name="スライド番号プレースホルダー 3">
            <a:extLst>
              <a:ext uri="{FF2B5EF4-FFF2-40B4-BE49-F238E27FC236}">
                <a16:creationId xmlns:a16="http://schemas.microsoft.com/office/drawing/2014/main" id="{082A4FD0-AA43-FFD0-DAB2-9B6CB789F950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F29B4B2C-647B-436D-B279-C655B4EB5E04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12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453345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BAA169A-C8BD-88C6-E84C-1D64CDE06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18ACAF-336B-456A-982B-01CB748106F5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A8CAC03-D5B3-C639-5A5A-138D937DBB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5C88339-D5AC-2DF8-2859-D090AB3B2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DCE224-1509-4E99-8C2D-B39B9EF3919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79824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903278-09F3-BD09-A436-18DF8F49C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A87EEA-E294-4EE2-AAEE-31DA198F9848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A61FD7-4606-18F2-CCC2-0E30EE561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C5E247-0C3C-5B65-B992-4E9A1045B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F1EB38-3DC8-496E-8616-0D3E3EA23A9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89382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4216963-FD18-3AB9-69D0-5CA8B3C3A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4D5326-0601-4AD3-8CDD-E9D76BE33184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7501DB-1CA5-39CF-4D7B-AD1D117E4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202454A-E8AB-5601-22B5-80C4F415C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82520E-7668-46FC-B262-88C784BEBC6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3320349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A4D32A9-6DDB-934A-AC4D-7DC106C64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2CD29C-30EC-44D6-B22A-5FC92CF86AF5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D205271-8E5E-BD61-129F-514E377C96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096F00A-1687-60CF-18D9-D76CED546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FB5725-8759-45C6-BA2F-42117E78D21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4001830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929D6F9-27E5-9C8A-48A3-AD8E00207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12F26D-7ED4-471A-86C1-9E5448E5E80B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1081017-9889-AB51-D972-E16EEF0D0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4E7E65-2B15-A17D-F284-0C894ACF1E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6FE7D4-CB52-4605-BFA7-1FC29B57532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6611038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6CAB463-8D0C-2796-1618-CCBC88B1BA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DB3AF2-7534-42B5-8501-7AA5E999C14F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7B0AAF3-F47D-2CC8-9D34-45818969E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63C575-D722-42C6-DF51-7E4FE7F8D0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7B8E3B-0674-4C89-B802-59710C03D1D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128439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B5479CC2-F350-3465-AFCE-6473DDD6C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53D7C7-F260-494F-91DD-C8DC76E782A4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77F23207-AD90-E1F0-EA33-A7AC372A43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28AC0E60-54C6-50FB-1635-33698501E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6AF554-D252-4F16-AC79-E7A7AD97085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9554394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>
            <a:extLst>
              <a:ext uri="{FF2B5EF4-FFF2-40B4-BE49-F238E27FC236}">
                <a16:creationId xmlns:a16="http://schemas.microsoft.com/office/drawing/2014/main" id="{0D789F85-3565-411C-E1B6-3EB0664E9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CAE174-BA7D-4148-A1F2-2D34143F6951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8" name="フッター プレースホルダー 4">
            <a:extLst>
              <a:ext uri="{FF2B5EF4-FFF2-40B4-BE49-F238E27FC236}">
                <a16:creationId xmlns:a16="http://schemas.microsoft.com/office/drawing/2014/main" id="{8A7E7848-B9EA-28DC-7516-AF368AC87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>
            <a:extLst>
              <a:ext uri="{FF2B5EF4-FFF2-40B4-BE49-F238E27FC236}">
                <a16:creationId xmlns:a16="http://schemas.microsoft.com/office/drawing/2014/main" id="{876755A4-AB09-8163-5B9D-97C5664DB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711862-439B-4997-A4E7-1F2CB70CAD5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1297958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>
            <a:extLst>
              <a:ext uri="{FF2B5EF4-FFF2-40B4-BE49-F238E27FC236}">
                <a16:creationId xmlns:a16="http://schemas.microsoft.com/office/drawing/2014/main" id="{977EA7AA-E531-E56E-311F-6EBBF89E0F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8C3B2A-B406-448E-B4FE-B8D205FF0FB6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4" name="フッター プレースホルダー 4">
            <a:extLst>
              <a:ext uri="{FF2B5EF4-FFF2-40B4-BE49-F238E27FC236}">
                <a16:creationId xmlns:a16="http://schemas.microsoft.com/office/drawing/2014/main" id="{43F6ECF9-9CA4-8FD2-19D6-CD0790D6F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>
            <a:extLst>
              <a:ext uri="{FF2B5EF4-FFF2-40B4-BE49-F238E27FC236}">
                <a16:creationId xmlns:a16="http://schemas.microsoft.com/office/drawing/2014/main" id="{4167853A-5E2F-63DF-AA6E-6F9185674D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0F831D-609F-4A3F-9BFF-437F17415C2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2544245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>
            <a:extLst>
              <a:ext uri="{FF2B5EF4-FFF2-40B4-BE49-F238E27FC236}">
                <a16:creationId xmlns:a16="http://schemas.microsoft.com/office/drawing/2014/main" id="{EB5F6B38-FC98-264B-711D-85C1898E9F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F4C6F7-1186-4C14-8BCC-BE41B63D0569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3" name="フッター プレースホルダー 4">
            <a:extLst>
              <a:ext uri="{FF2B5EF4-FFF2-40B4-BE49-F238E27FC236}">
                <a16:creationId xmlns:a16="http://schemas.microsoft.com/office/drawing/2014/main" id="{738605CC-27E8-C162-AD02-90AF565DE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>
            <a:extLst>
              <a:ext uri="{FF2B5EF4-FFF2-40B4-BE49-F238E27FC236}">
                <a16:creationId xmlns:a16="http://schemas.microsoft.com/office/drawing/2014/main" id="{6C5C7370-2978-010C-0CC1-46E37F09E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D9CCD3-8A45-41ED-99E2-6A4DBA1A59F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695828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9989A785-10E2-E225-273F-E7FC4724E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0E3FEE-8D8A-4F2F-B8D7-D95A5AC21027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AAED5BE8-6627-96B0-00B4-8A7DDE5E93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0EC7AF07-EDDE-4E81-8270-709BA97BDC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7BB78E-F790-4689-B251-165AD416356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88987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8CFE349-E830-01ED-7ED0-2335E16D6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412BBD-A833-46A6-ADEB-BF7D35BE83E6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7ECC4F7-E881-7E6E-D21C-0FF36E220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3D463C-9F2B-FDAC-E0EC-CB75E32A5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5B07BA-BAD5-48D1-B275-508422349AE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9706685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60768182-E8D9-B26C-E655-36791C5A4B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C12E59-A392-4A15-BD24-2963EA3C94E8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2379A3EB-A37D-2CEA-6904-117E72B3A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12B64FAC-3836-BD00-E36E-0B7BD47A1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E82951-D7C9-4BC4-8BD8-227478CD348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5255565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E1BFE5-668D-2F71-F95B-7F18F62B4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62FF0D-1142-43CD-8E29-1A8A712057C4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E43B842-A27D-1AE6-3643-AAD57345E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8AE683B-2352-3F9C-F443-5B38B19C0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3B3B9A-63E5-4F43-A709-C274A4DCE50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3063389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99A7A4B-86D8-780A-D98F-B1161A38C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D0BAEF-F299-461F-949E-EC0319929CFE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5E85E2F-14C8-2AB7-295F-7BEBC718B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547C912-DD5B-A9BC-8B8C-3BF316D7DF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FE6FF6-1D81-4148-9126-69FE2135E09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949997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C11E08C-6F13-9982-158E-BAB96165B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8BC047-D0C5-4B6F-AFF0-AD6226D991A6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1C29FB0-BF6B-4244-FD7F-17A43EFFA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2FB9A77-3ACA-410E-8DD4-8C60764C1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E47E1D-453C-4F05-BCCB-072AF0F2D41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85657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E0DC614E-5A46-668F-BED6-FBDA9DA9DF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1AA90B-2766-4BC9-9744-71F5A0991954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CCE6DD30-8899-0079-E362-69F25D0C96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88E4B0C5-FC07-DFBD-0137-990AA0F906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840FB4-EB99-4424-B3AB-6990BDD4BE8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43913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>
            <a:extLst>
              <a:ext uri="{FF2B5EF4-FFF2-40B4-BE49-F238E27FC236}">
                <a16:creationId xmlns:a16="http://schemas.microsoft.com/office/drawing/2014/main" id="{364317B6-1A6F-5C92-1BA0-2015F640F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042320-4A6E-4CC2-8B40-11D7E5EF0C69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8" name="フッター プレースホルダー 4">
            <a:extLst>
              <a:ext uri="{FF2B5EF4-FFF2-40B4-BE49-F238E27FC236}">
                <a16:creationId xmlns:a16="http://schemas.microsoft.com/office/drawing/2014/main" id="{BE40906A-9A76-2881-6EB9-85314E3549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>
            <a:extLst>
              <a:ext uri="{FF2B5EF4-FFF2-40B4-BE49-F238E27FC236}">
                <a16:creationId xmlns:a16="http://schemas.microsoft.com/office/drawing/2014/main" id="{D846D45F-648B-AF6A-D4AE-D3A0FA6E19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BF061E-337F-41DE-84B0-6BEE0A8E25E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45293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>
            <a:extLst>
              <a:ext uri="{FF2B5EF4-FFF2-40B4-BE49-F238E27FC236}">
                <a16:creationId xmlns:a16="http://schemas.microsoft.com/office/drawing/2014/main" id="{D5224300-EE00-8231-AE29-8CB10B223D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DCEC3B-C4B5-4AD3-B131-A26348868713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4" name="フッター プレースホルダー 4">
            <a:extLst>
              <a:ext uri="{FF2B5EF4-FFF2-40B4-BE49-F238E27FC236}">
                <a16:creationId xmlns:a16="http://schemas.microsoft.com/office/drawing/2014/main" id="{93DCA55E-99E2-921D-04C7-AE32CD8A0D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>
            <a:extLst>
              <a:ext uri="{FF2B5EF4-FFF2-40B4-BE49-F238E27FC236}">
                <a16:creationId xmlns:a16="http://schemas.microsoft.com/office/drawing/2014/main" id="{BD90BFB2-8FA2-9D7E-EDB4-7663A552CD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FAAB3-0674-4AA8-A331-45963934816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19761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>
            <a:extLst>
              <a:ext uri="{FF2B5EF4-FFF2-40B4-BE49-F238E27FC236}">
                <a16:creationId xmlns:a16="http://schemas.microsoft.com/office/drawing/2014/main" id="{CC56ABAA-23D5-3B71-9D07-2C61357CE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554BB9-B0E8-4ACE-883C-2DB8BE0AED60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3" name="フッター プレースホルダー 4">
            <a:extLst>
              <a:ext uri="{FF2B5EF4-FFF2-40B4-BE49-F238E27FC236}">
                <a16:creationId xmlns:a16="http://schemas.microsoft.com/office/drawing/2014/main" id="{27C8E5F3-51B3-633C-5DF6-75F197E38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>
            <a:extLst>
              <a:ext uri="{FF2B5EF4-FFF2-40B4-BE49-F238E27FC236}">
                <a16:creationId xmlns:a16="http://schemas.microsoft.com/office/drawing/2014/main" id="{1DE06545-C613-AA9E-4CAC-89F0D55FAB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B16363-18AB-4BB4-8C23-8B0096423E3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92673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B2EF8FC5-08F0-4AF7-B9A5-74F862662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54EC11-7639-4728-BAF4-D9A164747EC4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0D92AB65-B836-D929-9B59-0C1BBBBC4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830B85EA-541A-B84A-7D37-DF9F8A5C65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813B2A-77CB-4711-81E1-FD283D00206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95287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B0DF1D3D-0291-9025-CE04-BF053EA05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D61B62-9150-43EB-B1FB-1128E0A51647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B311D8C8-B818-3557-4BC1-B06627B6D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ACDD8358-1F23-4301-C613-278FDD0033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6C4F7C-25F8-4D42-9E76-092F32E5321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8953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>
            <a:extLst>
              <a:ext uri="{FF2B5EF4-FFF2-40B4-BE49-F238E27FC236}">
                <a16:creationId xmlns:a16="http://schemas.microsoft.com/office/drawing/2014/main" id="{ECF83E39-32E9-8897-1CA0-2AC6519AE665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>
            <a:extLst>
              <a:ext uri="{FF2B5EF4-FFF2-40B4-BE49-F238E27FC236}">
                <a16:creationId xmlns:a16="http://schemas.microsoft.com/office/drawing/2014/main" id="{3A2DBD02-8038-5493-96B4-C05A17773AAF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3A4546E-AD64-F143-6EE5-0CF8EB0C1E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ea typeface="ＭＳ Ｐゴシック" pitchFamily="50" charset="-128"/>
              </a:defRPr>
            </a:lvl1pPr>
          </a:lstStyle>
          <a:p>
            <a:pPr>
              <a:defRPr/>
            </a:pPr>
            <a:fld id="{553B0017-2696-4488-98EA-0637C221878D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AAF1E3-061D-03B4-181C-7EEDABA64B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0E442DD-377C-802F-EA96-A2BCCE1E9A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ea typeface="ＭＳ Ｐゴシック" panose="020B0600070205080204" pitchFamily="50" charset="-128"/>
              </a:defRPr>
            </a:lvl1pPr>
          </a:lstStyle>
          <a:p>
            <a:pPr>
              <a:defRPr/>
            </a:pPr>
            <a:fld id="{6E5B7995-49ED-4498-95BB-57959EAE024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8551442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>
            <a:extLst>
              <a:ext uri="{FF2B5EF4-FFF2-40B4-BE49-F238E27FC236}">
                <a16:creationId xmlns:a16="http://schemas.microsoft.com/office/drawing/2014/main" id="{CE904F58-99DD-E1AD-9F50-5EE30FD7BBC6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>
            <a:extLst>
              <a:ext uri="{FF2B5EF4-FFF2-40B4-BE49-F238E27FC236}">
                <a16:creationId xmlns:a16="http://schemas.microsoft.com/office/drawing/2014/main" id="{26B940D4-DEA9-C16F-EB68-2F23F8C21186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35A7A1-32AE-ADF0-F026-0280EEAB05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ea typeface="ＭＳ Ｐゴシック" pitchFamily="50" charset="-128"/>
              </a:defRPr>
            </a:lvl1pPr>
          </a:lstStyle>
          <a:p>
            <a:pPr>
              <a:defRPr/>
            </a:pPr>
            <a:fld id="{6D1CB626-9C31-4906-B0F6-18C28DDA341A}" type="datetimeFigureOut">
              <a:rPr lang="ja-JP" altLang="en-US"/>
              <a:pPr>
                <a:defRPr/>
              </a:pPr>
              <a:t>2023/1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748EAFF-E076-A937-CE6D-0C8EB9448E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7AC8020-F403-607B-1F85-0E9E950554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ea typeface="ＭＳ Ｐゴシック" panose="020B0600070205080204" pitchFamily="50" charset="-128"/>
              </a:defRPr>
            </a:lvl1pPr>
          </a:lstStyle>
          <a:p>
            <a:pPr>
              <a:defRPr/>
            </a:pPr>
            <a:fld id="{80F34614-9F93-43F5-ABCD-8E7DAA27796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80811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13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4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EC4332A-0B5B-D1C0-FD57-66F2C525B0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260648"/>
            <a:ext cx="8229600" cy="778098"/>
          </a:xfrm>
        </p:spPr>
        <p:txBody>
          <a:bodyPr/>
          <a:lstStyle/>
          <a:p>
            <a:r>
              <a:rPr lang="en-US" altLang="ja-JP" sz="2800" dirty="0"/>
              <a:t>Distribution of </a:t>
            </a:r>
            <a:r>
              <a:rPr lang="en-US" altLang="ja-JP" sz="2800" dirty="0" err="1"/>
              <a:t>HtTKV</a:t>
            </a:r>
            <a:r>
              <a:rPr lang="en-US" altLang="ja-JP" sz="2800" dirty="0"/>
              <a:t> and age at dialysis initiation</a:t>
            </a:r>
            <a:endParaRPr kumimoji="1" lang="ja-JP" altLang="en-US" sz="2800" dirty="0"/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13556F11-A736-FE39-BFD7-8CEFC7389FC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696" b="7320"/>
          <a:stretch/>
        </p:blipFill>
        <p:spPr>
          <a:xfrm>
            <a:off x="827584" y="879280"/>
            <a:ext cx="6768752" cy="5574056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8AB6BA9-3F2E-71EB-C380-52CDA1183E28}"/>
              </a:ext>
            </a:extLst>
          </p:cNvPr>
          <p:cNvSpPr txBox="1"/>
          <p:nvPr/>
        </p:nvSpPr>
        <p:spPr>
          <a:xfrm>
            <a:off x="3544362" y="6381328"/>
            <a:ext cx="15724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Age (years)</a:t>
            </a:r>
            <a:endParaRPr kumimoji="1" lang="ja-JP" altLang="en-US" sz="24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4383741-895A-8CD7-69AE-9A70BC91EA74}"/>
              </a:ext>
            </a:extLst>
          </p:cNvPr>
          <p:cNvSpPr txBox="1"/>
          <p:nvPr/>
        </p:nvSpPr>
        <p:spPr>
          <a:xfrm rot="-5400000">
            <a:off x="-497243" y="3166064"/>
            <a:ext cx="19591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err="1"/>
              <a:t>HtTKV</a:t>
            </a:r>
            <a:r>
              <a:rPr kumimoji="1" lang="en-US" altLang="ja-JP" sz="2400" dirty="0"/>
              <a:t> (mL/m)</a:t>
            </a:r>
            <a:endParaRPr kumimoji="1" lang="ja-JP" altLang="en-US" sz="24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F940573-BD04-9857-5839-92C73D78DF58}"/>
              </a:ext>
            </a:extLst>
          </p:cNvPr>
          <p:cNvSpPr txBox="1"/>
          <p:nvPr/>
        </p:nvSpPr>
        <p:spPr>
          <a:xfrm>
            <a:off x="7518705" y="1340768"/>
            <a:ext cx="133940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0070C0"/>
                </a:solidFill>
              </a:rPr>
              <a:t>Blue: Male</a:t>
            </a:r>
          </a:p>
          <a:p>
            <a:r>
              <a:rPr lang="en-US" altLang="ja-JP" dirty="0">
                <a:solidFill>
                  <a:srgbClr val="FF0000"/>
                </a:solidFill>
              </a:rPr>
              <a:t>Red: Female</a:t>
            </a:r>
            <a:endParaRPr kumimoji="1" lang="ja-JP" altLang="en-US" dirty="0">
              <a:solidFill>
                <a:srgbClr val="FF0000"/>
              </a:solidFill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E613CA1-D7FF-3E95-525D-297F0C3887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825" y="-27384"/>
            <a:ext cx="5067300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800" dirty="0"/>
              <a:t>(Supplemental Figure 1A)</a:t>
            </a:r>
            <a:r>
              <a:rPr lang="ja-JP" altLang="en-US" sz="2800" dirty="0"/>
              <a:t>　</a:t>
            </a:r>
          </a:p>
        </p:txBody>
      </p:sp>
    </p:spTree>
    <p:extLst>
      <p:ext uri="{BB962C8B-B14F-4D97-AF65-F5344CB8AC3E}">
        <p14:creationId xmlns:p14="http://schemas.microsoft.com/office/powerpoint/2010/main" val="346678961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98CA97A-71AA-51B8-2CA8-71D3FA8582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825" y="25228"/>
            <a:ext cx="5067300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800" dirty="0"/>
              <a:t>(Supplemental Figure 3D)</a:t>
            </a:r>
            <a:r>
              <a:rPr lang="ja-JP" altLang="en-US" sz="2800" dirty="0"/>
              <a:t>　</a:t>
            </a:r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7266566"/>
              </p:ext>
            </p:extLst>
          </p:nvPr>
        </p:nvGraphicFramePr>
        <p:xfrm>
          <a:off x="762765" y="1412776"/>
          <a:ext cx="8159333" cy="4787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99C6ACC-23A1-0B53-E5BC-3F25554CEC9A}"/>
              </a:ext>
            </a:extLst>
          </p:cNvPr>
          <p:cNvSpPr txBox="1"/>
          <p:nvPr/>
        </p:nvSpPr>
        <p:spPr>
          <a:xfrm>
            <a:off x="7326616" y="1905770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/>
              <a:t>P</a:t>
            </a:r>
            <a:r>
              <a:rPr kumimoji="1" lang="en-US" altLang="ja-JP" dirty="0"/>
              <a:t>=.01</a:t>
            </a:r>
            <a:endParaRPr kumimoji="1" lang="ja-JP" altLang="en-US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F6135D2-D1A3-1363-C067-F40E68F3B119}"/>
              </a:ext>
            </a:extLst>
          </p:cNvPr>
          <p:cNvSpPr txBox="1"/>
          <p:nvPr/>
        </p:nvSpPr>
        <p:spPr>
          <a:xfrm rot="-5400000">
            <a:off x="-418241" y="3166064"/>
            <a:ext cx="17419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TLV ratio (%)</a:t>
            </a:r>
            <a:endParaRPr kumimoji="1" lang="ja-JP" altLang="en-US" sz="2400" dirty="0"/>
          </a:p>
        </p:txBody>
      </p:sp>
      <p:sp>
        <p:nvSpPr>
          <p:cNvPr id="6" name="テキスト ボックス 27">
            <a:extLst>
              <a:ext uri="{FF2B5EF4-FFF2-40B4-BE49-F238E27FC236}">
                <a16:creationId xmlns:a16="http://schemas.microsoft.com/office/drawing/2014/main" id="{D6EECD11-F2DE-77D8-1A48-BA87D158F7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76257" y="6040142"/>
            <a:ext cx="203269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Time point (years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7" name="テキスト ボックス 1">
            <a:extLst>
              <a:ext uri="{FF2B5EF4-FFF2-40B4-BE49-F238E27FC236}">
                <a16:creationId xmlns:a16="http://schemas.microsoft.com/office/drawing/2014/main" id="{32C23D88-A95F-D231-EB4F-A3A19BD9C8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8766" y="6423421"/>
            <a:ext cx="913617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Dialysis initiation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BBE40B8B-78CC-3343-2F74-1DC7FFCF23C6}"/>
              </a:ext>
            </a:extLst>
          </p:cNvPr>
          <p:cNvCxnSpPr/>
          <p:nvPr/>
        </p:nvCxnSpPr>
        <p:spPr>
          <a:xfrm flipV="1">
            <a:off x="4426250" y="6149084"/>
            <a:ext cx="0" cy="287338"/>
          </a:xfrm>
          <a:prstGeom prst="straightConnector1">
            <a:avLst/>
          </a:prstGeom>
          <a:ln w="508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1">
            <a:extLst>
              <a:ext uri="{FF2B5EF4-FFF2-40B4-BE49-F238E27FC236}">
                <a16:creationId xmlns:a16="http://schemas.microsoft.com/office/drawing/2014/main" id="{A3B94B04-98A3-BF9F-BE02-6E0049D6653B}"/>
              </a:ext>
            </a:extLst>
          </p:cNvPr>
          <p:cNvSpPr txBox="1"/>
          <p:nvPr/>
        </p:nvSpPr>
        <p:spPr>
          <a:xfrm>
            <a:off x="7748851" y="3218995"/>
            <a:ext cx="1413076" cy="259750"/>
          </a:xfrm>
          <a:prstGeom prst="rect">
            <a:avLst/>
          </a:prstGeom>
          <a:solidFill>
            <a:schemeClr val="bg1"/>
          </a:solidFill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 err="1"/>
              <a:t>HtTLV</a:t>
            </a:r>
            <a:r>
              <a:rPr lang="en-US" altLang="ja-JP" sz="1400" dirty="0"/>
              <a:t> Quartile 1</a:t>
            </a:r>
            <a:endParaRPr lang="ja-JP" altLang="en-US" sz="1400" dirty="0"/>
          </a:p>
        </p:txBody>
      </p:sp>
      <p:sp>
        <p:nvSpPr>
          <p:cNvPr id="10" name="テキスト ボックス 1">
            <a:extLst>
              <a:ext uri="{FF2B5EF4-FFF2-40B4-BE49-F238E27FC236}">
                <a16:creationId xmlns:a16="http://schemas.microsoft.com/office/drawing/2014/main" id="{1CCE816B-33BC-11C8-1928-8384C49D7EFA}"/>
              </a:ext>
            </a:extLst>
          </p:cNvPr>
          <p:cNvSpPr txBox="1"/>
          <p:nvPr/>
        </p:nvSpPr>
        <p:spPr>
          <a:xfrm>
            <a:off x="7759846" y="3507028"/>
            <a:ext cx="1413076" cy="259750"/>
          </a:xfrm>
          <a:prstGeom prst="rect">
            <a:avLst/>
          </a:prstGeom>
          <a:solidFill>
            <a:schemeClr val="bg1"/>
          </a:solidFill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 err="1"/>
              <a:t>HtTLV</a:t>
            </a:r>
            <a:r>
              <a:rPr lang="en-US" altLang="ja-JP" sz="1400" dirty="0"/>
              <a:t> Quartile 2</a:t>
            </a:r>
            <a:endParaRPr lang="ja-JP" altLang="en-US" sz="1400" dirty="0"/>
          </a:p>
        </p:txBody>
      </p:sp>
      <p:sp>
        <p:nvSpPr>
          <p:cNvPr id="11" name="テキスト ボックス 1">
            <a:extLst>
              <a:ext uri="{FF2B5EF4-FFF2-40B4-BE49-F238E27FC236}">
                <a16:creationId xmlns:a16="http://schemas.microsoft.com/office/drawing/2014/main" id="{D695B838-8D77-1B77-5631-7532F1300DC9}"/>
              </a:ext>
            </a:extLst>
          </p:cNvPr>
          <p:cNvSpPr txBox="1"/>
          <p:nvPr/>
        </p:nvSpPr>
        <p:spPr>
          <a:xfrm>
            <a:off x="7761417" y="3804487"/>
            <a:ext cx="1413076" cy="259750"/>
          </a:xfrm>
          <a:prstGeom prst="rect">
            <a:avLst/>
          </a:prstGeom>
          <a:solidFill>
            <a:schemeClr val="bg1"/>
          </a:solidFill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 err="1"/>
              <a:t>HtTLV</a:t>
            </a:r>
            <a:r>
              <a:rPr lang="en-US" altLang="ja-JP" sz="1400" dirty="0"/>
              <a:t> Quartile 3</a:t>
            </a:r>
            <a:endParaRPr lang="ja-JP" altLang="en-US" sz="1400" dirty="0"/>
          </a:p>
        </p:txBody>
      </p:sp>
      <p:sp>
        <p:nvSpPr>
          <p:cNvPr id="12" name="テキスト ボックス 1">
            <a:extLst>
              <a:ext uri="{FF2B5EF4-FFF2-40B4-BE49-F238E27FC236}">
                <a16:creationId xmlns:a16="http://schemas.microsoft.com/office/drawing/2014/main" id="{638BA49A-9F88-540D-2C52-F4621DC715AC}"/>
              </a:ext>
            </a:extLst>
          </p:cNvPr>
          <p:cNvSpPr txBox="1"/>
          <p:nvPr/>
        </p:nvSpPr>
        <p:spPr>
          <a:xfrm>
            <a:off x="7758279" y="4105354"/>
            <a:ext cx="1413076" cy="259750"/>
          </a:xfrm>
          <a:prstGeom prst="rect">
            <a:avLst/>
          </a:prstGeom>
          <a:solidFill>
            <a:schemeClr val="bg1"/>
          </a:solidFill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 err="1"/>
              <a:t>HtTLV</a:t>
            </a:r>
            <a:r>
              <a:rPr lang="en-US" altLang="ja-JP" sz="1400" dirty="0"/>
              <a:t> Quartile 4</a:t>
            </a:r>
            <a:endParaRPr lang="ja-JP" altLang="en-US" sz="14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5F53EC5-407A-A9D1-EE1F-9A7A29A96247}"/>
              </a:ext>
            </a:extLst>
          </p:cNvPr>
          <p:cNvSpPr txBox="1"/>
          <p:nvPr/>
        </p:nvSpPr>
        <p:spPr>
          <a:xfrm>
            <a:off x="175404" y="550421"/>
            <a:ext cx="893427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Linear mixed model analysis showing the least squares mean of the TLV ratio at each time point according to </a:t>
            </a:r>
            <a:r>
              <a:rPr kumimoji="1" lang="en-US" altLang="ja-JP" dirty="0" err="1"/>
              <a:t>HtTLV</a:t>
            </a:r>
            <a:r>
              <a:rPr kumimoji="1" lang="en-US" altLang="ja-JP" dirty="0"/>
              <a:t> quartile. </a:t>
            </a:r>
          </a:p>
          <a:p>
            <a:r>
              <a:rPr kumimoji="1" lang="en-US" altLang="ja-JP" dirty="0"/>
              <a:t>There was a significant difference between the four groups (</a:t>
            </a:r>
            <a:r>
              <a:rPr kumimoji="1" lang="en-US" altLang="ja-JP" i="1" dirty="0"/>
              <a:t>P</a:t>
            </a:r>
            <a:r>
              <a:rPr kumimoji="1" lang="en-US" altLang="ja-JP" dirty="0"/>
              <a:t>=.01)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9637889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4818" name="グラフ 21">
            <a:extLst>
              <a:ext uri="{FF2B5EF4-FFF2-40B4-BE49-F238E27FC236}">
                <a16:creationId xmlns:a16="http://schemas.microsoft.com/office/drawing/2014/main" id="{77918D17-4752-0E40-8722-F378B62E8E9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3709294"/>
              </p:ext>
            </p:extLst>
          </p:nvPr>
        </p:nvGraphicFramePr>
        <p:xfrm>
          <a:off x="107950" y="1141484"/>
          <a:ext cx="8502650" cy="46322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art" r:id="rId2" imgW="8473298" imgH="5219857" progId="Excel.Chart.8">
                  <p:embed/>
                </p:oleObj>
              </mc:Choice>
              <mc:Fallback>
                <p:oleObj name="Chart" r:id="rId2" imgW="8473298" imgH="5219857" progId="Excel.Chart.8">
                  <p:embed/>
                  <p:pic>
                    <p:nvPicPr>
                      <p:cNvPr id="34818" name="グラフ 21">
                        <a:extLst>
                          <a:ext uri="{FF2B5EF4-FFF2-40B4-BE49-F238E27FC236}">
                            <a16:creationId xmlns:a16="http://schemas.microsoft.com/office/drawing/2014/main" id="{77918D17-4752-0E40-8722-F378B62E8E95}"/>
                          </a:ext>
                        </a:extLst>
                      </p:cNvPr>
                      <p:cNvPicPr>
                        <a:picLocks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7950" y="1141484"/>
                        <a:ext cx="8502650" cy="463225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819" name="テキスト ボックス 5">
            <a:extLst>
              <a:ext uri="{FF2B5EF4-FFF2-40B4-BE49-F238E27FC236}">
                <a16:creationId xmlns:a16="http://schemas.microsoft.com/office/drawing/2014/main" id="{1E7A4D14-AEBE-AC8D-4220-FA140B79FE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7725" y="6243638"/>
            <a:ext cx="3190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n</a:t>
            </a:r>
            <a:endParaRPr kumimoji="1" lang="ja-JP" alt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20" name="テキスト ボックス 6">
            <a:extLst>
              <a:ext uri="{FF2B5EF4-FFF2-40B4-BE49-F238E27FC236}">
                <a16:creationId xmlns:a16="http://schemas.microsoft.com/office/drawing/2014/main" id="{03FD8048-2786-CD4B-BA4A-F04F2AC94D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8575" y="6243638"/>
            <a:ext cx="4191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4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21" name="テキスト ボックス 7">
            <a:extLst>
              <a:ext uri="{FF2B5EF4-FFF2-40B4-BE49-F238E27FC236}">
                <a16:creationId xmlns:a16="http://schemas.microsoft.com/office/drawing/2014/main" id="{E746B0FC-478F-1F47-CD82-3CB71079AA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9438" y="6243638"/>
            <a:ext cx="4191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20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22" name="テキスト ボックス 8">
            <a:extLst>
              <a:ext uri="{FF2B5EF4-FFF2-40B4-BE49-F238E27FC236}">
                <a16:creationId xmlns:a16="http://schemas.microsoft.com/office/drawing/2014/main" id="{EF559659-5F8A-F093-EB38-8E6E50AD89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00300" y="6243638"/>
            <a:ext cx="41751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27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23" name="テキスト ボックス 9">
            <a:extLst>
              <a:ext uri="{FF2B5EF4-FFF2-40B4-BE49-F238E27FC236}">
                <a16:creationId xmlns:a16="http://schemas.microsoft.com/office/drawing/2014/main" id="{A2921FE5-EC40-5D52-BFB2-77548C4248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79738" y="6243638"/>
            <a:ext cx="417512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38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24" name="テキスト ボックス 10">
            <a:extLst>
              <a:ext uri="{FF2B5EF4-FFF2-40B4-BE49-F238E27FC236}">
                <a16:creationId xmlns:a16="http://schemas.microsoft.com/office/drawing/2014/main" id="{68C8E922-1F42-8A10-A9FF-8A8439A93B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29013" y="6243638"/>
            <a:ext cx="4191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53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25" name="テキスト ボックス 15">
            <a:extLst>
              <a:ext uri="{FF2B5EF4-FFF2-40B4-BE49-F238E27FC236}">
                <a16:creationId xmlns:a16="http://schemas.microsoft.com/office/drawing/2014/main" id="{7D55AD31-3456-60FA-A9A1-8310CDD610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9400" y="6243638"/>
            <a:ext cx="4191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72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26" name="テキスト ボックス 16">
            <a:extLst>
              <a:ext uri="{FF2B5EF4-FFF2-40B4-BE49-F238E27FC236}">
                <a16:creationId xmlns:a16="http://schemas.microsoft.com/office/drawing/2014/main" id="{D33AFD67-C742-4B85-1B87-6627B8919F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49788" y="6243638"/>
            <a:ext cx="4191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95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27" name="テキスト ボックス 17">
            <a:extLst>
              <a:ext uri="{FF2B5EF4-FFF2-40B4-BE49-F238E27FC236}">
                <a16:creationId xmlns:a16="http://schemas.microsoft.com/office/drawing/2014/main" id="{4FC8F253-7F3F-6897-6E84-AC801CA8C7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1125" y="6243638"/>
            <a:ext cx="4191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65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28" name="テキスト ボックス 22">
            <a:extLst>
              <a:ext uri="{FF2B5EF4-FFF2-40B4-BE49-F238E27FC236}">
                <a16:creationId xmlns:a16="http://schemas.microsoft.com/office/drawing/2014/main" id="{1FEDB58D-A6D6-E7B2-948A-D4A03A0525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41988" y="6243638"/>
            <a:ext cx="417512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40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29" name="テキスト ボックス 23">
            <a:extLst>
              <a:ext uri="{FF2B5EF4-FFF2-40B4-BE49-F238E27FC236}">
                <a16:creationId xmlns:a16="http://schemas.microsoft.com/office/drawing/2014/main" id="{192E2521-3AF5-F8F9-9453-BD691B0C22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02375" y="6243638"/>
            <a:ext cx="41751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26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30" name="テキスト ボックス 24">
            <a:extLst>
              <a:ext uri="{FF2B5EF4-FFF2-40B4-BE49-F238E27FC236}">
                <a16:creationId xmlns:a16="http://schemas.microsoft.com/office/drawing/2014/main" id="{06E268F9-9E09-88DA-6D7D-1D36D8CA9B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51650" y="6243638"/>
            <a:ext cx="4191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4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31" name="テキスト ボックス 25">
            <a:extLst>
              <a:ext uri="{FF2B5EF4-FFF2-40B4-BE49-F238E27FC236}">
                <a16:creationId xmlns:a16="http://schemas.microsoft.com/office/drawing/2014/main" id="{B923CA92-5731-F10A-55C6-6486E0FADB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21563" y="6243638"/>
            <a:ext cx="4191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3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32" name="テキスト ボックス 26">
            <a:extLst>
              <a:ext uri="{FF2B5EF4-FFF2-40B4-BE49-F238E27FC236}">
                <a16:creationId xmlns:a16="http://schemas.microsoft.com/office/drawing/2014/main" id="{453DDC91-566D-1DF2-E2C1-D6431EF899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29575" y="6243638"/>
            <a:ext cx="3016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7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33" name="テキスト ボックス 27">
            <a:extLst>
              <a:ext uri="{FF2B5EF4-FFF2-40B4-BE49-F238E27FC236}">
                <a16:creationId xmlns:a16="http://schemas.microsoft.com/office/drawing/2014/main" id="{E33F9016-B9B1-A4AB-8A88-CEFBE39A01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11975" y="5722938"/>
            <a:ext cx="206057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Time point (years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34" name="テキスト ボックス 6">
            <a:extLst>
              <a:ext uri="{FF2B5EF4-FFF2-40B4-BE49-F238E27FC236}">
                <a16:creationId xmlns:a16="http://schemas.microsoft.com/office/drawing/2014/main" id="{9ED3AC15-748F-836B-9AB4-E69E9F7767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17463"/>
            <a:ext cx="5940152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(Supplemental Figure 4A)</a:t>
            </a:r>
            <a:endParaRPr kumimoji="1" lang="ja-JP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2924FA1B-D9E0-E3C8-93C4-AF7E9B6F0951}"/>
              </a:ext>
            </a:extLst>
          </p:cNvPr>
          <p:cNvCxnSpPr/>
          <p:nvPr/>
        </p:nvCxnSpPr>
        <p:spPr>
          <a:xfrm flipV="1">
            <a:off x="4791913" y="5661025"/>
            <a:ext cx="0" cy="287338"/>
          </a:xfrm>
          <a:prstGeom prst="straightConnector1">
            <a:avLst/>
          </a:prstGeom>
          <a:ln w="508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836" name="テキスト ボックス 1">
            <a:extLst>
              <a:ext uri="{FF2B5EF4-FFF2-40B4-BE49-F238E27FC236}">
                <a16:creationId xmlns:a16="http://schemas.microsoft.com/office/drawing/2014/main" id="{05FCCF1E-D368-8EAB-B2F6-B28E01E483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37013" y="5913438"/>
            <a:ext cx="1106487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Dialysis initiation</a:t>
            </a:r>
            <a:endParaRPr kumimoji="1" lang="ja-JP" altLang="en-US" sz="1600" b="0" i="0" u="none" strike="noStrike" kern="1200" cap="none" spc="0" normalizeH="0" baseline="0" noProof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37" name="テキスト ボックス 1">
            <a:extLst>
              <a:ext uri="{FF2B5EF4-FFF2-40B4-BE49-F238E27FC236}">
                <a16:creationId xmlns:a16="http://schemas.microsoft.com/office/drawing/2014/main" id="{C31E93F3-EC8F-9701-2267-6AC099534A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0325" y="3707185"/>
            <a:ext cx="548656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Before dialysis initiation vs. after dialysis initiation: </a:t>
            </a:r>
            <a:r>
              <a:rPr kumimoji="1" lang="en-US" altLang="ja-JP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P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=.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A322332-3C80-D1D9-0A31-7E7CD703E596}"/>
              </a:ext>
            </a:extLst>
          </p:cNvPr>
          <p:cNvSpPr txBox="1"/>
          <p:nvPr/>
        </p:nvSpPr>
        <p:spPr>
          <a:xfrm>
            <a:off x="175404" y="550421"/>
            <a:ext cx="89342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Linear mixed model analysis showing that the least squares mean (95% confidence intervals) of systolic BP at each time point did not change significantly after dialysis initiation (</a:t>
            </a:r>
            <a:r>
              <a:rPr kumimoji="1" lang="en-US" altLang="ja-JP" i="1" dirty="0"/>
              <a:t>P</a:t>
            </a:r>
            <a:r>
              <a:rPr kumimoji="1" lang="en-US" altLang="ja-JP" dirty="0"/>
              <a:t>=.17).</a:t>
            </a:r>
            <a:endParaRPr kumimoji="1" lang="ja-JP" altLang="en-US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DCBCEC6-0144-D149-D8FF-0309773B55FF}"/>
              </a:ext>
            </a:extLst>
          </p:cNvPr>
          <p:cNvSpPr txBox="1"/>
          <p:nvPr/>
        </p:nvSpPr>
        <p:spPr>
          <a:xfrm rot="-5400000">
            <a:off x="-764163" y="3140282"/>
            <a:ext cx="2193549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000" dirty="0"/>
              <a:t>Systolic BP</a:t>
            </a:r>
            <a:r>
              <a:rPr kumimoji="1" lang="en-US" altLang="ja-JP" sz="2000" dirty="0"/>
              <a:t> (mmHg)</a:t>
            </a:r>
            <a:endParaRPr kumimoji="1" lang="ja-JP" altLang="en-US" sz="2000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C51516B-8C2E-A747-E3A4-DBD3DB136342}"/>
              </a:ext>
            </a:extLst>
          </p:cNvPr>
          <p:cNvSpPr txBox="1"/>
          <p:nvPr/>
        </p:nvSpPr>
        <p:spPr>
          <a:xfrm>
            <a:off x="107503" y="464146"/>
            <a:ext cx="882014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Linear mixed model analysis showing that the least squares mean (95% confidence intervals) of systolic BP at each time point was lower in patients on HD than that in patients on PD; however, the difference was not statistically significant (</a:t>
            </a:r>
            <a:r>
              <a:rPr kumimoji="1" lang="en-US" altLang="ja-JP" i="1" dirty="0"/>
              <a:t>P</a:t>
            </a:r>
            <a:r>
              <a:rPr kumimoji="1" lang="en-US" altLang="ja-JP" dirty="0"/>
              <a:t>=.45).</a:t>
            </a:r>
            <a:endParaRPr kumimoji="1" lang="ja-JP" altLang="en-US" dirty="0"/>
          </a:p>
        </p:txBody>
      </p:sp>
      <p:graphicFrame>
        <p:nvGraphicFramePr>
          <p:cNvPr id="35842" name="グラフ 23">
            <a:extLst>
              <a:ext uri="{FF2B5EF4-FFF2-40B4-BE49-F238E27FC236}">
                <a16:creationId xmlns:a16="http://schemas.microsoft.com/office/drawing/2014/main" id="{6CE7C13B-E29B-BEF3-B0D2-0156072676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296119"/>
              </p:ext>
            </p:extLst>
          </p:nvPr>
        </p:nvGraphicFramePr>
        <p:xfrm>
          <a:off x="0" y="1268760"/>
          <a:ext cx="8820150" cy="43589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art" r:id="rId3" imgW="8298074" imgH="4572094" progId="Excel.Chart.8">
                  <p:embed/>
                </p:oleObj>
              </mc:Choice>
              <mc:Fallback>
                <p:oleObj name="Chart" r:id="rId3" imgW="8298074" imgH="4572094" progId="Excel.Chart.8">
                  <p:embed/>
                  <p:pic>
                    <p:nvPicPr>
                      <p:cNvPr id="35842" name="グラフ 23">
                        <a:extLst>
                          <a:ext uri="{FF2B5EF4-FFF2-40B4-BE49-F238E27FC236}">
                            <a16:creationId xmlns:a16="http://schemas.microsoft.com/office/drawing/2014/main" id="{6CE7C13B-E29B-BEF3-B0D2-0156072676EE}"/>
                          </a:ext>
                        </a:extLst>
                      </p:cNvPr>
                      <p:cNvPicPr>
                        <a:picLocks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0" y="1268760"/>
                        <a:ext cx="8820150" cy="435892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843" name="テキスト ボックス 6">
            <a:extLst>
              <a:ext uri="{FF2B5EF4-FFF2-40B4-BE49-F238E27FC236}">
                <a16:creationId xmlns:a16="http://schemas.microsoft.com/office/drawing/2014/main" id="{98068425-65BA-4304-7E1E-369AC9BD05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925" y="17463"/>
            <a:ext cx="3859133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(Supplemental Figure 4B)</a:t>
            </a:r>
            <a:endParaRPr kumimoji="1" lang="ja-JP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44" name="テキスト ボックス 5">
            <a:extLst>
              <a:ext uri="{FF2B5EF4-FFF2-40B4-BE49-F238E27FC236}">
                <a16:creationId xmlns:a16="http://schemas.microsoft.com/office/drawing/2014/main" id="{62D88BAC-5291-BC92-3D84-9E4FDCD1BF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54825" y="5507038"/>
            <a:ext cx="211772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Time point (years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45" name="テキスト ボックス 1">
            <a:extLst>
              <a:ext uri="{FF2B5EF4-FFF2-40B4-BE49-F238E27FC236}">
                <a16:creationId xmlns:a16="http://schemas.microsoft.com/office/drawing/2014/main" id="{52FF92AC-0D6B-5401-01B2-BECA5881A1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06863" y="5761038"/>
            <a:ext cx="1106487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Dialysis initiation</a:t>
            </a:r>
            <a:endParaRPr kumimoji="1" lang="ja-JP" altLang="en-US" sz="1600" b="0" i="0" u="none" strike="noStrike" kern="1200" cap="none" spc="0" normalizeH="0" baseline="0" noProof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501FEA0A-D83D-9816-5CB9-8684631A674D}"/>
              </a:ext>
            </a:extLst>
          </p:cNvPr>
          <p:cNvCxnSpPr/>
          <p:nvPr/>
        </p:nvCxnSpPr>
        <p:spPr>
          <a:xfrm flipV="1">
            <a:off x="4875213" y="5495925"/>
            <a:ext cx="0" cy="287338"/>
          </a:xfrm>
          <a:prstGeom prst="straightConnector1">
            <a:avLst/>
          </a:prstGeom>
          <a:ln w="508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847" name="テキスト ボックス 8">
            <a:extLst>
              <a:ext uri="{FF2B5EF4-FFF2-40B4-BE49-F238E27FC236}">
                <a16:creationId xmlns:a16="http://schemas.microsoft.com/office/drawing/2014/main" id="{B8CB3976-FF5E-108E-1F50-F5B5C78B38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288" y="6021388"/>
            <a:ext cx="760412" cy="708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  HD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CAPD</a:t>
            </a:r>
            <a:endParaRPr kumimoji="1" lang="ja-JP" alt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48" name="テキスト ボックス 9">
            <a:extLst>
              <a:ext uri="{FF2B5EF4-FFF2-40B4-BE49-F238E27FC236}">
                <a16:creationId xmlns:a16="http://schemas.microsoft.com/office/drawing/2014/main" id="{E2CB66B9-42A3-F9F9-3112-2C06B7573D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8888" y="6021388"/>
            <a:ext cx="4191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2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 2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49" name="テキスト ボックス 10">
            <a:extLst>
              <a:ext uri="{FF2B5EF4-FFF2-40B4-BE49-F238E27FC236}">
                <a16:creationId xmlns:a16="http://schemas.microsoft.com/office/drawing/2014/main" id="{CC736F8D-793F-6FED-384B-39027AB221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5150" y="6021388"/>
            <a:ext cx="4191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9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50" name="テキスト ボックス 11">
            <a:extLst>
              <a:ext uri="{FF2B5EF4-FFF2-40B4-BE49-F238E27FC236}">
                <a16:creationId xmlns:a16="http://schemas.microsoft.com/office/drawing/2014/main" id="{E4F14D87-A8D2-537A-6039-6EEC0AEF1D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11413" y="6021388"/>
            <a:ext cx="4191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21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6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51" name="テキスト ボックス 12">
            <a:extLst>
              <a:ext uri="{FF2B5EF4-FFF2-40B4-BE49-F238E27FC236}">
                <a16:creationId xmlns:a16="http://schemas.microsoft.com/office/drawing/2014/main" id="{DE00CA26-030C-F985-1CD8-AE0BBE9D69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7675" y="6021388"/>
            <a:ext cx="4191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33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5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52" name="テキスト ボックス 13">
            <a:extLst>
              <a:ext uri="{FF2B5EF4-FFF2-40B4-BE49-F238E27FC236}">
                <a16:creationId xmlns:a16="http://schemas.microsoft.com/office/drawing/2014/main" id="{168A2355-5710-E508-828F-91658C7183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63938" y="6021388"/>
            <a:ext cx="4191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47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6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53" name="テキスト ボックス 14">
            <a:extLst>
              <a:ext uri="{FF2B5EF4-FFF2-40B4-BE49-F238E27FC236}">
                <a16:creationId xmlns:a16="http://schemas.microsoft.com/office/drawing/2014/main" id="{E821DD6A-5C6D-FB86-1872-217414C685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40200" y="6021388"/>
            <a:ext cx="4191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64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 8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54" name="テキスト ボックス 15">
            <a:extLst>
              <a:ext uri="{FF2B5EF4-FFF2-40B4-BE49-F238E27FC236}">
                <a16:creationId xmlns:a16="http://schemas.microsoft.com/office/drawing/2014/main" id="{6BBCE433-6257-7ED1-B6DD-230B7BBDCD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08525" y="6021388"/>
            <a:ext cx="4191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85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0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55" name="テキスト ボックス 16">
            <a:extLst>
              <a:ext uri="{FF2B5EF4-FFF2-40B4-BE49-F238E27FC236}">
                <a16:creationId xmlns:a16="http://schemas.microsoft.com/office/drawing/2014/main" id="{C0A388E3-3C90-AEA7-E45F-3787AB848C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3675" y="6021388"/>
            <a:ext cx="4191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55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0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56" name="テキスト ボックス 17">
            <a:extLst>
              <a:ext uri="{FF2B5EF4-FFF2-40B4-BE49-F238E27FC236}">
                <a16:creationId xmlns:a16="http://schemas.microsoft.com/office/drawing/2014/main" id="{8745A959-1E62-7BA3-C37F-B5BE29F26E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64225" y="6021388"/>
            <a:ext cx="4191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35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 5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57" name="テキスト ボックス 18">
            <a:extLst>
              <a:ext uri="{FF2B5EF4-FFF2-40B4-BE49-F238E27FC236}">
                <a16:creationId xmlns:a16="http://schemas.microsoft.com/office/drawing/2014/main" id="{85497893-CFE8-18B6-F9CA-AF40C75D36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35725" y="6021388"/>
            <a:ext cx="4191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23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3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58" name="テキスト ボックス 19">
            <a:extLst>
              <a:ext uri="{FF2B5EF4-FFF2-40B4-BE49-F238E27FC236}">
                <a16:creationId xmlns:a16="http://schemas.microsoft.com/office/drawing/2014/main" id="{38BCB096-97BD-4A9C-CAA2-C1EE764F5D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99288" y="6021388"/>
            <a:ext cx="4191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2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 2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59" name="テキスト ボックス 20">
            <a:extLst>
              <a:ext uri="{FF2B5EF4-FFF2-40B4-BE49-F238E27FC236}">
                <a16:creationId xmlns:a16="http://schemas.microsoft.com/office/drawing/2014/main" id="{358D6B2A-A8E5-A24E-4DD6-8BC0E6454A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88250" y="6021388"/>
            <a:ext cx="4191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2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60" name="テキスト ボックス 21">
            <a:extLst>
              <a:ext uri="{FF2B5EF4-FFF2-40B4-BE49-F238E27FC236}">
                <a16:creationId xmlns:a16="http://schemas.microsoft.com/office/drawing/2014/main" id="{44ED77E3-1285-0A20-36DC-E7EFCA431A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89913" y="6021388"/>
            <a:ext cx="301625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7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0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61" name="テキスト ボックス 21">
            <a:extLst>
              <a:ext uri="{FF2B5EF4-FFF2-40B4-BE49-F238E27FC236}">
                <a16:creationId xmlns:a16="http://schemas.microsoft.com/office/drawing/2014/main" id="{461D7C04-92A8-76B3-1741-F96E50E4A0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16936" y="2916684"/>
            <a:ext cx="47148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HD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62" name="テキスト ボックス 22">
            <a:extLst>
              <a:ext uri="{FF2B5EF4-FFF2-40B4-BE49-F238E27FC236}">
                <a16:creationId xmlns:a16="http://schemas.microsoft.com/office/drawing/2014/main" id="{FB305ED7-2F1C-EFDF-EB12-E22D740ED7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15163" y="1546945"/>
            <a:ext cx="4460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PD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5863" name="テキスト ボックス 23">
            <a:extLst>
              <a:ext uri="{FF2B5EF4-FFF2-40B4-BE49-F238E27FC236}">
                <a16:creationId xmlns:a16="http://schemas.microsoft.com/office/drawing/2014/main" id="{A5886EFC-43EF-E687-792A-5DB7572848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12160" y="3688886"/>
            <a:ext cx="178343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HD vs. PD: </a:t>
            </a:r>
            <a:r>
              <a:rPr kumimoji="1" lang="en-US" altLang="ja-JP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P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 =.4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CE693F4-EE97-DD19-B194-095A5AF3631D}"/>
              </a:ext>
            </a:extLst>
          </p:cNvPr>
          <p:cNvSpPr txBox="1"/>
          <p:nvPr/>
        </p:nvSpPr>
        <p:spPr>
          <a:xfrm rot="-5400000">
            <a:off x="-789215" y="3068274"/>
            <a:ext cx="2193549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000" dirty="0"/>
              <a:t>Systolic BP</a:t>
            </a:r>
            <a:r>
              <a:rPr kumimoji="1" lang="en-US" altLang="ja-JP" sz="2000" dirty="0"/>
              <a:t> (mmHg)</a:t>
            </a:r>
            <a:endParaRPr kumimoji="1" lang="ja-JP" altLang="en-US" sz="20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402E304B-549A-F30C-C28A-3751D22D8BD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955" b="7985"/>
          <a:stretch/>
        </p:blipFill>
        <p:spPr>
          <a:xfrm>
            <a:off x="827584" y="831378"/>
            <a:ext cx="6547105" cy="5500954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3115E02-E211-E53F-C042-A95E9313CE6E}"/>
              </a:ext>
            </a:extLst>
          </p:cNvPr>
          <p:cNvSpPr txBox="1"/>
          <p:nvPr/>
        </p:nvSpPr>
        <p:spPr>
          <a:xfrm>
            <a:off x="3707904" y="6279703"/>
            <a:ext cx="15724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Age (years)</a:t>
            </a:r>
            <a:endParaRPr kumimoji="1" lang="ja-JP" altLang="en-US" sz="24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1ABBE04-2FAD-9D53-859F-14E049ADCEB9}"/>
              </a:ext>
            </a:extLst>
          </p:cNvPr>
          <p:cNvSpPr txBox="1"/>
          <p:nvPr/>
        </p:nvSpPr>
        <p:spPr>
          <a:xfrm rot="-5400000">
            <a:off x="-398946" y="3166064"/>
            <a:ext cx="19066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err="1"/>
              <a:t>HtTLV</a:t>
            </a:r>
            <a:r>
              <a:rPr kumimoji="1" lang="en-US" altLang="ja-JP" sz="2400" dirty="0"/>
              <a:t> (mL/m)</a:t>
            </a:r>
            <a:endParaRPr kumimoji="1" lang="ja-JP" altLang="en-US" sz="24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BA70DE8-8261-1AB5-F5F6-90C798308CC7}"/>
              </a:ext>
            </a:extLst>
          </p:cNvPr>
          <p:cNvSpPr txBox="1"/>
          <p:nvPr/>
        </p:nvSpPr>
        <p:spPr>
          <a:xfrm>
            <a:off x="7518705" y="1412776"/>
            <a:ext cx="133940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0070C0"/>
                </a:solidFill>
              </a:rPr>
              <a:t>Blue: Male</a:t>
            </a:r>
          </a:p>
          <a:p>
            <a:r>
              <a:rPr lang="en-US" altLang="ja-JP" dirty="0">
                <a:solidFill>
                  <a:srgbClr val="FF0000"/>
                </a:solidFill>
              </a:rPr>
              <a:t>Red: Female</a:t>
            </a:r>
            <a:endParaRPr kumimoji="1" lang="ja-JP" altLang="en-US" dirty="0">
              <a:solidFill>
                <a:srgbClr val="FF0000"/>
              </a:solidFill>
            </a:endParaRPr>
          </a:p>
        </p:txBody>
      </p:sp>
      <p:sp>
        <p:nvSpPr>
          <p:cNvPr id="9" name="タイトル 1">
            <a:extLst>
              <a:ext uri="{FF2B5EF4-FFF2-40B4-BE49-F238E27FC236}">
                <a16:creationId xmlns:a16="http://schemas.microsoft.com/office/drawing/2014/main" id="{C4BB3A15-03CF-8BB7-4B75-3B3B3F95B0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260648"/>
            <a:ext cx="8229600" cy="778098"/>
          </a:xfrm>
        </p:spPr>
        <p:txBody>
          <a:bodyPr/>
          <a:lstStyle/>
          <a:p>
            <a:r>
              <a:rPr lang="en-US" altLang="ja-JP" sz="2800" dirty="0"/>
              <a:t>Distribution of </a:t>
            </a:r>
            <a:r>
              <a:rPr lang="en-US" altLang="ja-JP" sz="2800" dirty="0" err="1"/>
              <a:t>HtTLV</a:t>
            </a:r>
            <a:r>
              <a:rPr lang="en-US" altLang="ja-JP" sz="2800" dirty="0"/>
              <a:t> and age at dialysis initiation</a:t>
            </a:r>
            <a:endParaRPr kumimoji="1" lang="ja-JP" altLang="en-US" sz="28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EAB6C07-7A8A-64E5-5D7E-95BCB80574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825" y="-27384"/>
            <a:ext cx="5067300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800" dirty="0"/>
              <a:t>(Supplemental Figure 1B)</a:t>
            </a:r>
            <a:r>
              <a:rPr lang="ja-JP" altLang="en-US" sz="2800" dirty="0"/>
              <a:t>　</a:t>
            </a:r>
          </a:p>
        </p:txBody>
      </p:sp>
    </p:spTree>
    <p:extLst>
      <p:ext uri="{BB962C8B-B14F-4D97-AF65-F5344CB8AC3E}">
        <p14:creationId xmlns:p14="http://schemas.microsoft.com/office/powerpoint/2010/main" val="29652857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テキスト ボックス 5">
            <a:extLst>
              <a:ext uri="{FF2B5EF4-FFF2-40B4-BE49-F238E27FC236}">
                <a16:creationId xmlns:a16="http://schemas.microsoft.com/office/drawing/2014/main" id="{288FC6F1-8D80-FCE0-B316-6814D144B8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650" y="6237288"/>
            <a:ext cx="3190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n</a:t>
            </a:r>
            <a:endParaRPr kumimoji="1" lang="ja-JP" alt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5" name="テキスト ボックス 6">
            <a:extLst>
              <a:ext uri="{FF2B5EF4-FFF2-40B4-BE49-F238E27FC236}">
                <a16:creationId xmlns:a16="http://schemas.microsoft.com/office/drawing/2014/main" id="{EFA336EA-A4CC-1AF4-A5E1-3CA348E797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27138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12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6" name="テキスト ボックス 7">
            <a:extLst>
              <a:ext uri="{FF2B5EF4-FFF2-40B4-BE49-F238E27FC236}">
                <a16:creationId xmlns:a16="http://schemas.microsoft.com/office/drawing/2014/main" id="{CEA85ABF-68F6-D79B-DE3B-C1DB4A8A6A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8638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19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7" name="テキスト ボックス 8">
            <a:extLst>
              <a:ext uri="{FF2B5EF4-FFF2-40B4-BE49-F238E27FC236}">
                <a16:creationId xmlns:a16="http://schemas.microsoft.com/office/drawing/2014/main" id="{2116E8AA-2679-340A-B811-6D3F65666D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70138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2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8" name="テキスト ボックス 9">
            <a:extLst>
              <a:ext uri="{FF2B5EF4-FFF2-40B4-BE49-F238E27FC236}">
                <a16:creationId xmlns:a16="http://schemas.microsoft.com/office/drawing/2014/main" id="{401D63EC-5A42-605F-FB78-6FAB1ABC1C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1638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33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9" name="テキスト ボックス 10">
            <a:extLst>
              <a:ext uri="{FF2B5EF4-FFF2-40B4-BE49-F238E27FC236}">
                <a16:creationId xmlns:a16="http://schemas.microsoft.com/office/drawing/2014/main" id="{3DC0E237-651E-D128-9961-5F1431C6AD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14725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4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0" name="テキスト ボックス 15">
            <a:extLst>
              <a:ext uri="{FF2B5EF4-FFF2-40B4-BE49-F238E27FC236}">
                <a16:creationId xmlns:a16="http://schemas.microsoft.com/office/drawing/2014/main" id="{350ACA4C-DCC4-2DB0-6F54-BB87415DFE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6225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54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1" name="テキスト ボックス 16">
            <a:extLst>
              <a:ext uri="{FF2B5EF4-FFF2-40B4-BE49-F238E27FC236}">
                <a16:creationId xmlns:a16="http://schemas.microsoft.com/office/drawing/2014/main" id="{6C24A0A8-F1A9-72B6-C694-3666AE48AE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7725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8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2" name="テキスト ボックス 17">
            <a:extLst>
              <a:ext uri="{FF2B5EF4-FFF2-40B4-BE49-F238E27FC236}">
                <a16:creationId xmlns:a16="http://schemas.microsoft.com/office/drawing/2014/main" id="{6852D06A-2C2F-1F79-66C1-7C95E48C1C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9225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3" name="テキスト ボックス 22">
            <a:extLst>
              <a:ext uri="{FF2B5EF4-FFF2-40B4-BE49-F238E27FC236}">
                <a16:creationId xmlns:a16="http://schemas.microsoft.com/office/drawing/2014/main" id="{D3DBB397-3BAA-4638-D807-77B1EA46D3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00725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3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4" name="テキスト ボックス 23">
            <a:extLst>
              <a:ext uri="{FF2B5EF4-FFF2-40B4-BE49-F238E27FC236}">
                <a16:creationId xmlns:a16="http://schemas.microsoft.com/office/drawing/2014/main" id="{19E4AE5C-3A65-4F9C-F86F-438279F16B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72225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23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5" name="テキスト ボックス 24">
            <a:extLst>
              <a:ext uri="{FF2B5EF4-FFF2-40B4-BE49-F238E27FC236}">
                <a16:creationId xmlns:a16="http://schemas.microsoft.com/office/drawing/2014/main" id="{520FA8A9-39E6-9A8A-2B9E-507BEF651B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43725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2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6" name="テキスト ボックス 25">
            <a:extLst>
              <a:ext uri="{FF2B5EF4-FFF2-40B4-BE49-F238E27FC236}">
                <a16:creationId xmlns:a16="http://schemas.microsoft.com/office/drawing/2014/main" id="{BB79937A-D107-85F8-9BF7-9A6339D6A1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15225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2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7" name="テキスト ボックス 26">
            <a:extLst>
              <a:ext uri="{FF2B5EF4-FFF2-40B4-BE49-F238E27FC236}">
                <a16:creationId xmlns:a16="http://schemas.microsoft.com/office/drawing/2014/main" id="{B99B0C2A-971E-2B9B-F1A5-F93C6320D1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86725" y="6237288"/>
            <a:ext cx="3016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7</a:t>
            </a: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8" name="テキスト ボックス 27">
            <a:extLst>
              <a:ext uri="{FF2B5EF4-FFF2-40B4-BE49-F238E27FC236}">
                <a16:creationId xmlns:a16="http://schemas.microsoft.com/office/drawing/2014/main" id="{AEC67FF8-20E9-E319-1690-32F04DB74F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20273" y="5661025"/>
            <a:ext cx="19522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Time point (years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90" name="テキスト ボックス 1">
            <a:extLst>
              <a:ext uri="{FF2B5EF4-FFF2-40B4-BE49-F238E27FC236}">
                <a16:creationId xmlns:a16="http://schemas.microsoft.com/office/drawing/2014/main" id="{6F8EE9B1-C458-9BA8-AAB2-D0C5E6964A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9951" y="5962650"/>
            <a:ext cx="121602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Dialysis initiation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CE96D9ED-0191-CBD2-4B62-5CC9EA65E87D}"/>
              </a:ext>
            </a:extLst>
          </p:cNvPr>
          <p:cNvCxnSpPr/>
          <p:nvPr/>
        </p:nvCxnSpPr>
        <p:spPr>
          <a:xfrm flipV="1">
            <a:off x="4836113" y="5688313"/>
            <a:ext cx="0" cy="287338"/>
          </a:xfrm>
          <a:prstGeom prst="straightConnector1">
            <a:avLst/>
          </a:prstGeom>
          <a:ln w="508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1">
            <a:extLst>
              <a:ext uri="{FF2B5EF4-FFF2-40B4-BE49-F238E27FC236}">
                <a16:creationId xmlns:a16="http://schemas.microsoft.com/office/drawing/2014/main" id="{CBE9AFA5-D033-7810-652F-983779FE21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1560" y="461357"/>
            <a:ext cx="871296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2200" dirty="0"/>
              <a:t>Actual measured TKV of each enrolled patient on HD at each time point </a:t>
            </a:r>
            <a:endParaRPr lang="ja-JP" altLang="en-US" sz="22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AE4FB6D-C26F-4A02-B77B-42779F5DC9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593" y="-19087"/>
            <a:ext cx="5067300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800" dirty="0"/>
              <a:t>(Supplemental Figure 2A)</a:t>
            </a:r>
            <a:r>
              <a:rPr lang="ja-JP" altLang="en-US" sz="2800" dirty="0"/>
              <a:t>　</a:t>
            </a:r>
          </a:p>
        </p:txBody>
      </p:sp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5938732"/>
              </p:ext>
            </p:extLst>
          </p:nvPr>
        </p:nvGraphicFramePr>
        <p:xfrm>
          <a:off x="-36512" y="980728"/>
          <a:ext cx="8712968" cy="48011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テキスト ボックス 5">
            <a:extLst>
              <a:ext uri="{FF2B5EF4-FFF2-40B4-BE49-F238E27FC236}">
                <a16:creationId xmlns:a16="http://schemas.microsoft.com/office/drawing/2014/main" id="{288FC6F1-8D80-FCE0-B316-6814D144B8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650" y="6237288"/>
            <a:ext cx="3190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n</a:t>
            </a:r>
            <a:endParaRPr kumimoji="1" lang="ja-JP" alt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5" name="テキスト ボックス 6">
            <a:extLst>
              <a:ext uri="{FF2B5EF4-FFF2-40B4-BE49-F238E27FC236}">
                <a16:creationId xmlns:a16="http://schemas.microsoft.com/office/drawing/2014/main" id="{EFA336EA-A4CC-1AF4-A5E1-3CA348E797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5376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2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6" name="テキスト ボックス 7">
            <a:extLst>
              <a:ext uri="{FF2B5EF4-FFF2-40B4-BE49-F238E27FC236}">
                <a16:creationId xmlns:a16="http://schemas.microsoft.com/office/drawing/2014/main" id="{CEA85ABF-68F6-D79B-DE3B-C1DB4A8A6A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23352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7" name="テキスト ボックス 8">
            <a:extLst>
              <a:ext uri="{FF2B5EF4-FFF2-40B4-BE49-F238E27FC236}">
                <a16:creationId xmlns:a16="http://schemas.microsoft.com/office/drawing/2014/main" id="{2116E8AA-2679-340A-B811-6D3F65666D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98106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6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8" name="テキスト ボックス 9">
            <a:extLst>
              <a:ext uri="{FF2B5EF4-FFF2-40B4-BE49-F238E27FC236}">
                <a16:creationId xmlns:a16="http://schemas.microsoft.com/office/drawing/2014/main" id="{401D63EC-5A42-605F-FB78-6FAB1ABC1C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1638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9" name="テキスト ボックス 10">
            <a:extLst>
              <a:ext uri="{FF2B5EF4-FFF2-40B4-BE49-F238E27FC236}">
                <a16:creationId xmlns:a16="http://schemas.microsoft.com/office/drawing/2014/main" id="{3DC0E237-651E-D128-9961-5F1431C6AD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14725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6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0" name="テキスト ボックス 15">
            <a:extLst>
              <a:ext uri="{FF2B5EF4-FFF2-40B4-BE49-F238E27FC236}">
                <a16:creationId xmlns:a16="http://schemas.microsoft.com/office/drawing/2014/main" id="{350ACA4C-DCC4-2DB0-6F54-BB87415DFE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6225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1" name="テキスト ボックス 16">
            <a:extLst>
              <a:ext uri="{FF2B5EF4-FFF2-40B4-BE49-F238E27FC236}">
                <a16:creationId xmlns:a16="http://schemas.microsoft.com/office/drawing/2014/main" id="{6C24A0A8-F1A9-72B6-C694-3666AE48AE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4198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2" name="テキスト ボックス 17">
            <a:extLst>
              <a:ext uri="{FF2B5EF4-FFF2-40B4-BE49-F238E27FC236}">
                <a16:creationId xmlns:a16="http://schemas.microsoft.com/office/drawing/2014/main" id="{6852D06A-2C2F-1F79-66C1-7C95E48C1C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9225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3" name="テキスト ボックス 22">
            <a:extLst>
              <a:ext uri="{FF2B5EF4-FFF2-40B4-BE49-F238E27FC236}">
                <a16:creationId xmlns:a16="http://schemas.microsoft.com/office/drawing/2014/main" id="{D3DBB397-3BAA-4638-D807-77B1EA46D3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25439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4" name="テキスト ボックス 23">
            <a:extLst>
              <a:ext uri="{FF2B5EF4-FFF2-40B4-BE49-F238E27FC236}">
                <a16:creationId xmlns:a16="http://schemas.microsoft.com/office/drawing/2014/main" id="{19E4AE5C-3A65-4F9C-F86F-438279F16B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80463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3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5" name="テキスト ボックス 24">
            <a:extLst>
              <a:ext uri="{FF2B5EF4-FFF2-40B4-BE49-F238E27FC236}">
                <a16:creationId xmlns:a16="http://schemas.microsoft.com/office/drawing/2014/main" id="{520FA8A9-39E6-9A8A-2B9E-507BEF651B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51963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2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6" name="テキスト ボックス 25">
            <a:extLst>
              <a:ext uri="{FF2B5EF4-FFF2-40B4-BE49-F238E27FC236}">
                <a16:creationId xmlns:a16="http://schemas.microsoft.com/office/drawing/2014/main" id="{BB79937A-D107-85F8-9BF7-9A6339D6A1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23463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7" name="テキスト ボックス 26">
            <a:extLst>
              <a:ext uri="{FF2B5EF4-FFF2-40B4-BE49-F238E27FC236}">
                <a16:creationId xmlns:a16="http://schemas.microsoft.com/office/drawing/2014/main" id="{B99B0C2A-971E-2B9B-F1A5-F93C6320D1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03201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8" name="テキスト ボックス 27">
            <a:extLst>
              <a:ext uri="{FF2B5EF4-FFF2-40B4-BE49-F238E27FC236}">
                <a16:creationId xmlns:a16="http://schemas.microsoft.com/office/drawing/2014/main" id="{AEC67FF8-20E9-E319-1690-32F04DB74F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20273" y="5661025"/>
            <a:ext cx="195227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Time point (years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90" name="テキスト ボックス 1">
            <a:extLst>
              <a:ext uri="{FF2B5EF4-FFF2-40B4-BE49-F238E27FC236}">
                <a16:creationId xmlns:a16="http://schemas.microsoft.com/office/drawing/2014/main" id="{6F8EE9B1-C458-9BA8-AAB2-D0C5E6964A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0523" y="5962650"/>
            <a:ext cx="121602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Dialysis initiation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CE96D9ED-0191-CBD2-4B62-5CC9EA65E87D}"/>
              </a:ext>
            </a:extLst>
          </p:cNvPr>
          <p:cNvCxnSpPr/>
          <p:nvPr/>
        </p:nvCxnSpPr>
        <p:spPr>
          <a:xfrm flipV="1">
            <a:off x="4812738" y="5680075"/>
            <a:ext cx="0" cy="287338"/>
          </a:xfrm>
          <a:prstGeom prst="straightConnector1">
            <a:avLst/>
          </a:prstGeom>
          <a:ln w="508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87891BC-CA99-4C2A-532A-13714C285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825" y="25228"/>
            <a:ext cx="5067300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800" dirty="0"/>
              <a:t>(Supplemental Figure 2B)</a:t>
            </a:r>
            <a:r>
              <a:rPr lang="ja-JP" altLang="en-US" sz="2800" dirty="0"/>
              <a:t>　</a:t>
            </a:r>
          </a:p>
        </p:txBody>
      </p:sp>
      <p:sp>
        <p:nvSpPr>
          <p:cNvPr id="22" name="テキスト ボックス 1">
            <a:extLst>
              <a:ext uri="{FF2B5EF4-FFF2-40B4-BE49-F238E27FC236}">
                <a16:creationId xmlns:a16="http://schemas.microsoft.com/office/drawing/2014/main" id="{FA84B0B0-FF92-4C19-BB6B-33FFAABB37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1560" y="502547"/>
            <a:ext cx="871296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2200" dirty="0"/>
              <a:t>Actual measured TKV of each enrolled patient on PD at each time point </a:t>
            </a:r>
            <a:endParaRPr lang="ja-JP" altLang="en-US" sz="2200" dirty="0"/>
          </a:p>
        </p:txBody>
      </p:sp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0444720D-9113-4582-D8AC-EAFEC08EEA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1082711"/>
              </p:ext>
            </p:extLst>
          </p:nvPr>
        </p:nvGraphicFramePr>
        <p:xfrm>
          <a:off x="-119416" y="1031088"/>
          <a:ext cx="8712968" cy="47209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9767509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2957235"/>
              </p:ext>
            </p:extLst>
          </p:nvPr>
        </p:nvGraphicFramePr>
        <p:xfrm>
          <a:off x="683568" y="1340768"/>
          <a:ext cx="8445015" cy="50159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98CA97A-71AA-51B8-2CA8-71D3FA8582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825" y="25228"/>
            <a:ext cx="5067300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800" dirty="0"/>
              <a:t>(Supplemental Figure 2C)</a:t>
            </a:r>
            <a:r>
              <a:rPr lang="ja-JP" altLang="en-US" sz="2800" dirty="0"/>
              <a:t>　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18D79EB-9F11-0729-C959-F92106C8795C}"/>
              </a:ext>
            </a:extLst>
          </p:cNvPr>
          <p:cNvSpPr txBox="1"/>
          <p:nvPr/>
        </p:nvSpPr>
        <p:spPr>
          <a:xfrm rot="-5400000">
            <a:off x="-444530" y="3263295"/>
            <a:ext cx="17945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TKV ratio (%)</a:t>
            </a:r>
            <a:endParaRPr kumimoji="1" lang="ja-JP" altLang="en-US" sz="2400" dirty="0"/>
          </a:p>
        </p:txBody>
      </p:sp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168F3A60-B653-E31C-DABC-9EC89B373C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60031" y="6351413"/>
            <a:ext cx="121602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Dialysis initiation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0C9DF8FD-64AF-471B-7CD3-C56B94C9E252}"/>
              </a:ext>
            </a:extLst>
          </p:cNvPr>
          <p:cNvCxnSpPr/>
          <p:nvPr/>
        </p:nvCxnSpPr>
        <p:spPr>
          <a:xfrm flipV="1">
            <a:off x="4584526" y="6114654"/>
            <a:ext cx="0" cy="287338"/>
          </a:xfrm>
          <a:prstGeom prst="straightConnector1">
            <a:avLst/>
          </a:prstGeom>
          <a:ln w="508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487BC0D-68DC-7EA6-5F35-9602F97EE388}"/>
              </a:ext>
            </a:extLst>
          </p:cNvPr>
          <p:cNvSpPr txBox="1"/>
          <p:nvPr/>
        </p:nvSpPr>
        <p:spPr>
          <a:xfrm>
            <a:off x="175404" y="550421"/>
            <a:ext cx="89342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Linear mixed model analysis showing the least squares mean of the TKV ratio at each time point. There was </a:t>
            </a:r>
            <a:r>
              <a:rPr lang="en-US" altLang="ja-JP" dirty="0"/>
              <a:t>a </a:t>
            </a:r>
            <a:r>
              <a:rPr kumimoji="1" lang="en-US" altLang="ja-JP" dirty="0"/>
              <a:t>significant difference between male and female patients (</a:t>
            </a:r>
            <a:r>
              <a:rPr kumimoji="1" lang="en-US" altLang="ja-JP" i="1" dirty="0"/>
              <a:t>P&lt;.001</a:t>
            </a:r>
            <a:r>
              <a:rPr kumimoji="1" lang="en-US" altLang="ja-JP" dirty="0"/>
              <a:t>).</a:t>
            </a:r>
            <a:endParaRPr kumimoji="1" lang="ja-JP" altLang="en-US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E3830A1-C812-1DCD-8031-0C68F931C59E}"/>
              </a:ext>
            </a:extLst>
          </p:cNvPr>
          <p:cNvSpPr txBox="1"/>
          <p:nvPr/>
        </p:nvSpPr>
        <p:spPr>
          <a:xfrm>
            <a:off x="4139952" y="2156588"/>
            <a:ext cx="24565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ale vs. Female: </a:t>
            </a:r>
            <a:r>
              <a:rPr kumimoji="1" lang="en-US" altLang="ja-JP" i="1" dirty="0"/>
              <a:t>P</a:t>
            </a:r>
            <a:r>
              <a:rPr kumimoji="1" lang="en-US" altLang="ja-JP" dirty="0"/>
              <a:t>&lt;</a:t>
            </a:r>
            <a:r>
              <a:rPr kumimoji="1" lang="en-US" altLang="ja-JP" i="1" dirty="0"/>
              <a:t>.001</a:t>
            </a:r>
            <a:endParaRPr kumimoji="1" lang="ja-JP" altLang="en-US" dirty="0"/>
          </a:p>
        </p:txBody>
      </p:sp>
      <p:sp>
        <p:nvSpPr>
          <p:cNvPr id="7" name="テキスト ボックス 27">
            <a:extLst>
              <a:ext uri="{FF2B5EF4-FFF2-40B4-BE49-F238E27FC236}">
                <a16:creationId xmlns:a16="http://schemas.microsoft.com/office/drawing/2014/main" id="{CE538392-018E-D34D-2934-CEBEB917E5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76256" y="6178596"/>
            <a:ext cx="196068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Time point (years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1" name="テキスト ボックス 1">
            <a:extLst>
              <a:ext uri="{FF2B5EF4-FFF2-40B4-BE49-F238E27FC236}">
                <a16:creationId xmlns:a16="http://schemas.microsoft.com/office/drawing/2014/main" id="{DDD8A515-CD55-CB1D-22BD-EA72EEA9EBC0}"/>
              </a:ext>
            </a:extLst>
          </p:cNvPr>
          <p:cNvSpPr txBox="1"/>
          <p:nvPr/>
        </p:nvSpPr>
        <p:spPr>
          <a:xfrm>
            <a:off x="7596336" y="2309896"/>
            <a:ext cx="914400" cy="286966"/>
          </a:xfrm>
          <a:prstGeom prst="rect">
            <a:avLst/>
          </a:prstGeom>
          <a:solidFill>
            <a:schemeClr val="bg1"/>
          </a:solidFill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600" dirty="0"/>
              <a:t>Male</a:t>
            </a:r>
            <a:endParaRPr lang="ja-JP" altLang="en-US" sz="1600" dirty="0"/>
          </a:p>
        </p:txBody>
      </p:sp>
      <p:sp>
        <p:nvSpPr>
          <p:cNvPr id="10" name="テキスト ボックス 1">
            <a:extLst>
              <a:ext uri="{FF2B5EF4-FFF2-40B4-BE49-F238E27FC236}">
                <a16:creationId xmlns:a16="http://schemas.microsoft.com/office/drawing/2014/main" id="{F431FCDE-19D8-4B37-1F93-45AC4A53F47F}"/>
              </a:ext>
            </a:extLst>
          </p:cNvPr>
          <p:cNvSpPr txBox="1"/>
          <p:nvPr/>
        </p:nvSpPr>
        <p:spPr>
          <a:xfrm>
            <a:off x="7596336" y="3988600"/>
            <a:ext cx="914400" cy="290425"/>
          </a:xfrm>
          <a:prstGeom prst="rect">
            <a:avLst/>
          </a:prstGeom>
          <a:solidFill>
            <a:schemeClr val="bg1"/>
          </a:solidFill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600" dirty="0"/>
              <a:t>Female</a:t>
            </a:r>
            <a:endParaRPr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3915996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00000000-0008-0000-04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347421"/>
              </p:ext>
            </p:extLst>
          </p:nvPr>
        </p:nvGraphicFramePr>
        <p:xfrm>
          <a:off x="699725" y="1473750"/>
          <a:ext cx="8064896" cy="46721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98CA97A-71AA-51B8-2CA8-71D3FA8582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825" y="25228"/>
            <a:ext cx="5067300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800" dirty="0"/>
              <a:t>(Supplemental Figure 2D)</a:t>
            </a:r>
            <a:r>
              <a:rPr lang="ja-JP" altLang="en-US" sz="2800" dirty="0"/>
              <a:t>　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F6875E8-8C27-20C5-A016-1BE5B510D734}"/>
              </a:ext>
            </a:extLst>
          </p:cNvPr>
          <p:cNvSpPr txBox="1"/>
          <p:nvPr/>
        </p:nvSpPr>
        <p:spPr>
          <a:xfrm rot="-5400000">
            <a:off x="-444530" y="3166064"/>
            <a:ext cx="17945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TKV ratio (%)</a:t>
            </a:r>
            <a:endParaRPr kumimoji="1" lang="ja-JP" altLang="en-US" sz="2400" dirty="0"/>
          </a:p>
        </p:txBody>
      </p:sp>
      <p:sp>
        <p:nvSpPr>
          <p:cNvPr id="7" name="テキスト ボックス 27">
            <a:extLst>
              <a:ext uri="{FF2B5EF4-FFF2-40B4-BE49-F238E27FC236}">
                <a16:creationId xmlns:a16="http://schemas.microsoft.com/office/drawing/2014/main" id="{B67BEF8E-6D93-E8A4-03B7-8EAE162B08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20274" y="6011440"/>
            <a:ext cx="1888676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Time point (years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4923F48B-963F-F1A3-E8BB-0A8DB3DCDE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63888" y="6351413"/>
            <a:ext cx="121602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Dialysis initiation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B4E50C42-3621-F49A-090C-ED5ED79489E6}"/>
              </a:ext>
            </a:extLst>
          </p:cNvPr>
          <p:cNvCxnSpPr/>
          <p:nvPr/>
        </p:nvCxnSpPr>
        <p:spPr>
          <a:xfrm flipV="1">
            <a:off x="4317524" y="6077076"/>
            <a:ext cx="0" cy="287338"/>
          </a:xfrm>
          <a:prstGeom prst="straightConnector1">
            <a:avLst/>
          </a:prstGeom>
          <a:ln w="508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7F57C2E-75A8-CDBD-B5B6-F9F46D856A55}"/>
              </a:ext>
            </a:extLst>
          </p:cNvPr>
          <p:cNvSpPr txBox="1"/>
          <p:nvPr/>
        </p:nvSpPr>
        <p:spPr>
          <a:xfrm>
            <a:off x="7642674" y="3103281"/>
            <a:ext cx="1324593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Mayo 1A +</a:t>
            </a:r>
            <a:r>
              <a:rPr kumimoji="1" lang="ja-JP" altLang="en-US" sz="1600" dirty="0"/>
              <a:t>１</a:t>
            </a:r>
            <a:r>
              <a:rPr kumimoji="1" lang="en-US" altLang="ja-JP" sz="1600" dirty="0"/>
              <a:t>B</a:t>
            </a:r>
            <a:endParaRPr kumimoji="1" lang="ja-JP" altLang="en-US" sz="16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97E5CE4-DDCB-70E3-7750-82DBDA00C307}"/>
              </a:ext>
            </a:extLst>
          </p:cNvPr>
          <p:cNvSpPr txBox="1"/>
          <p:nvPr/>
        </p:nvSpPr>
        <p:spPr>
          <a:xfrm>
            <a:off x="7658917" y="4098558"/>
            <a:ext cx="904607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Mayo 1E</a:t>
            </a:r>
            <a:endParaRPr kumimoji="1" lang="ja-JP" altLang="en-US" sz="16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B867364-3CE4-769B-2237-850D8A84D3A2}"/>
              </a:ext>
            </a:extLst>
          </p:cNvPr>
          <p:cNvSpPr txBox="1"/>
          <p:nvPr/>
        </p:nvSpPr>
        <p:spPr>
          <a:xfrm>
            <a:off x="7643471" y="3453894"/>
            <a:ext cx="91262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Mayo 1C</a:t>
            </a:r>
            <a:endParaRPr kumimoji="1" lang="ja-JP" altLang="en-US" sz="16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F9E6A1E-2887-1B48-87CF-CC1CB644DEF5}"/>
              </a:ext>
            </a:extLst>
          </p:cNvPr>
          <p:cNvSpPr txBox="1"/>
          <p:nvPr/>
        </p:nvSpPr>
        <p:spPr>
          <a:xfrm>
            <a:off x="7653669" y="3776226"/>
            <a:ext cx="930255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Mayo 1D</a:t>
            </a:r>
            <a:endParaRPr kumimoji="1" lang="ja-JP" altLang="en-US" sz="16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C77110E-44FD-CC52-CC08-A38740E1B1A3}"/>
              </a:ext>
            </a:extLst>
          </p:cNvPr>
          <p:cNvSpPr txBox="1"/>
          <p:nvPr/>
        </p:nvSpPr>
        <p:spPr>
          <a:xfrm>
            <a:off x="175404" y="550421"/>
            <a:ext cx="893427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Linear mixed model analysis showing the least squares mean of the TKV ratio at each time point according to Mayo Classification. </a:t>
            </a:r>
          </a:p>
          <a:p>
            <a:r>
              <a:rPr kumimoji="1" lang="en-US" altLang="ja-JP" dirty="0"/>
              <a:t>There was a significant difference between the four groups (</a:t>
            </a:r>
            <a:r>
              <a:rPr kumimoji="1" lang="en-US" altLang="ja-JP" i="1" dirty="0"/>
              <a:t>P</a:t>
            </a:r>
            <a:r>
              <a:rPr kumimoji="1" lang="en-US" altLang="ja-JP" dirty="0"/>
              <a:t>&lt;.001).</a:t>
            </a:r>
            <a:endParaRPr kumimoji="1" lang="ja-JP" altLang="en-US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5898715-17FA-D565-A91A-69B545AB434C}"/>
              </a:ext>
            </a:extLst>
          </p:cNvPr>
          <p:cNvSpPr txBox="1"/>
          <p:nvPr/>
        </p:nvSpPr>
        <p:spPr>
          <a:xfrm>
            <a:off x="7344929" y="1772816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/>
              <a:t>P</a:t>
            </a:r>
            <a:r>
              <a:rPr kumimoji="1" lang="en-US" altLang="ja-JP" dirty="0"/>
              <a:t>&lt;.001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353054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テキスト ボックス 5">
            <a:extLst>
              <a:ext uri="{FF2B5EF4-FFF2-40B4-BE49-F238E27FC236}">
                <a16:creationId xmlns:a16="http://schemas.microsoft.com/office/drawing/2014/main" id="{288FC6F1-8D80-FCE0-B316-6814D144B8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650" y="6237288"/>
            <a:ext cx="3190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n</a:t>
            </a:r>
            <a:endParaRPr kumimoji="1" lang="ja-JP" alt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5" name="テキスト ボックス 6">
            <a:extLst>
              <a:ext uri="{FF2B5EF4-FFF2-40B4-BE49-F238E27FC236}">
                <a16:creationId xmlns:a16="http://schemas.microsoft.com/office/drawing/2014/main" id="{EFA336EA-A4CC-1AF4-A5E1-3CA348E797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9632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6" name="テキスト ボックス 7">
            <a:extLst>
              <a:ext uri="{FF2B5EF4-FFF2-40B4-BE49-F238E27FC236}">
                <a16:creationId xmlns:a16="http://schemas.microsoft.com/office/drawing/2014/main" id="{CEA85ABF-68F6-D79B-DE3B-C1DB4A8A6A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8638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1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7" name="テキスト ボックス 8">
            <a:extLst>
              <a:ext uri="{FF2B5EF4-FFF2-40B4-BE49-F238E27FC236}">
                <a16:creationId xmlns:a16="http://schemas.microsoft.com/office/drawing/2014/main" id="{2116E8AA-2679-340A-B811-6D3F65666D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70138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1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8" name="テキスト ボックス 9">
            <a:extLst>
              <a:ext uri="{FF2B5EF4-FFF2-40B4-BE49-F238E27FC236}">
                <a16:creationId xmlns:a16="http://schemas.microsoft.com/office/drawing/2014/main" id="{401D63EC-5A42-605F-FB78-6FAB1ABC1C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3400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2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9" name="テキスト ボックス 10">
            <a:extLst>
              <a:ext uri="{FF2B5EF4-FFF2-40B4-BE49-F238E27FC236}">
                <a16:creationId xmlns:a16="http://schemas.microsoft.com/office/drawing/2014/main" id="{3DC0E237-651E-D128-9961-5F1431C6AD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98249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3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3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0" name="テキスト ボックス 15">
            <a:extLst>
              <a:ext uri="{FF2B5EF4-FFF2-40B4-BE49-F238E27FC236}">
                <a16:creationId xmlns:a16="http://schemas.microsoft.com/office/drawing/2014/main" id="{350ACA4C-DCC4-2DB0-6F54-BB87415DFE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77987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34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1" name="テキスト ボックス 16">
            <a:extLst>
              <a:ext uri="{FF2B5EF4-FFF2-40B4-BE49-F238E27FC236}">
                <a16:creationId xmlns:a16="http://schemas.microsoft.com/office/drawing/2014/main" id="{6C24A0A8-F1A9-72B6-C694-3666AE48AE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49487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5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2" name="テキスト ボックス 17">
            <a:extLst>
              <a:ext uri="{FF2B5EF4-FFF2-40B4-BE49-F238E27FC236}">
                <a16:creationId xmlns:a16="http://schemas.microsoft.com/office/drawing/2014/main" id="{6852D06A-2C2F-1F79-66C1-7C95E48C1C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0987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3" name="テキスト ボックス 22">
            <a:extLst>
              <a:ext uri="{FF2B5EF4-FFF2-40B4-BE49-F238E27FC236}">
                <a16:creationId xmlns:a16="http://schemas.microsoft.com/office/drawing/2014/main" id="{D3DBB397-3BAA-4638-D807-77B1EA46D3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2487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2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4" name="テキスト ボックス 23">
            <a:extLst>
              <a:ext uri="{FF2B5EF4-FFF2-40B4-BE49-F238E27FC236}">
                <a16:creationId xmlns:a16="http://schemas.microsoft.com/office/drawing/2014/main" id="{19E4AE5C-3A65-4F9C-F86F-438279F16B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55749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5" name="テキスト ボックス 24">
            <a:extLst>
              <a:ext uri="{FF2B5EF4-FFF2-40B4-BE49-F238E27FC236}">
                <a16:creationId xmlns:a16="http://schemas.microsoft.com/office/drawing/2014/main" id="{520FA8A9-39E6-9A8A-2B9E-507BEF651B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35487" y="6237288"/>
            <a:ext cx="4187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1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6" name="テキスト ボックス 25">
            <a:extLst>
              <a:ext uri="{FF2B5EF4-FFF2-40B4-BE49-F238E27FC236}">
                <a16:creationId xmlns:a16="http://schemas.microsoft.com/office/drawing/2014/main" id="{BB79937A-D107-85F8-9BF7-9A6339D6A1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5590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9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7" name="テキスト ボックス 26">
            <a:extLst>
              <a:ext uri="{FF2B5EF4-FFF2-40B4-BE49-F238E27FC236}">
                <a16:creationId xmlns:a16="http://schemas.microsoft.com/office/drawing/2014/main" id="{B99B0C2A-971E-2B9B-F1A5-F93C6320D1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86725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6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8" name="テキスト ボックス 27">
            <a:extLst>
              <a:ext uri="{FF2B5EF4-FFF2-40B4-BE49-F238E27FC236}">
                <a16:creationId xmlns:a16="http://schemas.microsoft.com/office/drawing/2014/main" id="{AEC67FF8-20E9-E319-1690-32F04DB74F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35487" y="5661025"/>
            <a:ext cx="20370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Time point (years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90" name="テキスト ボックス 1">
            <a:extLst>
              <a:ext uri="{FF2B5EF4-FFF2-40B4-BE49-F238E27FC236}">
                <a16:creationId xmlns:a16="http://schemas.microsoft.com/office/drawing/2014/main" id="{6F8EE9B1-C458-9BA8-AAB2-D0C5E6964A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95936" y="5962650"/>
            <a:ext cx="121602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Dialysis initiation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CE96D9ED-0191-CBD2-4B62-5CC9EA65E87D}"/>
              </a:ext>
            </a:extLst>
          </p:cNvPr>
          <p:cNvCxnSpPr/>
          <p:nvPr/>
        </p:nvCxnSpPr>
        <p:spPr>
          <a:xfrm flipV="1">
            <a:off x="4817503" y="5733950"/>
            <a:ext cx="0" cy="287338"/>
          </a:xfrm>
          <a:prstGeom prst="straightConnector1">
            <a:avLst/>
          </a:prstGeom>
          <a:ln w="508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DFA7A8F-8F03-E4CF-77A2-CE98B6D82B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593" y="-19087"/>
            <a:ext cx="5067300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800" dirty="0"/>
              <a:t>(Supplemental Figure 3A)</a:t>
            </a:r>
            <a:r>
              <a:rPr lang="ja-JP" altLang="en-US" sz="2800" dirty="0"/>
              <a:t>　</a:t>
            </a:r>
          </a:p>
        </p:txBody>
      </p:sp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00000000-0008-0000-09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8492920"/>
              </p:ext>
            </p:extLst>
          </p:nvPr>
        </p:nvGraphicFramePr>
        <p:xfrm>
          <a:off x="-50581" y="939127"/>
          <a:ext cx="8727037" cy="48129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2" name="テキスト ボックス 1">
            <a:extLst>
              <a:ext uri="{FF2B5EF4-FFF2-40B4-BE49-F238E27FC236}">
                <a16:creationId xmlns:a16="http://schemas.microsoft.com/office/drawing/2014/main" id="{E04AA479-5337-7879-4796-FC7ED743AE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1560" y="422301"/>
            <a:ext cx="871296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2200" dirty="0"/>
              <a:t>Actual measured TLV of each enrolled patient on HD at each time point </a:t>
            </a:r>
            <a:endParaRPr lang="ja-JP" altLang="en-US" sz="2200" dirty="0"/>
          </a:p>
        </p:txBody>
      </p:sp>
    </p:spTree>
    <p:extLst>
      <p:ext uri="{BB962C8B-B14F-4D97-AF65-F5344CB8AC3E}">
        <p14:creationId xmlns:p14="http://schemas.microsoft.com/office/powerpoint/2010/main" val="10935782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テキスト ボックス 5">
            <a:extLst>
              <a:ext uri="{FF2B5EF4-FFF2-40B4-BE49-F238E27FC236}">
                <a16:creationId xmlns:a16="http://schemas.microsoft.com/office/drawing/2014/main" id="{288FC6F1-8D80-FCE0-B316-6814D144B8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650" y="6237288"/>
            <a:ext cx="3190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n</a:t>
            </a:r>
            <a:endParaRPr kumimoji="1" lang="ja-JP" alt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5" name="テキスト ボックス 6">
            <a:extLst>
              <a:ext uri="{FF2B5EF4-FFF2-40B4-BE49-F238E27FC236}">
                <a16:creationId xmlns:a16="http://schemas.microsoft.com/office/drawing/2014/main" id="{EFA336EA-A4CC-1AF4-A5E1-3CA348E797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7340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2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6" name="テキスト ボックス 7">
            <a:extLst>
              <a:ext uri="{FF2B5EF4-FFF2-40B4-BE49-F238E27FC236}">
                <a16:creationId xmlns:a16="http://schemas.microsoft.com/office/drawing/2014/main" id="{CEA85ABF-68F6-D79B-DE3B-C1DB4A8A6A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7492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7" name="テキスト ボックス 8">
            <a:extLst>
              <a:ext uri="{FF2B5EF4-FFF2-40B4-BE49-F238E27FC236}">
                <a16:creationId xmlns:a16="http://schemas.microsoft.com/office/drawing/2014/main" id="{2116E8AA-2679-340A-B811-6D3F65666D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70138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6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8" name="テキスト ボックス 9">
            <a:extLst>
              <a:ext uri="{FF2B5EF4-FFF2-40B4-BE49-F238E27FC236}">
                <a16:creationId xmlns:a16="http://schemas.microsoft.com/office/drawing/2014/main" id="{401D63EC-5A42-605F-FB78-6FAB1ABC1C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1638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4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79" name="テキスト ボックス 10">
            <a:extLst>
              <a:ext uri="{FF2B5EF4-FFF2-40B4-BE49-F238E27FC236}">
                <a16:creationId xmlns:a16="http://schemas.microsoft.com/office/drawing/2014/main" id="{3DC0E237-651E-D128-9961-5F1431C6AD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14725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0" name="テキスト ボックス 15">
            <a:extLst>
              <a:ext uri="{FF2B5EF4-FFF2-40B4-BE49-F238E27FC236}">
                <a16:creationId xmlns:a16="http://schemas.microsoft.com/office/drawing/2014/main" id="{350ACA4C-DCC4-2DB0-6F54-BB87415DFE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6225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1" name="テキスト ボックス 16">
            <a:extLst>
              <a:ext uri="{FF2B5EF4-FFF2-40B4-BE49-F238E27FC236}">
                <a16:creationId xmlns:a16="http://schemas.microsoft.com/office/drawing/2014/main" id="{6C24A0A8-F1A9-72B6-C694-3666AE48AE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7725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9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2" name="テキスト ボックス 17">
            <a:extLst>
              <a:ext uri="{FF2B5EF4-FFF2-40B4-BE49-F238E27FC236}">
                <a16:creationId xmlns:a16="http://schemas.microsoft.com/office/drawing/2014/main" id="{6852D06A-2C2F-1F79-66C1-7C95E48C1C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9225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9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3" name="テキスト ボックス 22">
            <a:extLst>
              <a:ext uri="{FF2B5EF4-FFF2-40B4-BE49-F238E27FC236}">
                <a16:creationId xmlns:a16="http://schemas.microsoft.com/office/drawing/2014/main" id="{D3DBB397-3BAA-4638-D807-77B1EA46D3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00725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4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4" name="テキスト ボックス 23">
            <a:extLst>
              <a:ext uri="{FF2B5EF4-FFF2-40B4-BE49-F238E27FC236}">
                <a16:creationId xmlns:a16="http://schemas.microsoft.com/office/drawing/2014/main" id="{19E4AE5C-3A65-4F9C-F86F-438279F16B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91079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3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5" name="テキスト ボックス 24">
            <a:extLst>
              <a:ext uri="{FF2B5EF4-FFF2-40B4-BE49-F238E27FC236}">
                <a16:creationId xmlns:a16="http://schemas.microsoft.com/office/drawing/2014/main" id="{520FA8A9-39E6-9A8A-2B9E-507BEF651B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43725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2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6" name="テキスト ボックス 25">
            <a:extLst>
              <a:ext uri="{FF2B5EF4-FFF2-40B4-BE49-F238E27FC236}">
                <a16:creationId xmlns:a16="http://schemas.microsoft.com/office/drawing/2014/main" id="{BB79937A-D107-85F8-9BF7-9A6339D6A1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15225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prstClr val="black"/>
                </a:solidFill>
              </a:rPr>
              <a:t>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7" name="テキスト ボックス 26">
            <a:extLst>
              <a:ext uri="{FF2B5EF4-FFF2-40B4-BE49-F238E27FC236}">
                <a16:creationId xmlns:a16="http://schemas.microsoft.com/office/drawing/2014/main" id="{B99B0C2A-971E-2B9B-F1A5-F93C6320D1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86725" y="6237288"/>
            <a:ext cx="301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88" name="テキスト ボックス 27">
            <a:extLst>
              <a:ext uri="{FF2B5EF4-FFF2-40B4-BE49-F238E27FC236}">
                <a16:creationId xmlns:a16="http://schemas.microsoft.com/office/drawing/2014/main" id="{AEC67FF8-20E9-E319-1690-32F04DB74F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76256" y="5723408"/>
            <a:ext cx="2096294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Time point (years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690" name="テキスト ボックス 1">
            <a:extLst>
              <a:ext uri="{FF2B5EF4-FFF2-40B4-BE49-F238E27FC236}">
                <a16:creationId xmlns:a16="http://schemas.microsoft.com/office/drawing/2014/main" id="{6F8EE9B1-C458-9BA8-AAB2-D0C5E6964A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23349" y="5962650"/>
            <a:ext cx="121602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Dialysis initiation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CE96D9ED-0191-CBD2-4B62-5CC9EA65E87D}"/>
              </a:ext>
            </a:extLst>
          </p:cNvPr>
          <p:cNvCxnSpPr/>
          <p:nvPr/>
        </p:nvCxnSpPr>
        <p:spPr>
          <a:xfrm flipV="1">
            <a:off x="4827080" y="5733950"/>
            <a:ext cx="0" cy="287338"/>
          </a:xfrm>
          <a:prstGeom prst="straightConnector1">
            <a:avLst/>
          </a:prstGeom>
          <a:ln w="508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E8333DE-F0EE-85E2-DBC4-0510313C7F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593" y="-19087"/>
            <a:ext cx="5067300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800" dirty="0"/>
              <a:t>(Supplemental Figure 3B)</a:t>
            </a:r>
            <a:r>
              <a:rPr lang="ja-JP" altLang="en-US" sz="2800" dirty="0"/>
              <a:t>　</a:t>
            </a:r>
          </a:p>
        </p:txBody>
      </p:sp>
      <p:sp>
        <p:nvSpPr>
          <p:cNvPr id="24" name="テキスト ボックス 1">
            <a:extLst>
              <a:ext uri="{FF2B5EF4-FFF2-40B4-BE49-F238E27FC236}">
                <a16:creationId xmlns:a16="http://schemas.microsoft.com/office/drawing/2014/main" id="{002E3A52-3DB4-02B6-D24D-0E408D66DE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1560" y="422301"/>
            <a:ext cx="8712968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2200" dirty="0"/>
              <a:t>Actual measured TLV of each enrolled patient on PD at each time point </a:t>
            </a:r>
            <a:endParaRPr lang="ja-JP" altLang="en-US" sz="2200" dirty="0"/>
          </a:p>
        </p:txBody>
      </p:sp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00000000-0008-0000-0B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001566"/>
              </p:ext>
            </p:extLst>
          </p:nvPr>
        </p:nvGraphicFramePr>
        <p:xfrm>
          <a:off x="86593" y="1056059"/>
          <a:ext cx="8589864" cy="47256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7339035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98CA97A-71AA-51B8-2CA8-71D3FA8582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825" y="25228"/>
            <a:ext cx="5067300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800" dirty="0"/>
              <a:t>(Supplemental Figure 3C)</a:t>
            </a:r>
            <a:r>
              <a:rPr lang="ja-JP" altLang="en-US" sz="2800" dirty="0"/>
              <a:t>　</a:t>
            </a:r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7143618"/>
              </p:ext>
            </p:extLst>
          </p:nvPr>
        </p:nvGraphicFramePr>
        <p:xfrm>
          <a:off x="610094" y="1195011"/>
          <a:ext cx="8064896" cy="5112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E3830A1-C812-1DCD-8031-0C68F931C59E}"/>
              </a:ext>
            </a:extLst>
          </p:cNvPr>
          <p:cNvSpPr txBox="1"/>
          <p:nvPr/>
        </p:nvSpPr>
        <p:spPr>
          <a:xfrm>
            <a:off x="4706937" y="3636663"/>
            <a:ext cx="23346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ale vs. Female: </a:t>
            </a:r>
            <a:r>
              <a:rPr kumimoji="1" lang="en-US" altLang="ja-JP" i="1" dirty="0"/>
              <a:t>P</a:t>
            </a:r>
            <a:r>
              <a:rPr kumimoji="1" lang="en-US" altLang="ja-JP" dirty="0"/>
              <a:t>=.98</a:t>
            </a:r>
            <a:endParaRPr kumimoji="1"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18D79EB-9F11-0729-C959-F92106C8795C}"/>
              </a:ext>
            </a:extLst>
          </p:cNvPr>
          <p:cNvSpPr txBox="1"/>
          <p:nvPr/>
        </p:nvSpPr>
        <p:spPr>
          <a:xfrm rot="-5400000">
            <a:off x="-418241" y="3166064"/>
            <a:ext cx="17419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TLV ratio (%)</a:t>
            </a:r>
            <a:endParaRPr kumimoji="1" lang="ja-JP" altLang="en-US" sz="2400" dirty="0"/>
          </a:p>
        </p:txBody>
      </p:sp>
      <p:sp>
        <p:nvSpPr>
          <p:cNvPr id="7" name="テキスト ボックス 27">
            <a:extLst>
              <a:ext uri="{FF2B5EF4-FFF2-40B4-BE49-F238E27FC236}">
                <a16:creationId xmlns:a16="http://schemas.microsoft.com/office/drawing/2014/main" id="{CE538392-018E-D34D-2934-CEBEB917E5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48267" y="6046340"/>
            <a:ext cx="196068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Time point (years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168F3A60-B653-E31C-DABC-9EC89B373C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6758" y="6351413"/>
            <a:ext cx="121602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Dialysis initiation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0C9DF8FD-64AF-471B-7CD3-C56B94C9E252}"/>
              </a:ext>
            </a:extLst>
          </p:cNvPr>
          <p:cNvCxnSpPr/>
          <p:nvPr/>
        </p:nvCxnSpPr>
        <p:spPr>
          <a:xfrm flipV="1">
            <a:off x="4492920" y="6077076"/>
            <a:ext cx="0" cy="287338"/>
          </a:xfrm>
          <a:prstGeom prst="straightConnector1">
            <a:avLst/>
          </a:prstGeom>
          <a:ln w="508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1">
            <a:extLst>
              <a:ext uri="{FF2B5EF4-FFF2-40B4-BE49-F238E27FC236}">
                <a16:creationId xmlns:a16="http://schemas.microsoft.com/office/drawing/2014/main" id="{F431FCDE-19D8-4B37-1F93-45AC4A53F47F}"/>
              </a:ext>
            </a:extLst>
          </p:cNvPr>
          <p:cNvSpPr txBox="1"/>
          <p:nvPr/>
        </p:nvSpPr>
        <p:spPr>
          <a:xfrm>
            <a:off x="8169231" y="3718098"/>
            <a:ext cx="914400" cy="286966"/>
          </a:xfrm>
          <a:prstGeom prst="rect">
            <a:avLst/>
          </a:prstGeom>
          <a:solidFill>
            <a:schemeClr val="bg1"/>
          </a:solidFill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600" dirty="0"/>
              <a:t>Female</a:t>
            </a:r>
            <a:endParaRPr lang="ja-JP" altLang="en-US" sz="1600" dirty="0"/>
          </a:p>
        </p:txBody>
      </p:sp>
      <p:sp>
        <p:nvSpPr>
          <p:cNvPr id="11" name="テキスト ボックス 1">
            <a:extLst>
              <a:ext uri="{FF2B5EF4-FFF2-40B4-BE49-F238E27FC236}">
                <a16:creationId xmlns:a16="http://schemas.microsoft.com/office/drawing/2014/main" id="{DDD8A515-CD55-CB1D-22BD-EA72EEA9EBC0}"/>
              </a:ext>
            </a:extLst>
          </p:cNvPr>
          <p:cNvSpPr txBox="1"/>
          <p:nvPr/>
        </p:nvSpPr>
        <p:spPr>
          <a:xfrm>
            <a:off x="8181827" y="3430066"/>
            <a:ext cx="914400" cy="286966"/>
          </a:xfrm>
          <a:prstGeom prst="rect">
            <a:avLst/>
          </a:prstGeom>
          <a:solidFill>
            <a:schemeClr val="bg1"/>
          </a:solidFill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600" dirty="0"/>
              <a:t>Male</a:t>
            </a:r>
            <a:endParaRPr lang="ja-JP" altLang="en-US" sz="16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487BC0D-68DC-7EA6-5F35-9602F97EE388}"/>
              </a:ext>
            </a:extLst>
          </p:cNvPr>
          <p:cNvSpPr txBox="1"/>
          <p:nvPr/>
        </p:nvSpPr>
        <p:spPr>
          <a:xfrm>
            <a:off x="175404" y="550421"/>
            <a:ext cx="89342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Linear mixed model analysis showing the least squares mean of the TLV ratio at each time point. There was no significant difference between male and female patients (</a:t>
            </a:r>
            <a:r>
              <a:rPr kumimoji="1" lang="en-US" altLang="ja-JP" i="1" dirty="0"/>
              <a:t>P</a:t>
            </a:r>
            <a:r>
              <a:rPr kumimoji="1" lang="en-US" altLang="ja-JP" dirty="0"/>
              <a:t>=.98)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18373376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5" ma:contentTypeDescription="Create a new document." ma:contentTypeScope="" ma:versionID="27b70b7d379b7d2bf5181e6ec30efaae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81e77bac0c22e49f90422e75eabcf476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2d571ce-5d5e-4577-851b-36fe2b87e29c" xsi:nil="true"/>
    <lcf76f155ced4ddcb4097134ff3c332f xmlns="7805362c-7fb7-47ff-9049-83b2c46e6485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E0D53026-936C-4248-AB20-610DBEEE2B6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61912384-821E-4284-8284-368C1AC5B246}">
  <ds:schemaRefs>
    <ds:schemaRef ds:uri="http://schemas.microsoft.com/office/2006/metadata/properties"/>
    <ds:schemaRef ds:uri="http://schemas.microsoft.com/office/infopath/2007/PartnerControls"/>
    <ds:schemaRef ds:uri="22d571ce-5d5e-4577-851b-36fe2b87e29c"/>
    <ds:schemaRef ds:uri="7805362c-7fb7-47ff-9049-83b2c46e6485"/>
  </ds:schemaRefs>
</ds:datastoreItem>
</file>

<file path=customXml/itemProps3.xml><?xml version="1.0" encoding="utf-8"?>
<ds:datastoreItem xmlns:ds="http://schemas.openxmlformats.org/officeDocument/2006/customXml" ds:itemID="{29481D6F-5820-41BA-AE26-2D4025853FA1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124</TotalTime>
  <Words>666</Words>
  <Application>Microsoft Office PowerPoint</Application>
  <PresentationFormat>画面に合わせる (4:3)</PresentationFormat>
  <Paragraphs>184</Paragraphs>
  <Slides>12</Slides>
  <Notes>2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2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2</vt:i4>
      </vt:variant>
    </vt:vector>
  </HeadingPairs>
  <TitlesOfParts>
    <vt:vector size="18" baseType="lpstr">
      <vt:lpstr>游ゴシック</vt:lpstr>
      <vt:lpstr>Arial</vt:lpstr>
      <vt:lpstr>Calibri</vt:lpstr>
      <vt:lpstr>1_Office ​​テーマ</vt:lpstr>
      <vt:lpstr>Office ​​テーマ</vt:lpstr>
      <vt:lpstr>Chart</vt:lpstr>
      <vt:lpstr>Distribution of HtTKV and age at dialysis initiation</vt:lpstr>
      <vt:lpstr>Distribution of HtTLV and age at dialysis initiation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kage</dc:creator>
  <cp:lastModifiedBy>達也</cp:lastModifiedBy>
  <cp:revision>117</cp:revision>
  <dcterms:created xsi:type="dcterms:W3CDTF">2022-05-21T07:17:05Z</dcterms:created>
  <dcterms:modified xsi:type="dcterms:W3CDTF">2023-01-14T04:13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D935350FB4524AA9B0551AC744F54C</vt:lpwstr>
  </property>
</Properties>
</file>